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olors1.xml" ContentType="application/vnd.ms-office.chartcolorstyle+xml"/>
  <Override PartName="/ppt/charts/colors2.xml" ContentType="application/vnd.ms-office.chartcolorstyle+xml"/>
  <Override PartName="/ppt/charts/colors3.xml" ContentType="application/vnd.ms-office.chartcolorstyle+xml"/>
  <Override PartName="/ppt/charts/colors4.xml" ContentType="application/vnd.ms-office.chartcolorstyle+xml"/>
  <Override PartName="/ppt/charts/colors5.xml" ContentType="application/vnd.ms-office.chartcolorstyle+xml"/>
  <Override PartName="/ppt/charts/style1.xml" ContentType="application/vnd.ms-office.chartstyle+xml"/>
  <Override PartName="/ppt/charts/style2.xml" ContentType="application/vnd.ms-office.chartstyle+xml"/>
  <Override PartName="/ppt/charts/style3.xml" ContentType="application/vnd.ms-office.chartstyle+xml"/>
  <Override PartName="/ppt/charts/style4.xml" ContentType="application/vnd.ms-office.chartstyle+xml"/>
  <Override PartName="/ppt/charts/style5.xml" ContentType="application/vnd.ms-office.chartstyle+xml"/>
  <Override PartName="/ppt/notesMasters/notesMaster1.xml" ContentType="application/vnd.openxmlformats-officedocument.presentationml.notesMaster+xml"/>
  <Override PartName="/ppt/presentation.xml" ContentType="application/vnd.openxmlformats-officedocument.presentationml.presentation.main+xml"/>
  <Override PartName="/ppt/presProps.xml" ContentType="application/vnd.openxmlformats-officedocument.presentationml.presPro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 = '1.0' encoding = 'UTF-8' standalone = 'yes'?>
<Relationships xmlns="http://schemas.openxmlformats.org/package/2006/relationships">
   <Relationship Id="rId1" Type="http://schemas.openxmlformats.org/officeDocument/2006/relationships/officeDocument" Target="ppt/presentation.xml"/>
   <Relationship Id="rId2" Type="http://schemas.openxmlformats.org/package/2006/relationships/metadata/thumbnail" Target="docProps/thumbnail.jpeg"/>
   <Relationship Id="rId3" Type="http://schemas.openxmlformats.org/package/2006/relationships/metadata/core-properties" Target="docProps/core.xml"/>
   <Relationship Id="rId4" Type="http://schemas.openxmlformats.org/officeDocument/2006/relationships/extended-properties" Target="docProps/app.xml"/>
</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312" r:id="rId2"/>
    <p:sldId id="307" r:id="rId3"/>
    <p:sldId id="308" r:id="rId4"/>
    <p:sldId id="310" r:id="rId5"/>
    <p:sldId id="309" r:id="rId6"/>
    <p:sldId id="271" r:id="rId7"/>
    <p:sldId id="270"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CC9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70" d="100"/>
          <a:sy n="70" d="100"/>
        </p:scale>
        <p:origin x="714" y="72"/>
      </p:cViewPr>
      <p:guideLst/>
    </p:cSldViewPr>
  </p:slideViewPr>
  <p:notesTextViewPr>
    <p:cViewPr>
      <p:scale>
        <a:sx n="1" d="1"/>
        <a:sy n="1" d="1"/>
      </p:scale>
      <p:origin x="0" y="0"/>
    </p:cViewPr>
  </p:notesTextViewPr>
  <p:gridSpacing cx="76200" cy="76200"/>
</p:viewPr>
</file>

<file path=ppt/_rels/presentation.xml.rels><?xml version = '1.0' encoding = 'UTF-8' standalone = 'yes'?>
<Relationships xmlns="http://schemas.openxmlformats.org/package/2006/relationships">
   <Relationship Id="rId1" Type="http://schemas.openxmlformats.org/officeDocument/2006/relationships/slideMaster" Target="slideMasters/slideMaster1.xml"/>
   <Relationship Id="rId10" Type="http://schemas.openxmlformats.org/officeDocument/2006/relationships/presProps" Target="presProps.xml"/>
   <Relationship Id="rId11" Type="http://schemas.openxmlformats.org/officeDocument/2006/relationships/viewProps" Target="viewProps.xml"/>
   <Relationship Id="rId12" Type="http://schemas.openxmlformats.org/officeDocument/2006/relationships/theme" Target="theme/theme1.xml"/>
   <Relationship Id="rId13" Type="http://schemas.openxmlformats.org/officeDocument/2006/relationships/tableStyles" Target="tableStyles.xml"/>
   <Relationship Id="rId2" Type="http://schemas.openxmlformats.org/officeDocument/2006/relationships/slide" Target="slides/slide1.xml"/>
   <Relationship Id="rId3" Type="http://schemas.openxmlformats.org/officeDocument/2006/relationships/slide" Target="slides/slide2.xml"/>
   <Relationship Id="rId4" Type="http://schemas.openxmlformats.org/officeDocument/2006/relationships/slide" Target="slides/slide3.xml"/>
   <Relationship Id="rId5" Type="http://schemas.openxmlformats.org/officeDocument/2006/relationships/slide" Target="slides/slide4.xml"/>
   <Relationship Id="rId6" Type="http://schemas.openxmlformats.org/officeDocument/2006/relationships/slide" Target="slides/slide5.xml"/>
   <Relationship Id="rId7" Type="http://schemas.openxmlformats.org/officeDocument/2006/relationships/slide" Target="slides/slide6.xml"/>
   <Relationship Id="rId8" Type="http://schemas.openxmlformats.org/officeDocument/2006/relationships/slide" Target="slides/slide7.xml"/>
   <Relationship Id="rId9" Type="http://schemas.openxmlformats.org/officeDocument/2006/relationships/notesMaster" Target="notesMasters/notesMaster1.xml"/>
</Relationships>
</file>

<file path=ppt/charts/_rels/chart1.xml.rels><?xml version = '1.0' encoding = 'UTF-8' standalone = 'yes'?>
<Relationships xmlns="http://schemas.openxmlformats.org/package/2006/relationships">
   <Relationship Id="rId1" Type="http://schemas.microsoft.com/office/2011/relationships/chartStyle" Target="style1.xml"/>
   <Relationship Id="rId2" Type="http://schemas.microsoft.com/office/2011/relationships/chartColorStyle" Target="colors1.xml"/>
   <Relationship Id="rId3" Type="http://schemas.openxmlformats.org/officeDocument/2006/relationships/oleObject" TargetMode="External" Target="file:///C:/Users/gglinsky/Desktop/2015_2016%20VittorioS/2016_CSC%20VittorioS/HPATs%20BLastocyst%20Cells/HPATs%20Blastocysts.xlsx"/>
</Relationships>
</file>

<file path=ppt/charts/_rels/chart2.xml.rels><?xml version = '1.0' encoding = 'UTF-8' standalone = 'yes'?>
<Relationships xmlns="http://schemas.openxmlformats.org/package/2006/relationships">
   <Relationship Id="rId1" Type="http://schemas.microsoft.com/office/2011/relationships/chartStyle" Target="style2.xml"/>
   <Relationship Id="rId2" Type="http://schemas.microsoft.com/office/2011/relationships/chartColorStyle" Target="colors2.xml"/>
   <Relationship Id="rId3" Type="http://schemas.openxmlformats.org/officeDocument/2006/relationships/oleObject" TargetMode="External" Target="file:///C:/Users/gglinsky/Desktop/2015_2016%20VittorioS/2016_CSC%20VittorioS/HPATs%20BLastocyst%20Cells/HPATclassification.xlsx"/>
</Relationships>
</file>

<file path=ppt/charts/_rels/chart3.xml.rels><?xml version = '1.0' encoding = 'UTF-8' standalone = 'yes'?>
<Relationships xmlns="http://schemas.openxmlformats.org/package/2006/relationships">
   <Relationship Id="rId1" Type="http://schemas.microsoft.com/office/2011/relationships/chartStyle" Target="style3.xml"/>
   <Relationship Id="rId2" Type="http://schemas.microsoft.com/office/2011/relationships/chartColorStyle" Target="colors3.xml"/>
   <Relationship Id="rId3" Type="http://schemas.openxmlformats.org/officeDocument/2006/relationships/oleObject" TargetMode="External" Target="file:///C:/Users/gglinsky/Desktop/2015_2016%20VittorioS/2016_CSC%20VittorioS/HPATs%20BLastocyst%20Cells/HPATclassification.xlsx"/>
</Relationships>
</file>

<file path=ppt/charts/_rels/chart4.xml.rels><?xml version = '1.0' encoding = 'UTF-8' standalone = 'yes'?>
<Relationships xmlns="http://schemas.openxmlformats.org/package/2006/relationships">
   <Relationship Id="rId1" Type="http://schemas.microsoft.com/office/2011/relationships/chartStyle" Target="style4.xml"/>
   <Relationship Id="rId2" Type="http://schemas.microsoft.com/office/2011/relationships/chartColorStyle" Target="colors4.xml"/>
   <Relationship Id="rId3" Type="http://schemas.openxmlformats.org/officeDocument/2006/relationships/oleObject" TargetMode="External" Target="file:///C:/Users/gglinsky/Desktop/2015_2016%20VittorioS/2016_CSC%20VittorioS/HPATs%20BLastocyst%20Cells/Table%20S2%20-%20Data%20matrix%20Copy.xlsx"/>
</Relationships>
</file>

<file path=ppt/charts/_rels/chart5.xml.rels><?xml version = '1.0' encoding = 'UTF-8' standalone = 'yes'?>
<Relationships xmlns="http://schemas.openxmlformats.org/package/2006/relationships">
   <Relationship Id="rId1" Type="http://schemas.microsoft.com/office/2011/relationships/chartStyle" Target="style5.xml"/>
   <Relationship Id="rId2" Type="http://schemas.microsoft.com/office/2011/relationships/chartColorStyle" Target="colors5.xml"/>
   <Relationship Id="rId3" Type="http://schemas.openxmlformats.org/officeDocument/2006/relationships/oleObject" TargetMode="External" Target="file:///C:/Users/gglinsky/Desktop/2015_2016%20VittorioS/2016_CSC%20VittorioS/HPATs%20BLastocyst%20Cells/Table%20S2%20-%20Data%20matrix%20Copy.xlsx"/>
</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600" b="1" i="0" u="none" strike="noStrike" kern="1200" spc="0" baseline="0">
                <a:solidFill>
                  <a:sysClr val="windowText" lastClr="000000"/>
                </a:solidFill>
                <a:latin typeface="+mn-lt"/>
                <a:ea typeface="+mn-ea"/>
                <a:cs typeface="+mn-cs"/>
              </a:defRPr>
            </a:pPr>
            <a:r>
              <a:rPr lang="en-US" sz="1600" b="1">
                <a:solidFill>
                  <a:sysClr val="windowText" lastClr="000000"/>
                </a:solidFill>
              </a:rPr>
              <a:t>EXPRESSION</a:t>
            </a:r>
            <a:r>
              <a:rPr lang="en-US" sz="1600" b="1" baseline="0">
                <a:solidFill>
                  <a:sysClr val="windowText" lastClr="000000"/>
                </a:solidFill>
              </a:rPr>
              <a:t> PATTERNS OF THE HPAT21; HPAT15; AND HPAT2 IN 241 HUMAN BLASTOCYST CELLS</a:t>
            </a:r>
            <a:endParaRPr lang="en-US" sz="1600" b="1">
              <a:solidFill>
                <a:sysClr val="windowText" lastClr="000000"/>
              </a:solidFill>
            </a:endParaRPr>
          </a:p>
        </c:rich>
      </c:tx>
      <c:overlay val="0"/>
      <c:spPr>
        <a:noFill/>
        <a:ln>
          <a:noFill/>
        </a:ln>
        <a:effectLst/>
      </c:spPr>
      <c:txPr>
        <a:bodyPr rot="0" spcFirstLastPara="1" vertOverflow="ellipsis" vert="horz" wrap="square" anchor="ctr" anchorCtr="1"/>
        <a:lstStyle/>
        <a:p>
          <a:pPr>
            <a:defRPr sz="1600" b="1" i="0" u="none" strike="noStrike" kern="1200" spc="0" baseline="0">
              <a:solidFill>
                <a:sysClr val="windowText" lastClr="000000"/>
              </a:solidFill>
              <a:latin typeface="+mn-lt"/>
              <a:ea typeface="+mn-ea"/>
              <a:cs typeface="+mn-cs"/>
            </a:defRPr>
          </a:pPr>
          <a:endParaRPr lang="en-US"/>
        </a:p>
      </c:txPr>
    </c:title>
    <c:autoTitleDeleted val="0"/>
    <c:plotArea>
      <c:layout>
        <c:manualLayout>
          <c:layoutTarget val="inner"/>
          <c:xMode val="edge"/>
          <c:yMode val="edge"/>
          <c:x val="9.5536434438509704E-2"/>
          <c:y val="0.1430622138903597"/>
          <c:w val="0.88833906828337927"/>
          <c:h val="0.80402028267910719"/>
        </c:manualLayout>
      </c:layout>
      <c:areaChart>
        <c:grouping val="stacked"/>
        <c:varyColors val="0"/>
        <c:ser>
          <c:idx val="0"/>
          <c:order val="0"/>
          <c:tx>
            <c:strRef>
              <c:f>Sheet1!$D$1</c:f>
              <c:strCache>
                <c:ptCount val="1"/>
                <c:pt idx="0">
                  <c:v>HPAT21</c:v>
                </c:pt>
              </c:strCache>
            </c:strRef>
          </c:tx>
          <c:spPr>
            <a:solidFill>
              <a:schemeClr val="accent1"/>
            </a:solidFill>
            <a:ln>
              <a:noFill/>
            </a:ln>
            <a:effectLst/>
          </c:spPr>
          <c:cat>
            <c:strRef>
              <c:f>Sheet1!$C$2:$C$242</c:f>
              <c:strCache>
                <c:ptCount val="241"/>
                <c:pt idx="0">
                  <c:v>Embryo1_12</c:v>
                </c:pt>
                <c:pt idx="1">
                  <c:v>Embryo1_17</c:v>
                </c:pt>
                <c:pt idx="2">
                  <c:v>Embryo1_23</c:v>
                </c:pt>
                <c:pt idx="3">
                  <c:v>Embryo1_30</c:v>
                </c:pt>
                <c:pt idx="4">
                  <c:v>Embryo1_31</c:v>
                </c:pt>
                <c:pt idx="5">
                  <c:v>Embryo1_32</c:v>
                </c:pt>
                <c:pt idx="6">
                  <c:v>Embryo1_34</c:v>
                </c:pt>
                <c:pt idx="7">
                  <c:v>Embryo1_40</c:v>
                </c:pt>
                <c:pt idx="8">
                  <c:v>Embryo1_43</c:v>
                </c:pt>
                <c:pt idx="9">
                  <c:v>Embryo1_46</c:v>
                </c:pt>
                <c:pt idx="10">
                  <c:v>Embryo1_47</c:v>
                </c:pt>
                <c:pt idx="11">
                  <c:v>Embryo1_48</c:v>
                </c:pt>
                <c:pt idx="12">
                  <c:v>Embryo1_51</c:v>
                </c:pt>
                <c:pt idx="13">
                  <c:v>Embryo2_1</c:v>
                </c:pt>
                <c:pt idx="14">
                  <c:v>Embryo2_6</c:v>
                </c:pt>
                <c:pt idx="15">
                  <c:v>Embryo2_7</c:v>
                </c:pt>
                <c:pt idx="16">
                  <c:v>Embryo2_10</c:v>
                </c:pt>
                <c:pt idx="17">
                  <c:v>Embryo2_12</c:v>
                </c:pt>
                <c:pt idx="18">
                  <c:v>Embryo2_13</c:v>
                </c:pt>
                <c:pt idx="19">
                  <c:v>Embryo2_20</c:v>
                </c:pt>
                <c:pt idx="20">
                  <c:v>Embryo2_23</c:v>
                </c:pt>
                <c:pt idx="21">
                  <c:v>Embryo2_28</c:v>
                </c:pt>
                <c:pt idx="22">
                  <c:v>Embryo2_31</c:v>
                </c:pt>
                <c:pt idx="23">
                  <c:v>Embryo2_33</c:v>
                </c:pt>
                <c:pt idx="24">
                  <c:v>Embryo2_35</c:v>
                </c:pt>
                <c:pt idx="25">
                  <c:v>Embryo1_8</c:v>
                </c:pt>
                <c:pt idx="26">
                  <c:v>Embryo1_10</c:v>
                </c:pt>
                <c:pt idx="27">
                  <c:v>Embryo1_37</c:v>
                </c:pt>
                <c:pt idx="28">
                  <c:v>Embryo1_50</c:v>
                </c:pt>
                <c:pt idx="29">
                  <c:v>Embryo1_53</c:v>
                </c:pt>
                <c:pt idx="30">
                  <c:v>Embryo2_25</c:v>
                </c:pt>
                <c:pt idx="31">
                  <c:v>Embryo3_1</c:v>
                </c:pt>
                <c:pt idx="32">
                  <c:v>Embryo3_2</c:v>
                </c:pt>
                <c:pt idx="33">
                  <c:v>Embryo3_5</c:v>
                </c:pt>
                <c:pt idx="34">
                  <c:v>Embryo3_7</c:v>
                </c:pt>
                <c:pt idx="35">
                  <c:v>Embryo3_10</c:v>
                </c:pt>
                <c:pt idx="36">
                  <c:v>Embryo3_11</c:v>
                </c:pt>
                <c:pt idx="37">
                  <c:v>Embryo3_12</c:v>
                </c:pt>
                <c:pt idx="38">
                  <c:v>Embryo3_14</c:v>
                </c:pt>
                <c:pt idx="39">
                  <c:v>Embryo3_15</c:v>
                </c:pt>
                <c:pt idx="40">
                  <c:v>Embryo3_18</c:v>
                </c:pt>
                <c:pt idx="41">
                  <c:v>Embryo3_20</c:v>
                </c:pt>
                <c:pt idx="42">
                  <c:v>Embryo3_22</c:v>
                </c:pt>
                <c:pt idx="43">
                  <c:v>Embryo3_27</c:v>
                </c:pt>
                <c:pt idx="44">
                  <c:v>Embryo3_35</c:v>
                </c:pt>
                <c:pt idx="45">
                  <c:v>Embryo3_39</c:v>
                </c:pt>
                <c:pt idx="46">
                  <c:v>Embryo3_44</c:v>
                </c:pt>
                <c:pt idx="47">
                  <c:v>Embryo3_49</c:v>
                </c:pt>
                <c:pt idx="48">
                  <c:v>Embryo3_51</c:v>
                </c:pt>
                <c:pt idx="49">
                  <c:v>Embryo3_55</c:v>
                </c:pt>
                <c:pt idx="50">
                  <c:v>Embryo3_62</c:v>
                </c:pt>
                <c:pt idx="51">
                  <c:v>Embryo3_67</c:v>
                </c:pt>
                <c:pt idx="52">
                  <c:v>Embryo3_68</c:v>
                </c:pt>
                <c:pt idx="53">
                  <c:v>Embryo3_70</c:v>
                </c:pt>
                <c:pt idx="54">
                  <c:v>Embryo3_72</c:v>
                </c:pt>
                <c:pt idx="55">
                  <c:v>Embryo3_73</c:v>
                </c:pt>
                <c:pt idx="56">
                  <c:v>Embryo3_78</c:v>
                </c:pt>
                <c:pt idx="57">
                  <c:v>Embryo3_81</c:v>
                </c:pt>
                <c:pt idx="58">
                  <c:v>Embryo3_82</c:v>
                </c:pt>
                <c:pt idx="59">
                  <c:v>Embryo4_2</c:v>
                </c:pt>
                <c:pt idx="60">
                  <c:v>Embryo4_3</c:v>
                </c:pt>
                <c:pt idx="61">
                  <c:v>Embryo4_4</c:v>
                </c:pt>
                <c:pt idx="62">
                  <c:v>Embryo4_5</c:v>
                </c:pt>
                <c:pt idx="63">
                  <c:v>Embryo4_8</c:v>
                </c:pt>
                <c:pt idx="64">
                  <c:v>Embryo4_10</c:v>
                </c:pt>
                <c:pt idx="65">
                  <c:v>Embryo4_11</c:v>
                </c:pt>
                <c:pt idx="66">
                  <c:v>Embryo4_14</c:v>
                </c:pt>
                <c:pt idx="67">
                  <c:v>Embryo4_15</c:v>
                </c:pt>
                <c:pt idx="68">
                  <c:v>Embryo4_16</c:v>
                </c:pt>
                <c:pt idx="69">
                  <c:v>Embryo4_21</c:v>
                </c:pt>
                <c:pt idx="70">
                  <c:v>Embryo4_32</c:v>
                </c:pt>
                <c:pt idx="71">
                  <c:v>Embryo4_37</c:v>
                </c:pt>
                <c:pt idx="72">
                  <c:v>Embryo4_39</c:v>
                </c:pt>
                <c:pt idx="73">
                  <c:v>Embryo4_40</c:v>
                </c:pt>
                <c:pt idx="74">
                  <c:v>Embryo4_41</c:v>
                </c:pt>
                <c:pt idx="75">
                  <c:v>Embryo4_43</c:v>
                </c:pt>
                <c:pt idx="76">
                  <c:v>Embryo4_46</c:v>
                </c:pt>
                <c:pt idx="77">
                  <c:v>Embryo4_47</c:v>
                </c:pt>
                <c:pt idx="78">
                  <c:v>Embryo4_50</c:v>
                </c:pt>
                <c:pt idx="79">
                  <c:v>Embryo4_52</c:v>
                </c:pt>
                <c:pt idx="80">
                  <c:v>Embryo4_54</c:v>
                </c:pt>
                <c:pt idx="81">
                  <c:v>Embryo4_55</c:v>
                </c:pt>
                <c:pt idx="82">
                  <c:v>Embryo4_59</c:v>
                </c:pt>
                <c:pt idx="83">
                  <c:v>Embryo4_60</c:v>
                </c:pt>
                <c:pt idx="84">
                  <c:v>Embryo4_61</c:v>
                </c:pt>
                <c:pt idx="85">
                  <c:v>Embryo4_62</c:v>
                </c:pt>
                <c:pt idx="86">
                  <c:v>Embryo4_65</c:v>
                </c:pt>
                <c:pt idx="87">
                  <c:v>Embryo4_70</c:v>
                </c:pt>
                <c:pt idx="88">
                  <c:v>Embryo1_6</c:v>
                </c:pt>
                <c:pt idx="89">
                  <c:v>Embryo1_13</c:v>
                </c:pt>
                <c:pt idx="90">
                  <c:v>Embryo2_11</c:v>
                </c:pt>
                <c:pt idx="91">
                  <c:v>Embryo2_24</c:v>
                </c:pt>
                <c:pt idx="92">
                  <c:v>Embryo3_21</c:v>
                </c:pt>
                <c:pt idx="93">
                  <c:v>Embryo3_26</c:v>
                </c:pt>
                <c:pt idx="94">
                  <c:v>Embryo3_28</c:v>
                </c:pt>
                <c:pt idx="95">
                  <c:v>Embryo3_32</c:v>
                </c:pt>
                <c:pt idx="96">
                  <c:v>Embryo3_45</c:v>
                </c:pt>
                <c:pt idx="97">
                  <c:v>Embryo3_48</c:v>
                </c:pt>
                <c:pt idx="98">
                  <c:v>Embryo3_52</c:v>
                </c:pt>
                <c:pt idx="99">
                  <c:v>Embryo3_54</c:v>
                </c:pt>
                <c:pt idx="100">
                  <c:v>Embryo3_60</c:v>
                </c:pt>
                <c:pt idx="101">
                  <c:v>Embryo3_64</c:v>
                </c:pt>
                <c:pt idx="102">
                  <c:v>Embryo3_80</c:v>
                </c:pt>
                <c:pt idx="103">
                  <c:v>Embryo4_7</c:v>
                </c:pt>
                <c:pt idx="104">
                  <c:v>Embryo4_20</c:v>
                </c:pt>
                <c:pt idx="105">
                  <c:v>Embryo4_25</c:v>
                </c:pt>
                <c:pt idx="106">
                  <c:v>Embryo4_28</c:v>
                </c:pt>
                <c:pt idx="107">
                  <c:v>Embryo4_29</c:v>
                </c:pt>
                <c:pt idx="108">
                  <c:v>Embryo4_34</c:v>
                </c:pt>
                <c:pt idx="109">
                  <c:v>Embryo4_35</c:v>
                </c:pt>
                <c:pt idx="110">
                  <c:v>Embryo4_49</c:v>
                </c:pt>
                <c:pt idx="111">
                  <c:v>Embryo4_58</c:v>
                </c:pt>
                <c:pt idx="112">
                  <c:v>Embryo4_18</c:v>
                </c:pt>
                <c:pt idx="113">
                  <c:v>Embryo1_7</c:v>
                </c:pt>
                <c:pt idx="114">
                  <c:v>Embryo1_18</c:v>
                </c:pt>
                <c:pt idx="115">
                  <c:v>Embryo1_22</c:v>
                </c:pt>
                <c:pt idx="116">
                  <c:v>Embryo1_35</c:v>
                </c:pt>
                <c:pt idx="117">
                  <c:v>Embryo1_42</c:v>
                </c:pt>
                <c:pt idx="118">
                  <c:v>Embryo1_44</c:v>
                </c:pt>
                <c:pt idx="119">
                  <c:v>Embryo1_45</c:v>
                </c:pt>
                <c:pt idx="120">
                  <c:v>Embryo1_49</c:v>
                </c:pt>
                <c:pt idx="121">
                  <c:v>Embryo2_9</c:v>
                </c:pt>
                <c:pt idx="122">
                  <c:v>Embryo2_14</c:v>
                </c:pt>
                <c:pt idx="123">
                  <c:v>Embryo2_15</c:v>
                </c:pt>
                <c:pt idx="124">
                  <c:v>Embryo2_16</c:v>
                </c:pt>
                <c:pt idx="125">
                  <c:v>Embryo2_18</c:v>
                </c:pt>
                <c:pt idx="126">
                  <c:v>Embryo2_21</c:v>
                </c:pt>
                <c:pt idx="127">
                  <c:v>Embryo2_22</c:v>
                </c:pt>
                <c:pt idx="128">
                  <c:v>Embryo2_32</c:v>
                </c:pt>
                <c:pt idx="129">
                  <c:v>Embryo3_8</c:v>
                </c:pt>
                <c:pt idx="130">
                  <c:v>Embryo3_23</c:v>
                </c:pt>
                <c:pt idx="131">
                  <c:v>Embryo3_24</c:v>
                </c:pt>
                <c:pt idx="132">
                  <c:v>Embryo3_29</c:v>
                </c:pt>
                <c:pt idx="133">
                  <c:v>Embryo3_30</c:v>
                </c:pt>
                <c:pt idx="134">
                  <c:v>Embryo3_65</c:v>
                </c:pt>
                <c:pt idx="135">
                  <c:v>Embryo3_66</c:v>
                </c:pt>
                <c:pt idx="136">
                  <c:v>Embryo3_74</c:v>
                </c:pt>
                <c:pt idx="137">
                  <c:v>Embryo3_75</c:v>
                </c:pt>
                <c:pt idx="138">
                  <c:v>Embryo3_77</c:v>
                </c:pt>
                <c:pt idx="139">
                  <c:v>Embryo3_79</c:v>
                </c:pt>
                <c:pt idx="140">
                  <c:v>Embryo4_1</c:v>
                </c:pt>
                <c:pt idx="141">
                  <c:v>Embryo4_19</c:v>
                </c:pt>
                <c:pt idx="142">
                  <c:v>Embryo4_30</c:v>
                </c:pt>
                <c:pt idx="143">
                  <c:v>Embryo4_45</c:v>
                </c:pt>
                <c:pt idx="144">
                  <c:v>Embryo4_71</c:v>
                </c:pt>
                <c:pt idx="145">
                  <c:v>Embryo1_28</c:v>
                </c:pt>
                <c:pt idx="146">
                  <c:v>Embryo1_2</c:v>
                </c:pt>
                <c:pt idx="147">
                  <c:v>Embryo1_3</c:v>
                </c:pt>
                <c:pt idx="148">
                  <c:v>Embryo1_5</c:v>
                </c:pt>
                <c:pt idx="149">
                  <c:v>Embryo1_9</c:v>
                </c:pt>
                <c:pt idx="150">
                  <c:v>Embryo1_11</c:v>
                </c:pt>
                <c:pt idx="151">
                  <c:v>Embryo1_16</c:v>
                </c:pt>
                <c:pt idx="152">
                  <c:v>Embryo1_19</c:v>
                </c:pt>
                <c:pt idx="153">
                  <c:v>Embryo1_20</c:v>
                </c:pt>
                <c:pt idx="154">
                  <c:v>Embryo1_24</c:v>
                </c:pt>
                <c:pt idx="155">
                  <c:v>Embryo1_25</c:v>
                </c:pt>
                <c:pt idx="156">
                  <c:v>Embryo1_26</c:v>
                </c:pt>
                <c:pt idx="157">
                  <c:v>Embryo1_27</c:v>
                </c:pt>
                <c:pt idx="158">
                  <c:v>Embryo1_29</c:v>
                </c:pt>
                <c:pt idx="159">
                  <c:v>Embryo1_33</c:v>
                </c:pt>
                <c:pt idx="160">
                  <c:v>Embryo1_36</c:v>
                </c:pt>
                <c:pt idx="161">
                  <c:v>Embryo1_38</c:v>
                </c:pt>
                <c:pt idx="162">
                  <c:v>Embryo1_39</c:v>
                </c:pt>
                <c:pt idx="163">
                  <c:v>Embryo1_52</c:v>
                </c:pt>
                <c:pt idx="164">
                  <c:v>Embryo2_2</c:v>
                </c:pt>
                <c:pt idx="165">
                  <c:v>Embryo2_3</c:v>
                </c:pt>
                <c:pt idx="166">
                  <c:v>Embryo2_4</c:v>
                </c:pt>
                <c:pt idx="167">
                  <c:v>Embryo2_5</c:v>
                </c:pt>
                <c:pt idx="168">
                  <c:v>Embryo2_8</c:v>
                </c:pt>
                <c:pt idx="169">
                  <c:v>Embryo2_19</c:v>
                </c:pt>
                <c:pt idx="170">
                  <c:v>Embryo2_26</c:v>
                </c:pt>
                <c:pt idx="171">
                  <c:v>Embryo2_27</c:v>
                </c:pt>
                <c:pt idx="172">
                  <c:v>Embryo2_29</c:v>
                </c:pt>
                <c:pt idx="173">
                  <c:v>Embryo2_30</c:v>
                </c:pt>
                <c:pt idx="174">
                  <c:v>Embryo2_34</c:v>
                </c:pt>
                <c:pt idx="175">
                  <c:v>Embryo3_3</c:v>
                </c:pt>
                <c:pt idx="176">
                  <c:v>Embryo3_4</c:v>
                </c:pt>
                <c:pt idx="177">
                  <c:v>Embryo3_6</c:v>
                </c:pt>
                <c:pt idx="178">
                  <c:v>Embryo3_9</c:v>
                </c:pt>
                <c:pt idx="179">
                  <c:v>Embryo3_16</c:v>
                </c:pt>
                <c:pt idx="180">
                  <c:v>Embryo3_17</c:v>
                </c:pt>
                <c:pt idx="181">
                  <c:v>Embryo3_19</c:v>
                </c:pt>
                <c:pt idx="182">
                  <c:v>Embryo3_31</c:v>
                </c:pt>
                <c:pt idx="183">
                  <c:v>Embryo3_33</c:v>
                </c:pt>
                <c:pt idx="184">
                  <c:v>Embryo3_34</c:v>
                </c:pt>
                <c:pt idx="185">
                  <c:v>Embryo3_36</c:v>
                </c:pt>
                <c:pt idx="186">
                  <c:v>Embryo3_38</c:v>
                </c:pt>
                <c:pt idx="187">
                  <c:v>Embryo3_41</c:v>
                </c:pt>
                <c:pt idx="188">
                  <c:v>Embryo3_42</c:v>
                </c:pt>
                <c:pt idx="189">
                  <c:v>Embryo3_43</c:v>
                </c:pt>
                <c:pt idx="190">
                  <c:v>Embryo3_46</c:v>
                </c:pt>
                <c:pt idx="191">
                  <c:v>Embryo3_47</c:v>
                </c:pt>
                <c:pt idx="192">
                  <c:v>Embryo3_50</c:v>
                </c:pt>
                <c:pt idx="193">
                  <c:v>Embryo3_53</c:v>
                </c:pt>
                <c:pt idx="194">
                  <c:v>Embryo3_56</c:v>
                </c:pt>
                <c:pt idx="195">
                  <c:v>Embryo3_57</c:v>
                </c:pt>
                <c:pt idx="196">
                  <c:v>Embryo3_58</c:v>
                </c:pt>
                <c:pt idx="197">
                  <c:v>Embryo3_59</c:v>
                </c:pt>
                <c:pt idx="198">
                  <c:v>Embryo3_61</c:v>
                </c:pt>
                <c:pt idx="199">
                  <c:v>Embryo3_63</c:v>
                </c:pt>
                <c:pt idx="200">
                  <c:v>Embryo3_69</c:v>
                </c:pt>
                <c:pt idx="201">
                  <c:v>Embryo3_71</c:v>
                </c:pt>
                <c:pt idx="202">
                  <c:v>Embryo4_6</c:v>
                </c:pt>
                <c:pt idx="203">
                  <c:v>Embryo4_9</c:v>
                </c:pt>
                <c:pt idx="204">
                  <c:v>Embryo4_12</c:v>
                </c:pt>
                <c:pt idx="205">
                  <c:v>Embryo4_13</c:v>
                </c:pt>
                <c:pt idx="206">
                  <c:v>Embryo4_17</c:v>
                </c:pt>
                <c:pt idx="207">
                  <c:v>Embryo4_22</c:v>
                </c:pt>
                <c:pt idx="208">
                  <c:v>Embryo4_23</c:v>
                </c:pt>
                <c:pt idx="209">
                  <c:v>Embryo4_26</c:v>
                </c:pt>
                <c:pt idx="210">
                  <c:v>Embryo4_27</c:v>
                </c:pt>
                <c:pt idx="211">
                  <c:v>Embryo4_31</c:v>
                </c:pt>
                <c:pt idx="212">
                  <c:v>Embryo4_33</c:v>
                </c:pt>
                <c:pt idx="213">
                  <c:v>Embryo4_36</c:v>
                </c:pt>
                <c:pt idx="214">
                  <c:v>Embryo4_38</c:v>
                </c:pt>
                <c:pt idx="215">
                  <c:v>Embryo4_42</c:v>
                </c:pt>
                <c:pt idx="216">
                  <c:v>Embryo4_44</c:v>
                </c:pt>
                <c:pt idx="217">
                  <c:v>Embryo4_48</c:v>
                </c:pt>
                <c:pt idx="218">
                  <c:v>Embryo4_51</c:v>
                </c:pt>
                <c:pt idx="219">
                  <c:v>Embryo4_53</c:v>
                </c:pt>
                <c:pt idx="220">
                  <c:v>Embryo4_57</c:v>
                </c:pt>
                <c:pt idx="221">
                  <c:v>Embryo4_63</c:v>
                </c:pt>
                <c:pt idx="222">
                  <c:v>Embryo4_64</c:v>
                </c:pt>
                <c:pt idx="223">
                  <c:v>Embryo4_66</c:v>
                </c:pt>
                <c:pt idx="224">
                  <c:v>Embryo4_67</c:v>
                </c:pt>
                <c:pt idx="225">
                  <c:v>Embryo4_68</c:v>
                </c:pt>
                <c:pt idx="226">
                  <c:v>Embryo4_69</c:v>
                </c:pt>
                <c:pt idx="227">
                  <c:v>Embryo2_17</c:v>
                </c:pt>
                <c:pt idx="228">
                  <c:v>Embryo1_4</c:v>
                </c:pt>
                <c:pt idx="229">
                  <c:v>Embryo1_14</c:v>
                </c:pt>
                <c:pt idx="230">
                  <c:v>Embryo1_15</c:v>
                </c:pt>
                <c:pt idx="231">
                  <c:v>Embryo1_21</c:v>
                </c:pt>
                <c:pt idx="232">
                  <c:v>Embryo3_13</c:v>
                </c:pt>
                <c:pt idx="233">
                  <c:v>Embryo3_25</c:v>
                </c:pt>
                <c:pt idx="234">
                  <c:v>Embryo3_37</c:v>
                </c:pt>
                <c:pt idx="235">
                  <c:v>Embryo3_40</c:v>
                </c:pt>
                <c:pt idx="236">
                  <c:v>Embryo3_76</c:v>
                </c:pt>
                <c:pt idx="237">
                  <c:v>Embryo4_24</c:v>
                </c:pt>
                <c:pt idx="238">
                  <c:v>Embryo4_56</c:v>
                </c:pt>
                <c:pt idx="239">
                  <c:v>Embryo1_1</c:v>
                </c:pt>
                <c:pt idx="240">
                  <c:v>Embryo1_41</c:v>
                </c:pt>
              </c:strCache>
            </c:strRef>
          </c:cat>
          <c:val>
            <c:numRef>
              <c:f>Sheet1!$D$2:$D$242</c:f>
              <c:numCache>
                <c:formatCode>General</c:formatCode>
                <c:ptCount val="241"/>
                <c:pt idx="0">
                  <c:v>11.99873328</c:v>
                </c:pt>
                <c:pt idx="1">
                  <c:v>12.09656665</c:v>
                </c:pt>
                <c:pt idx="2">
                  <c:v>10.13427742</c:v>
                </c:pt>
                <c:pt idx="3">
                  <c:v>5.7545995220000004</c:v>
                </c:pt>
                <c:pt idx="4">
                  <c:v>5.2873062040000001</c:v>
                </c:pt>
                <c:pt idx="5">
                  <c:v>9.5741062479999997</c:v>
                </c:pt>
                <c:pt idx="6">
                  <c:v>11.191305699999999</c:v>
                </c:pt>
                <c:pt idx="7">
                  <c:v>9.4413358800000005</c:v>
                </c:pt>
                <c:pt idx="8">
                  <c:v>10.97115032</c:v>
                </c:pt>
                <c:pt idx="9">
                  <c:v>7.7423445859999998</c:v>
                </c:pt>
                <c:pt idx="10">
                  <c:v>11.50356021</c:v>
                </c:pt>
                <c:pt idx="11">
                  <c:v>11.41893282</c:v>
                </c:pt>
                <c:pt idx="12">
                  <c:v>8.3299059379999996</c:v>
                </c:pt>
                <c:pt idx="13">
                  <c:v>11.14788624</c:v>
                </c:pt>
                <c:pt idx="14">
                  <c:v>11.04963373</c:v>
                </c:pt>
                <c:pt idx="15">
                  <c:v>10.278764730000001</c:v>
                </c:pt>
                <c:pt idx="16">
                  <c:v>5.315456706</c:v>
                </c:pt>
                <c:pt idx="17">
                  <c:v>11.5565427</c:v>
                </c:pt>
                <c:pt idx="18">
                  <c:v>9.6389264959999998</c:v>
                </c:pt>
                <c:pt idx="19">
                  <c:v>9.0586594320000007</c:v>
                </c:pt>
                <c:pt idx="20">
                  <c:v>9.2414128519999998</c:v>
                </c:pt>
                <c:pt idx="21">
                  <c:v>7.1095627280000002</c:v>
                </c:pt>
                <c:pt idx="22">
                  <c:v>12.48149197</c:v>
                </c:pt>
                <c:pt idx="23">
                  <c:v>11.61118426</c:v>
                </c:pt>
                <c:pt idx="24">
                  <c:v>10.645449599999999</c:v>
                </c:pt>
                <c:pt idx="25">
                  <c:v>0</c:v>
                </c:pt>
                <c:pt idx="26">
                  <c:v>0</c:v>
                </c:pt>
                <c:pt idx="27">
                  <c:v>0</c:v>
                </c:pt>
                <c:pt idx="28">
                  <c:v>0</c:v>
                </c:pt>
                <c:pt idx="29">
                  <c:v>0</c:v>
                </c:pt>
                <c:pt idx="30">
                  <c:v>0</c:v>
                </c:pt>
                <c:pt idx="31">
                  <c:v>9.558829867</c:v>
                </c:pt>
                <c:pt idx="32">
                  <c:v>11.419728510000001</c:v>
                </c:pt>
                <c:pt idx="33">
                  <c:v>12.59500261</c:v>
                </c:pt>
                <c:pt idx="34">
                  <c:v>8.8265643209999993</c:v>
                </c:pt>
                <c:pt idx="35">
                  <c:v>9.2752559699999999</c:v>
                </c:pt>
                <c:pt idx="36">
                  <c:v>11.86805801</c:v>
                </c:pt>
                <c:pt idx="37">
                  <c:v>6.9712677320000003</c:v>
                </c:pt>
                <c:pt idx="38">
                  <c:v>9.092474245</c:v>
                </c:pt>
                <c:pt idx="39">
                  <c:v>8.9943366400000002</c:v>
                </c:pt>
                <c:pt idx="40">
                  <c:v>12.529868909999999</c:v>
                </c:pt>
                <c:pt idx="41">
                  <c:v>14.033336050000001</c:v>
                </c:pt>
                <c:pt idx="42">
                  <c:v>13.276352060000001</c:v>
                </c:pt>
                <c:pt idx="43">
                  <c:v>11.63699366</c:v>
                </c:pt>
                <c:pt idx="44">
                  <c:v>10.075975120000001</c:v>
                </c:pt>
                <c:pt idx="45">
                  <c:v>7.7950492029999996</c:v>
                </c:pt>
                <c:pt idx="46">
                  <c:v>8.8695645110000001</c:v>
                </c:pt>
                <c:pt idx="47">
                  <c:v>10.090433190000001</c:v>
                </c:pt>
                <c:pt idx="48">
                  <c:v>9.7654756549999995</c:v>
                </c:pt>
                <c:pt idx="49">
                  <c:v>11.228448350000001</c:v>
                </c:pt>
                <c:pt idx="50">
                  <c:v>12.10672969</c:v>
                </c:pt>
                <c:pt idx="51">
                  <c:v>12.946798920000001</c:v>
                </c:pt>
                <c:pt idx="52">
                  <c:v>9.8251244930000006</c:v>
                </c:pt>
                <c:pt idx="53">
                  <c:v>8.9613813580000006</c:v>
                </c:pt>
                <c:pt idx="54">
                  <c:v>13.85670767</c:v>
                </c:pt>
                <c:pt idx="55">
                  <c:v>12.60755625</c:v>
                </c:pt>
                <c:pt idx="56">
                  <c:v>9.2933112040000001</c:v>
                </c:pt>
                <c:pt idx="57">
                  <c:v>9.6009175689999999</c:v>
                </c:pt>
                <c:pt idx="58">
                  <c:v>12.579351559999999</c:v>
                </c:pt>
                <c:pt idx="59">
                  <c:v>13.5442982</c:v>
                </c:pt>
                <c:pt idx="60">
                  <c:v>11.628524669999999</c:v>
                </c:pt>
                <c:pt idx="61">
                  <c:v>10.9684515</c:v>
                </c:pt>
                <c:pt idx="62">
                  <c:v>9.906762252</c:v>
                </c:pt>
                <c:pt idx="63">
                  <c:v>13.149525580000001</c:v>
                </c:pt>
                <c:pt idx="64">
                  <c:v>10.30622556</c:v>
                </c:pt>
                <c:pt idx="65">
                  <c:v>8.7947638690000005</c:v>
                </c:pt>
                <c:pt idx="66">
                  <c:v>12.062914320000001</c:v>
                </c:pt>
                <c:pt idx="67">
                  <c:v>10.463341079999999</c:v>
                </c:pt>
                <c:pt idx="68">
                  <c:v>14.298528279999999</c:v>
                </c:pt>
                <c:pt idx="69">
                  <c:v>9.5730352609999994</c:v>
                </c:pt>
                <c:pt idx="70">
                  <c:v>12.783326990000001</c:v>
                </c:pt>
                <c:pt idx="71">
                  <c:v>12.246702170000001</c:v>
                </c:pt>
                <c:pt idx="72">
                  <c:v>9.8184804470000007</c:v>
                </c:pt>
                <c:pt idx="73">
                  <c:v>11.740371740000001</c:v>
                </c:pt>
                <c:pt idx="74">
                  <c:v>10.047336899999999</c:v>
                </c:pt>
                <c:pt idx="75">
                  <c:v>10.64002268</c:v>
                </c:pt>
                <c:pt idx="76">
                  <c:v>12.279840780000001</c:v>
                </c:pt>
                <c:pt idx="77">
                  <c:v>12.04419204</c:v>
                </c:pt>
                <c:pt idx="78">
                  <c:v>13.29778217</c:v>
                </c:pt>
                <c:pt idx="79">
                  <c:v>10.20815657</c:v>
                </c:pt>
                <c:pt idx="80">
                  <c:v>8.8188217630000008</c:v>
                </c:pt>
                <c:pt idx="81">
                  <c:v>13.81619759</c:v>
                </c:pt>
                <c:pt idx="82">
                  <c:v>11.579533830000001</c:v>
                </c:pt>
                <c:pt idx="83">
                  <c:v>12.546473130000001</c:v>
                </c:pt>
                <c:pt idx="84">
                  <c:v>13.59995793</c:v>
                </c:pt>
                <c:pt idx="85">
                  <c:v>12.89354855</c:v>
                </c:pt>
                <c:pt idx="86">
                  <c:v>10.875782429999999</c:v>
                </c:pt>
                <c:pt idx="87">
                  <c:v>13.53578914</c:v>
                </c:pt>
                <c:pt idx="88">
                  <c:v>9.0330645040000004</c:v>
                </c:pt>
                <c:pt idx="89">
                  <c:v>9.2452232379999995</c:v>
                </c:pt>
                <c:pt idx="90">
                  <c:v>9.2604894580000003</c:v>
                </c:pt>
                <c:pt idx="91">
                  <c:v>9.9070771519999994</c:v>
                </c:pt>
                <c:pt idx="92">
                  <c:v>8.521000634</c:v>
                </c:pt>
                <c:pt idx="93">
                  <c:v>8.4581842149999993</c:v>
                </c:pt>
                <c:pt idx="94">
                  <c:v>9.4746934409999994</c:v>
                </c:pt>
                <c:pt idx="95">
                  <c:v>9.8537901229999996</c:v>
                </c:pt>
                <c:pt idx="96">
                  <c:v>9.0151419330000007</c:v>
                </c:pt>
                <c:pt idx="97">
                  <c:v>9.5186147420000005</c:v>
                </c:pt>
                <c:pt idx="98">
                  <c:v>6.7153747399999997</c:v>
                </c:pt>
                <c:pt idx="99">
                  <c:v>7.3983567470000002</c:v>
                </c:pt>
                <c:pt idx="100">
                  <c:v>6.8419123949999996</c:v>
                </c:pt>
                <c:pt idx="101">
                  <c:v>9.1059359400000002</c:v>
                </c:pt>
                <c:pt idx="102">
                  <c:v>11.41001146</c:v>
                </c:pt>
                <c:pt idx="103">
                  <c:v>11.96716417</c:v>
                </c:pt>
                <c:pt idx="104">
                  <c:v>9.6308498020000002</c:v>
                </c:pt>
                <c:pt idx="105">
                  <c:v>10.02052555</c:v>
                </c:pt>
                <c:pt idx="106">
                  <c:v>7.7943884399999996</c:v>
                </c:pt>
                <c:pt idx="107">
                  <c:v>9.2745528559999997</c:v>
                </c:pt>
                <c:pt idx="108">
                  <c:v>7.6357183449999999</c:v>
                </c:pt>
                <c:pt idx="109">
                  <c:v>4.6151159770000003</c:v>
                </c:pt>
                <c:pt idx="110">
                  <c:v>11.245972699999999</c:v>
                </c:pt>
                <c:pt idx="111">
                  <c:v>3.6535841269999998</c:v>
                </c:pt>
                <c:pt idx="112">
                  <c:v>11.492176430000001</c:v>
                </c:pt>
                <c:pt idx="113">
                  <c:v>7.6784977359999997</c:v>
                </c:pt>
                <c:pt idx="114">
                  <c:v>8.7513392959999994</c:v>
                </c:pt>
                <c:pt idx="115">
                  <c:v>8.2399293710000006</c:v>
                </c:pt>
                <c:pt idx="116">
                  <c:v>7.8421158889999996</c:v>
                </c:pt>
                <c:pt idx="117">
                  <c:v>9.320875354</c:v>
                </c:pt>
                <c:pt idx="118">
                  <c:v>9.5174813070000006</c:v>
                </c:pt>
                <c:pt idx="119">
                  <c:v>9.9499931939999993</c:v>
                </c:pt>
                <c:pt idx="120">
                  <c:v>9.7179215879999994</c:v>
                </c:pt>
                <c:pt idx="121">
                  <c:v>9.3960813759999997</c:v>
                </c:pt>
                <c:pt idx="122">
                  <c:v>9.9017408870000008</c:v>
                </c:pt>
                <c:pt idx="123">
                  <c:v>8.9861219460000008</c:v>
                </c:pt>
                <c:pt idx="124">
                  <c:v>9.4770085739999992</c:v>
                </c:pt>
                <c:pt idx="125">
                  <c:v>8.7636199809999997</c:v>
                </c:pt>
                <c:pt idx="126">
                  <c:v>10.03357658</c:v>
                </c:pt>
                <c:pt idx="127">
                  <c:v>8.0073399260000002</c:v>
                </c:pt>
                <c:pt idx="128">
                  <c:v>9.3717993340000003</c:v>
                </c:pt>
                <c:pt idx="129">
                  <c:v>10.24437818</c:v>
                </c:pt>
                <c:pt idx="130">
                  <c:v>7.324374079</c:v>
                </c:pt>
                <c:pt idx="131">
                  <c:v>9.0150677829999992</c:v>
                </c:pt>
                <c:pt idx="132">
                  <c:v>9.5703522779999997</c:v>
                </c:pt>
                <c:pt idx="133">
                  <c:v>9.6221092049999992</c:v>
                </c:pt>
                <c:pt idx="134">
                  <c:v>9.2542914399999994</c:v>
                </c:pt>
                <c:pt idx="135">
                  <c:v>10.18147076</c:v>
                </c:pt>
                <c:pt idx="136">
                  <c:v>11.470322899999999</c:v>
                </c:pt>
                <c:pt idx="137">
                  <c:v>10.304745670000001</c:v>
                </c:pt>
                <c:pt idx="138">
                  <c:v>9.1870411440000002</c:v>
                </c:pt>
                <c:pt idx="139">
                  <c:v>10.838005920000001</c:v>
                </c:pt>
                <c:pt idx="140">
                  <c:v>7.0548333789999997</c:v>
                </c:pt>
                <c:pt idx="141">
                  <c:v>12.92020327</c:v>
                </c:pt>
                <c:pt idx="142">
                  <c:v>9.9930027389999996</c:v>
                </c:pt>
                <c:pt idx="143">
                  <c:v>10.82369712</c:v>
                </c:pt>
                <c:pt idx="144">
                  <c:v>9.0384907709999993</c:v>
                </c:pt>
                <c:pt idx="145">
                  <c:v>9.1778097340000002</c:v>
                </c:pt>
                <c:pt idx="146">
                  <c:v>8.7879346379999994</c:v>
                </c:pt>
                <c:pt idx="147">
                  <c:v>10.254375550000001</c:v>
                </c:pt>
                <c:pt idx="148">
                  <c:v>3.0057328980000002</c:v>
                </c:pt>
                <c:pt idx="149">
                  <c:v>13.422421290000001</c:v>
                </c:pt>
                <c:pt idx="150">
                  <c:v>8.7994767770000006</c:v>
                </c:pt>
                <c:pt idx="151">
                  <c:v>13.874650340000001</c:v>
                </c:pt>
                <c:pt idx="152">
                  <c:v>8.6742953909999994</c:v>
                </c:pt>
                <c:pt idx="153">
                  <c:v>8.7303543579999996</c:v>
                </c:pt>
                <c:pt idx="154">
                  <c:v>9.0835642389999993</c:v>
                </c:pt>
                <c:pt idx="155">
                  <c:v>12.383625990000001</c:v>
                </c:pt>
                <c:pt idx="156">
                  <c:v>8.5247452490000004</c:v>
                </c:pt>
                <c:pt idx="157">
                  <c:v>5.8660914980000003</c:v>
                </c:pt>
                <c:pt idx="158">
                  <c:v>11.50230284</c:v>
                </c:pt>
                <c:pt idx="159">
                  <c:v>10.405437040000001</c:v>
                </c:pt>
                <c:pt idx="160">
                  <c:v>10.121867590000001</c:v>
                </c:pt>
                <c:pt idx="161">
                  <c:v>8.7648517049999999</c:v>
                </c:pt>
                <c:pt idx="162">
                  <c:v>9.7256319449999999</c:v>
                </c:pt>
                <c:pt idx="163">
                  <c:v>8.5222880659999998</c:v>
                </c:pt>
                <c:pt idx="164">
                  <c:v>14.14588307</c:v>
                </c:pt>
                <c:pt idx="165">
                  <c:v>8.9349455259999999</c:v>
                </c:pt>
                <c:pt idx="166">
                  <c:v>11.89505561</c:v>
                </c:pt>
                <c:pt idx="167">
                  <c:v>7.5699177259999999</c:v>
                </c:pt>
                <c:pt idx="168">
                  <c:v>15.1767082</c:v>
                </c:pt>
                <c:pt idx="169">
                  <c:v>13.382433669999999</c:v>
                </c:pt>
                <c:pt idx="170">
                  <c:v>9.2357632029999994</c:v>
                </c:pt>
                <c:pt idx="171">
                  <c:v>14.314837259999999</c:v>
                </c:pt>
                <c:pt idx="172">
                  <c:v>8.9836593419999993</c:v>
                </c:pt>
                <c:pt idx="173">
                  <c:v>13.73097211</c:v>
                </c:pt>
                <c:pt idx="174">
                  <c:v>8.6599420560000002</c:v>
                </c:pt>
                <c:pt idx="175">
                  <c:v>15.15021438</c:v>
                </c:pt>
                <c:pt idx="176">
                  <c:v>11.2064789</c:v>
                </c:pt>
                <c:pt idx="177">
                  <c:v>12.4402782</c:v>
                </c:pt>
                <c:pt idx="178">
                  <c:v>10.823246210000001</c:v>
                </c:pt>
                <c:pt idx="179">
                  <c:v>13.83920966</c:v>
                </c:pt>
                <c:pt idx="180">
                  <c:v>13.49463211</c:v>
                </c:pt>
                <c:pt idx="181">
                  <c:v>16.087255899999999</c:v>
                </c:pt>
                <c:pt idx="182">
                  <c:v>8.5814796829999995</c:v>
                </c:pt>
                <c:pt idx="183">
                  <c:v>11.66762662</c:v>
                </c:pt>
                <c:pt idx="184">
                  <c:v>13.951573939999999</c:v>
                </c:pt>
                <c:pt idx="185">
                  <c:v>12.05683786</c:v>
                </c:pt>
                <c:pt idx="186">
                  <c:v>10.6800382</c:v>
                </c:pt>
                <c:pt idx="187">
                  <c:v>9.1448827070000007</c:v>
                </c:pt>
                <c:pt idx="188">
                  <c:v>9.2675851429999998</c:v>
                </c:pt>
                <c:pt idx="189">
                  <c:v>11.01545707</c:v>
                </c:pt>
                <c:pt idx="190">
                  <c:v>7.9953558180000002</c:v>
                </c:pt>
                <c:pt idx="191">
                  <c:v>8.8651370939999996</c:v>
                </c:pt>
                <c:pt idx="192">
                  <c:v>9.6499371390000004</c:v>
                </c:pt>
                <c:pt idx="193">
                  <c:v>8.224094333</c:v>
                </c:pt>
                <c:pt idx="194">
                  <c:v>9.4934328420000007</c:v>
                </c:pt>
                <c:pt idx="195">
                  <c:v>8.2568802899999998</c:v>
                </c:pt>
                <c:pt idx="196">
                  <c:v>13.49369866</c:v>
                </c:pt>
                <c:pt idx="197">
                  <c:v>9.6881992550000007</c:v>
                </c:pt>
                <c:pt idx="198">
                  <c:v>8.994670352</c:v>
                </c:pt>
                <c:pt idx="199">
                  <c:v>10.693199890000001</c:v>
                </c:pt>
                <c:pt idx="200">
                  <c:v>8.7137384359999999</c:v>
                </c:pt>
                <c:pt idx="201">
                  <c:v>11.452228180000001</c:v>
                </c:pt>
                <c:pt idx="202">
                  <c:v>11.5651113</c:v>
                </c:pt>
                <c:pt idx="203">
                  <c:v>9.1383961320000004</c:v>
                </c:pt>
                <c:pt idx="204">
                  <c:v>8.8386195910000005</c:v>
                </c:pt>
                <c:pt idx="205">
                  <c:v>9.3409282499999993</c:v>
                </c:pt>
                <c:pt idx="206">
                  <c:v>9.7540076550000006</c:v>
                </c:pt>
                <c:pt idx="207">
                  <c:v>12.059088170000001</c:v>
                </c:pt>
                <c:pt idx="208">
                  <c:v>9.2657596410000007</c:v>
                </c:pt>
                <c:pt idx="209">
                  <c:v>13.055139499999999</c:v>
                </c:pt>
                <c:pt idx="210">
                  <c:v>11.97987575</c:v>
                </c:pt>
                <c:pt idx="211">
                  <c:v>10.76630201</c:v>
                </c:pt>
                <c:pt idx="212">
                  <c:v>9.3522181389999997</c:v>
                </c:pt>
                <c:pt idx="213">
                  <c:v>11.331466949999999</c:v>
                </c:pt>
                <c:pt idx="214">
                  <c:v>8.9663466290000002</c:v>
                </c:pt>
                <c:pt idx="215">
                  <c:v>8.8485732939999995</c:v>
                </c:pt>
                <c:pt idx="216">
                  <c:v>9.2245337559999996</c:v>
                </c:pt>
                <c:pt idx="217">
                  <c:v>8.7657777419999992</c:v>
                </c:pt>
                <c:pt idx="218">
                  <c:v>9.3253948900000001</c:v>
                </c:pt>
                <c:pt idx="219">
                  <c:v>8.8393793630000008</c:v>
                </c:pt>
                <c:pt idx="220">
                  <c:v>11.31452889</c:v>
                </c:pt>
                <c:pt idx="221">
                  <c:v>9.4367379079999996</c:v>
                </c:pt>
                <c:pt idx="222">
                  <c:v>9.6909964290000001</c:v>
                </c:pt>
                <c:pt idx="223">
                  <c:v>10.079952349999999</c:v>
                </c:pt>
                <c:pt idx="224">
                  <c:v>11.17803099</c:v>
                </c:pt>
                <c:pt idx="225">
                  <c:v>11.443634749999999</c:v>
                </c:pt>
                <c:pt idx="226">
                  <c:v>9.5549889750000006</c:v>
                </c:pt>
                <c:pt idx="227">
                  <c:v>0</c:v>
                </c:pt>
                <c:pt idx="228">
                  <c:v>9.8327566110000006</c:v>
                </c:pt>
                <c:pt idx="229">
                  <c:v>9.9776251029999994</c:v>
                </c:pt>
                <c:pt idx="230">
                  <c:v>9.3359428690000001</c:v>
                </c:pt>
                <c:pt idx="231">
                  <c:v>12.987317770000001</c:v>
                </c:pt>
                <c:pt idx="232">
                  <c:v>8.9306590610000001</c:v>
                </c:pt>
                <c:pt idx="233">
                  <c:v>8.3854919599999995</c:v>
                </c:pt>
                <c:pt idx="234">
                  <c:v>9.0432355609999995</c:v>
                </c:pt>
                <c:pt idx="235">
                  <c:v>8.6321694400000002</c:v>
                </c:pt>
                <c:pt idx="236">
                  <c:v>8.5734262290000007</c:v>
                </c:pt>
                <c:pt idx="237">
                  <c:v>10.929428059999999</c:v>
                </c:pt>
                <c:pt idx="238">
                  <c:v>11.44340375</c:v>
                </c:pt>
                <c:pt idx="239">
                  <c:v>11.509520220000001</c:v>
                </c:pt>
                <c:pt idx="240">
                  <c:v>11.49715307</c:v>
                </c:pt>
              </c:numCache>
            </c:numRef>
          </c:val>
        </c:ser>
        <c:ser>
          <c:idx val="1"/>
          <c:order val="1"/>
          <c:tx>
            <c:strRef>
              <c:f>Sheet1!$E$1</c:f>
              <c:strCache>
                <c:ptCount val="1"/>
                <c:pt idx="0">
                  <c:v>HPAT15</c:v>
                </c:pt>
              </c:strCache>
            </c:strRef>
          </c:tx>
          <c:spPr>
            <a:solidFill>
              <a:srgbClr val="FF0000"/>
            </a:solidFill>
            <a:ln>
              <a:noFill/>
            </a:ln>
            <a:effectLst/>
          </c:spPr>
          <c:cat>
            <c:strRef>
              <c:f>Sheet1!$C$2:$C$242</c:f>
              <c:strCache>
                <c:ptCount val="241"/>
                <c:pt idx="0">
                  <c:v>Embryo1_12</c:v>
                </c:pt>
                <c:pt idx="1">
                  <c:v>Embryo1_17</c:v>
                </c:pt>
                <c:pt idx="2">
                  <c:v>Embryo1_23</c:v>
                </c:pt>
                <c:pt idx="3">
                  <c:v>Embryo1_30</c:v>
                </c:pt>
                <c:pt idx="4">
                  <c:v>Embryo1_31</c:v>
                </c:pt>
                <c:pt idx="5">
                  <c:v>Embryo1_32</c:v>
                </c:pt>
                <c:pt idx="6">
                  <c:v>Embryo1_34</c:v>
                </c:pt>
                <c:pt idx="7">
                  <c:v>Embryo1_40</c:v>
                </c:pt>
                <c:pt idx="8">
                  <c:v>Embryo1_43</c:v>
                </c:pt>
                <c:pt idx="9">
                  <c:v>Embryo1_46</c:v>
                </c:pt>
                <c:pt idx="10">
                  <c:v>Embryo1_47</c:v>
                </c:pt>
                <c:pt idx="11">
                  <c:v>Embryo1_48</c:v>
                </c:pt>
                <c:pt idx="12">
                  <c:v>Embryo1_51</c:v>
                </c:pt>
                <c:pt idx="13">
                  <c:v>Embryo2_1</c:v>
                </c:pt>
                <c:pt idx="14">
                  <c:v>Embryo2_6</c:v>
                </c:pt>
                <c:pt idx="15">
                  <c:v>Embryo2_7</c:v>
                </c:pt>
                <c:pt idx="16">
                  <c:v>Embryo2_10</c:v>
                </c:pt>
                <c:pt idx="17">
                  <c:v>Embryo2_12</c:v>
                </c:pt>
                <c:pt idx="18">
                  <c:v>Embryo2_13</c:v>
                </c:pt>
                <c:pt idx="19">
                  <c:v>Embryo2_20</c:v>
                </c:pt>
                <c:pt idx="20">
                  <c:v>Embryo2_23</c:v>
                </c:pt>
                <c:pt idx="21">
                  <c:v>Embryo2_28</c:v>
                </c:pt>
                <c:pt idx="22">
                  <c:v>Embryo2_31</c:v>
                </c:pt>
                <c:pt idx="23">
                  <c:v>Embryo2_33</c:v>
                </c:pt>
                <c:pt idx="24">
                  <c:v>Embryo2_35</c:v>
                </c:pt>
                <c:pt idx="25">
                  <c:v>Embryo1_8</c:v>
                </c:pt>
                <c:pt idx="26">
                  <c:v>Embryo1_10</c:v>
                </c:pt>
                <c:pt idx="27">
                  <c:v>Embryo1_37</c:v>
                </c:pt>
                <c:pt idx="28">
                  <c:v>Embryo1_50</c:v>
                </c:pt>
                <c:pt idx="29">
                  <c:v>Embryo1_53</c:v>
                </c:pt>
                <c:pt idx="30">
                  <c:v>Embryo2_25</c:v>
                </c:pt>
                <c:pt idx="31">
                  <c:v>Embryo3_1</c:v>
                </c:pt>
                <c:pt idx="32">
                  <c:v>Embryo3_2</c:v>
                </c:pt>
                <c:pt idx="33">
                  <c:v>Embryo3_5</c:v>
                </c:pt>
                <c:pt idx="34">
                  <c:v>Embryo3_7</c:v>
                </c:pt>
                <c:pt idx="35">
                  <c:v>Embryo3_10</c:v>
                </c:pt>
                <c:pt idx="36">
                  <c:v>Embryo3_11</c:v>
                </c:pt>
                <c:pt idx="37">
                  <c:v>Embryo3_12</c:v>
                </c:pt>
                <c:pt idx="38">
                  <c:v>Embryo3_14</c:v>
                </c:pt>
                <c:pt idx="39">
                  <c:v>Embryo3_15</c:v>
                </c:pt>
                <c:pt idx="40">
                  <c:v>Embryo3_18</c:v>
                </c:pt>
                <c:pt idx="41">
                  <c:v>Embryo3_20</c:v>
                </c:pt>
                <c:pt idx="42">
                  <c:v>Embryo3_22</c:v>
                </c:pt>
                <c:pt idx="43">
                  <c:v>Embryo3_27</c:v>
                </c:pt>
                <c:pt idx="44">
                  <c:v>Embryo3_35</c:v>
                </c:pt>
                <c:pt idx="45">
                  <c:v>Embryo3_39</c:v>
                </c:pt>
                <c:pt idx="46">
                  <c:v>Embryo3_44</c:v>
                </c:pt>
                <c:pt idx="47">
                  <c:v>Embryo3_49</c:v>
                </c:pt>
                <c:pt idx="48">
                  <c:v>Embryo3_51</c:v>
                </c:pt>
                <c:pt idx="49">
                  <c:v>Embryo3_55</c:v>
                </c:pt>
                <c:pt idx="50">
                  <c:v>Embryo3_62</c:v>
                </c:pt>
                <c:pt idx="51">
                  <c:v>Embryo3_67</c:v>
                </c:pt>
                <c:pt idx="52">
                  <c:v>Embryo3_68</c:v>
                </c:pt>
                <c:pt idx="53">
                  <c:v>Embryo3_70</c:v>
                </c:pt>
                <c:pt idx="54">
                  <c:v>Embryo3_72</c:v>
                </c:pt>
                <c:pt idx="55">
                  <c:v>Embryo3_73</c:v>
                </c:pt>
                <c:pt idx="56">
                  <c:v>Embryo3_78</c:v>
                </c:pt>
                <c:pt idx="57">
                  <c:v>Embryo3_81</c:v>
                </c:pt>
                <c:pt idx="58">
                  <c:v>Embryo3_82</c:v>
                </c:pt>
                <c:pt idx="59">
                  <c:v>Embryo4_2</c:v>
                </c:pt>
                <c:pt idx="60">
                  <c:v>Embryo4_3</c:v>
                </c:pt>
                <c:pt idx="61">
                  <c:v>Embryo4_4</c:v>
                </c:pt>
                <c:pt idx="62">
                  <c:v>Embryo4_5</c:v>
                </c:pt>
                <c:pt idx="63">
                  <c:v>Embryo4_8</c:v>
                </c:pt>
                <c:pt idx="64">
                  <c:v>Embryo4_10</c:v>
                </c:pt>
                <c:pt idx="65">
                  <c:v>Embryo4_11</c:v>
                </c:pt>
                <c:pt idx="66">
                  <c:v>Embryo4_14</c:v>
                </c:pt>
                <c:pt idx="67">
                  <c:v>Embryo4_15</c:v>
                </c:pt>
                <c:pt idx="68">
                  <c:v>Embryo4_16</c:v>
                </c:pt>
                <c:pt idx="69">
                  <c:v>Embryo4_21</c:v>
                </c:pt>
                <c:pt idx="70">
                  <c:v>Embryo4_32</c:v>
                </c:pt>
                <c:pt idx="71">
                  <c:v>Embryo4_37</c:v>
                </c:pt>
                <c:pt idx="72">
                  <c:v>Embryo4_39</c:v>
                </c:pt>
                <c:pt idx="73">
                  <c:v>Embryo4_40</c:v>
                </c:pt>
                <c:pt idx="74">
                  <c:v>Embryo4_41</c:v>
                </c:pt>
                <c:pt idx="75">
                  <c:v>Embryo4_43</c:v>
                </c:pt>
                <c:pt idx="76">
                  <c:v>Embryo4_46</c:v>
                </c:pt>
                <c:pt idx="77">
                  <c:v>Embryo4_47</c:v>
                </c:pt>
                <c:pt idx="78">
                  <c:v>Embryo4_50</c:v>
                </c:pt>
                <c:pt idx="79">
                  <c:v>Embryo4_52</c:v>
                </c:pt>
                <c:pt idx="80">
                  <c:v>Embryo4_54</c:v>
                </c:pt>
                <c:pt idx="81">
                  <c:v>Embryo4_55</c:v>
                </c:pt>
                <c:pt idx="82">
                  <c:v>Embryo4_59</c:v>
                </c:pt>
                <c:pt idx="83">
                  <c:v>Embryo4_60</c:v>
                </c:pt>
                <c:pt idx="84">
                  <c:v>Embryo4_61</c:v>
                </c:pt>
                <c:pt idx="85">
                  <c:v>Embryo4_62</c:v>
                </c:pt>
                <c:pt idx="86">
                  <c:v>Embryo4_65</c:v>
                </c:pt>
                <c:pt idx="87">
                  <c:v>Embryo4_70</c:v>
                </c:pt>
                <c:pt idx="88">
                  <c:v>Embryo1_6</c:v>
                </c:pt>
                <c:pt idx="89">
                  <c:v>Embryo1_13</c:v>
                </c:pt>
                <c:pt idx="90">
                  <c:v>Embryo2_11</c:v>
                </c:pt>
                <c:pt idx="91">
                  <c:v>Embryo2_24</c:v>
                </c:pt>
                <c:pt idx="92">
                  <c:v>Embryo3_21</c:v>
                </c:pt>
                <c:pt idx="93">
                  <c:v>Embryo3_26</c:v>
                </c:pt>
                <c:pt idx="94">
                  <c:v>Embryo3_28</c:v>
                </c:pt>
                <c:pt idx="95">
                  <c:v>Embryo3_32</c:v>
                </c:pt>
                <c:pt idx="96">
                  <c:v>Embryo3_45</c:v>
                </c:pt>
                <c:pt idx="97">
                  <c:v>Embryo3_48</c:v>
                </c:pt>
                <c:pt idx="98">
                  <c:v>Embryo3_52</c:v>
                </c:pt>
                <c:pt idx="99">
                  <c:v>Embryo3_54</c:v>
                </c:pt>
                <c:pt idx="100">
                  <c:v>Embryo3_60</c:v>
                </c:pt>
                <c:pt idx="101">
                  <c:v>Embryo3_64</c:v>
                </c:pt>
                <c:pt idx="102">
                  <c:v>Embryo3_80</c:v>
                </c:pt>
                <c:pt idx="103">
                  <c:v>Embryo4_7</c:v>
                </c:pt>
                <c:pt idx="104">
                  <c:v>Embryo4_20</c:v>
                </c:pt>
                <c:pt idx="105">
                  <c:v>Embryo4_25</c:v>
                </c:pt>
                <c:pt idx="106">
                  <c:v>Embryo4_28</c:v>
                </c:pt>
                <c:pt idx="107">
                  <c:v>Embryo4_29</c:v>
                </c:pt>
                <c:pt idx="108">
                  <c:v>Embryo4_34</c:v>
                </c:pt>
                <c:pt idx="109">
                  <c:v>Embryo4_35</c:v>
                </c:pt>
                <c:pt idx="110">
                  <c:v>Embryo4_49</c:v>
                </c:pt>
                <c:pt idx="111">
                  <c:v>Embryo4_58</c:v>
                </c:pt>
                <c:pt idx="112">
                  <c:v>Embryo4_18</c:v>
                </c:pt>
                <c:pt idx="113">
                  <c:v>Embryo1_7</c:v>
                </c:pt>
                <c:pt idx="114">
                  <c:v>Embryo1_18</c:v>
                </c:pt>
                <c:pt idx="115">
                  <c:v>Embryo1_22</c:v>
                </c:pt>
                <c:pt idx="116">
                  <c:v>Embryo1_35</c:v>
                </c:pt>
                <c:pt idx="117">
                  <c:v>Embryo1_42</c:v>
                </c:pt>
                <c:pt idx="118">
                  <c:v>Embryo1_44</c:v>
                </c:pt>
                <c:pt idx="119">
                  <c:v>Embryo1_45</c:v>
                </c:pt>
                <c:pt idx="120">
                  <c:v>Embryo1_49</c:v>
                </c:pt>
                <c:pt idx="121">
                  <c:v>Embryo2_9</c:v>
                </c:pt>
                <c:pt idx="122">
                  <c:v>Embryo2_14</c:v>
                </c:pt>
                <c:pt idx="123">
                  <c:v>Embryo2_15</c:v>
                </c:pt>
                <c:pt idx="124">
                  <c:v>Embryo2_16</c:v>
                </c:pt>
                <c:pt idx="125">
                  <c:v>Embryo2_18</c:v>
                </c:pt>
                <c:pt idx="126">
                  <c:v>Embryo2_21</c:v>
                </c:pt>
                <c:pt idx="127">
                  <c:v>Embryo2_22</c:v>
                </c:pt>
                <c:pt idx="128">
                  <c:v>Embryo2_32</c:v>
                </c:pt>
                <c:pt idx="129">
                  <c:v>Embryo3_8</c:v>
                </c:pt>
                <c:pt idx="130">
                  <c:v>Embryo3_23</c:v>
                </c:pt>
                <c:pt idx="131">
                  <c:v>Embryo3_24</c:v>
                </c:pt>
                <c:pt idx="132">
                  <c:v>Embryo3_29</c:v>
                </c:pt>
                <c:pt idx="133">
                  <c:v>Embryo3_30</c:v>
                </c:pt>
                <c:pt idx="134">
                  <c:v>Embryo3_65</c:v>
                </c:pt>
                <c:pt idx="135">
                  <c:v>Embryo3_66</c:v>
                </c:pt>
                <c:pt idx="136">
                  <c:v>Embryo3_74</c:v>
                </c:pt>
                <c:pt idx="137">
                  <c:v>Embryo3_75</c:v>
                </c:pt>
                <c:pt idx="138">
                  <c:v>Embryo3_77</c:v>
                </c:pt>
                <c:pt idx="139">
                  <c:v>Embryo3_79</c:v>
                </c:pt>
                <c:pt idx="140">
                  <c:v>Embryo4_1</c:v>
                </c:pt>
                <c:pt idx="141">
                  <c:v>Embryo4_19</c:v>
                </c:pt>
                <c:pt idx="142">
                  <c:v>Embryo4_30</c:v>
                </c:pt>
                <c:pt idx="143">
                  <c:v>Embryo4_45</c:v>
                </c:pt>
                <c:pt idx="144">
                  <c:v>Embryo4_71</c:v>
                </c:pt>
                <c:pt idx="145">
                  <c:v>Embryo1_28</c:v>
                </c:pt>
                <c:pt idx="146">
                  <c:v>Embryo1_2</c:v>
                </c:pt>
                <c:pt idx="147">
                  <c:v>Embryo1_3</c:v>
                </c:pt>
                <c:pt idx="148">
                  <c:v>Embryo1_5</c:v>
                </c:pt>
                <c:pt idx="149">
                  <c:v>Embryo1_9</c:v>
                </c:pt>
                <c:pt idx="150">
                  <c:v>Embryo1_11</c:v>
                </c:pt>
                <c:pt idx="151">
                  <c:v>Embryo1_16</c:v>
                </c:pt>
                <c:pt idx="152">
                  <c:v>Embryo1_19</c:v>
                </c:pt>
                <c:pt idx="153">
                  <c:v>Embryo1_20</c:v>
                </c:pt>
                <c:pt idx="154">
                  <c:v>Embryo1_24</c:v>
                </c:pt>
                <c:pt idx="155">
                  <c:v>Embryo1_25</c:v>
                </c:pt>
                <c:pt idx="156">
                  <c:v>Embryo1_26</c:v>
                </c:pt>
                <c:pt idx="157">
                  <c:v>Embryo1_27</c:v>
                </c:pt>
                <c:pt idx="158">
                  <c:v>Embryo1_29</c:v>
                </c:pt>
                <c:pt idx="159">
                  <c:v>Embryo1_33</c:v>
                </c:pt>
                <c:pt idx="160">
                  <c:v>Embryo1_36</c:v>
                </c:pt>
                <c:pt idx="161">
                  <c:v>Embryo1_38</c:v>
                </c:pt>
                <c:pt idx="162">
                  <c:v>Embryo1_39</c:v>
                </c:pt>
                <c:pt idx="163">
                  <c:v>Embryo1_52</c:v>
                </c:pt>
                <c:pt idx="164">
                  <c:v>Embryo2_2</c:v>
                </c:pt>
                <c:pt idx="165">
                  <c:v>Embryo2_3</c:v>
                </c:pt>
                <c:pt idx="166">
                  <c:v>Embryo2_4</c:v>
                </c:pt>
                <c:pt idx="167">
                  <c:v>Embryo2_5</c:v>
                </c:pt>
                <c:pt idx="168">
                  <c:v>Embryo2_8</c:v>
                </c:pt>
                <c:pt idx="169">
                  <c:v>Embryo2_19</c:v>
                </c:pt>
                <c:pt idx="170">
                  <c:v>Embryo2_26</c:v>
                </c:pt>
                <c:pt idx="171">
                  <c:v>Embryo2_27</c:v>
                </c:pt>
                <c:pt idx="172">
                  <c:v>Embryo2_29</c:v>
                </c:pt>
                <c:pt idx="173">
                  <c:v>Embryo2_30</c:v>
                </c:pt>
                <c:pt idx="174">
                  <c:v>Embryo2_34</c:v>
                </c:pt>
                <c:pt idx="175">
                  <c:v>Embryo3_3</c:v>
                </c:pt>
                <c:pt idx="176">
                  <c:v>Embryo3_4</c:v>
                </c:pt>
                <c:pt idx="177">
                  <c:v>Embryo3_6</c:v>
                </c:pt>
                <c:pt idx="178">
                  <c:v>Embryo3_9</c:v>
                </c:pt>
                <c:pt idx="179">
                  <c:v>Embryo3_16</c:v>
                </c:pt>
                <c:pt idx="180">
                  <c:v>Embryo3_17</c:v>
                </c:pt>
                <c:pt idx="181">
                  <c:v>Embryo3_19</c:v>
                </c:pt>
                <c:pt idx="182">
                  <c:v>Embryo3_31</c:v>
                </c:pt>
                <c:pt idx="183">
                  <c:v>Embryo3_33</c:v>
                </c:pt>
                <c:pt idx="184">
                  <c:v>Embryo3_34</c:v>
                </c:pt>
                <c:pt idx="185">
                  <c:v>Embryo3_36</c:v>
                </c:pt>
                <c:pt idx="186">
                  <c:v>Embryo3_38</c:v>
                </c:pt>
                <c:pt idx="187">
                  <c:v>Embryo3_41</c:v>
                </c:pt>
                <c:pt idx="188">
                  <c:v>Embryo3_42</c:v>
                </c:pt>
                <c:pt idx="189">
                  <c:v>Embryo3_43</c:v>
                </c:pt>
                <c:pt idx="190">
                  <c:v>Embryo3_46</c:v>
                </c:pt>
                <c:pt idx="191">
                  <c:v>Embryo3_47</c:v>
                </c:pt>
                <c:pt idx="192">
                  <c:v>Embryo3_50</c:v>
                </c:pt>
                <c:pt idx="193">
                  <c:v>Embryo3_53</c:v>
                </c:pt>
                <c:pt idx="194">
                  <c:v>Embryo3_56</c:v>
                </c:pt>
                <c:pt idx="195">
                  <c:v>Embryo3_57</c:v>
                </c:pt>
                <c:pt idx="196">
                  <c:v>Embryo3_58</c:v>
                </c:pt>
                <c:pt idx="197">
                  <c:v>Embryo3_59</c:v>
                </c:pt>
                <c:pt idx="198">
                  <c:v>Embryo3_61</c:v>
                </c:pt>
                <c:pt idx="199">
                  <c:v>Embryo3_63</c:v>
                </c:pt>
                <c:pt idx="200">
                  <c:v>Embryo3_69</c:v>
                </c:pt>
                <c:pt idx="201">
                  <c:v>Embryo3_71</c:v>
                </c:pt>
                <c:pt idx="202">
                  <c:v>Embryo4_6</c:v>
                </c:pt>
                <c:pt idx="203">
                  <c:v>Embryo4_9</c:v>
                </c:pt>
                <c:pt idx="204">
                  <c:v>Embryo4_12</c:v>
                </c:pt>
                <c:pt idx="205">
                  <c:v>Embryo4_13</c:v>
                </c:pt>
                <c:pt idx="206">
                  <c:v>Embryo4_17</c:v>
                </c:pt>
                <c:pt idx="207">
                  <c:v>Embryo4_22</c:v>
                </c:pt>
                <c:pt idx="208">
                  <c:v>Embryo4_23</c:v>
                </c:pt>
                <c:pt idx="209">
                  <c:v>Embryo4_26</c:v>
                </c:pt>
                <c:pt idx="210">
                  <c:v>Embryo4_27</c:v>
                </c:pt>
                <c:pt idx="211">
                  <c:v>Embryo4_31</c:v>
                </c:pt>
                <c:pt idx="212">
                  <c:v>Embryo4_33</c:v>
                </c:pt>
                <c:pt idx="213">
                  <c:v>Embryo4_36</c:v>
                </c:pt>
                <c:pt idx="214">
                  <c:v>Embryo4_38</c:v>
                </c:pt>
                <c:pt idx="215">
                  <c:v>Embryo4_42</c:v>
                </c:pt>
                <c:pt idx="216">
                  <c:v>Embryo4_44</c:v>
                </c:pt>
                <c:pt idx="217">
                  <c:v>Embryo4_48</c:v>
                </c:pt>
                <c:pt idx="218">
                  <c:v>Embryo4_51</c:v>
                </c:pt>
                <c:pt idx="219">
                  <c:v>Embryo4_53</c:v>
                </c:pt>
                <c:pt idx="220">
                  <c:v>Embryo4_57</c:v>
                </c:pt>
                <c:pt idx="221">
                  <c:v>Embryo4_63</c:v>
                </c:pt>
                <c:pt idx="222">
                  <c:v>Embryo4_64</c:v>
                </c:pt>
                <c:pt idx="223">
                  <c:v>Embryo4_66</c:v>
                </c:pt>
                <c:pt idx="224">
                  <c:v>Embryo4_67</c:v>
                </c:pt>
                <c:pt idx="225">
                  <c:v>Embryo4_68</c:v>
                </c:pt>
                <c:pt idx="226">
                  <c:v>Embryo4_69</c:v>
                </c:pt>
                <c:pt idx="227">
                  <c:v>Embryo2_17</c:v>
                </c:pt>
                <c:pt idx="228">
                  <c:v>Embryo1_4</c:v>
                </c:pt>
                <c:pt idx="229">
                  <c:v>Embryo1_14</c:v>
                </c:pt>
                <c:pt idx="230">
                  <c:v>Embryo1_15</c:v>
                </c:pt>
                <c:pt idx="231">
                  <c:v>Embryo1_21</c:v>
                </c:pt>
                <c:pt idx="232">
                  <c:v>Embryo3_13</c:v>
                </c:pt>
                <c:pt idx="233">
                  <c:v>Embryo3_25</c:v>
                </c:pt>
                <c:pt idx="234">
                  <c:v>Embryo3_37</c:v>
                </c:pt>
                <c:pt idx="235">
                  <c:v>Embryo3_40</c:v>
                </c:pt>
                <c:pt idx="236">
                  <c:v>Embryo3_76</c:v>
                </c:pt>
                <c:pt idx="237">
                  <c:v>Embryo4_24</c:v>
                </c:pt>
                <c:pt idx="238">
                  <c:v>Embryo4_56</c:v>
                </c:pt>
                <c:pt idx="239">
                  <c:v>Embryo1_1</c:v>
                </c:pt>
                <c:pt idx="240">
                  <c:v>Embryo1_41</c:v>
                </c:pt>
              </c:strCache>
            </c:strRef>
          </c:cat>
          <c:val>
            <c:numRef>
              <c:f>Sheet1!$E$2:$E$242</c:f>
              <c:numCache>
                <c:formatCode>General</c:formatCode>
                <c:ptCount val="241"/>
                <c:pt idx="0">
                  <c:v>6.9996444860000002</c:v>
                </c:pt>
                <c:pt idx="1">
                  <c:v>9.8138476430000008</c:v>
                </c:pt>
                <c:pt idx="2">
                  <c:v>2.3446043009999999</c:v>
                </c:pt>
                <c:pt idx="3">
                  <c:v>3.3524538100000001</c:v>
                </c:pt>
                <c:pt idx="4">
                  <c:v>4.0931578569999996</c:v>
                </c:pt>
                <c:pt idx="5">
                  <c:v>4.4251827239999999</c:v>
                </c:pt>
                <c:pt idx="6">
                  <c:v>8.6669600990000006</c:v>
                </c:pt>
                <c:pt idx="7">
                  <c:v>5.1696126250000001</c:v>
                </c:pt>
                <c:pt idx="8">
                  <c:v>4.320395435</c:v>
                </c:pt>
                <c:pt idx="9">
                  <c:v>3.5046871369999999</c:v>
                </c:pt>
                <c:pt idx="10">
                  <c:v>8.2352069970000006</c:v>
                </c:pt>
                <c:pt idx="11">
                  <c:v>6.9996444860000002</c:v>
                </c:pt>
                <c:pt idx="12">
                  <c:v>6.2256769739999998</c:v>
                </c:pt>
                <c:pt idx="13">
                  <c:v>3.6770208360000001</c:v>
                </c:pt>
                <c:pt idx="14">
                  <c:v>8.7807667550000001</c:v>
                </c:pt>
                <c:pt idx="15">
                  <c:v>7.7136675930000003</c:v>
                </c:pt>
                <c:pt idx="16">
                  <c:v>2.8077451180000002</c:v>
                </c:pt>
                <c:pt idx="17">
                  <c:v>6.9996444860000002</c:v>
                </c:pt>
                <c:pt idx="18">
                  <c:v>4.8747249200000002</c:v>
                </c:pt>
                <c:pt idx="19">
                  <c:v>6.6067635090000003</c:v>
                </c:pt>
                <c:pt idx="20">
                  <c:v>6.0686000870000001</c:v>
                </c:pt>
                <c:pt idx="21">
                  <c:v>3.3608375960000001</c:v>
                </c:pt>
                <c:pt idx="22">
                  <c:v>6.060982836</c:v>
                </c:pt>
                <c:pt idx="23">
                  <c:v>7.1275798229999996</c:v>
                </c:pt>
                <c:pt idx="24">
                  <c:v>6.9996444860000002</c:v>
                </c:pt>
                <c:pt idx="25">
                  <c:v>1.3207421239999999</c:v>
                </c:pt>
                <c:pt idx="26">
                  <c:v>5.3911759789999998</c:v>
                </c:pt>
                <c:pt idx="27">
                  <c:v>3.3331441979999998</c:v>
                </c:pt>
                <c:pt idx="28">
                  <c:v>3.5046871369999999</c:v>
                </c:pt>
                <c:pt idx="29">
                  <c:v>3.2649024780000002</c:v>
                </c:pt>
                <c:pt idx="30">
                  <c:v>3.771597479</c:v>
                </c:pt>
                <c:pt idx="31">
                  <c:v>2.9409640420000001</c:v>
                </c:pt>
                <c:pt idx="32">
                  <c:v>4.7284095920000002</c:v>
                </c:pt>
                <c:pt idx="33">
                  <c:v>9.4504517640000003</c:v>
                </c:pt>
                <c:pt idx="34">
                  <c:v>3.422435712</c:v>
                </c:pt>
                <c:pt idx="35">
                  <c:v>3.9183800799999999</c:v>
                </c:pt>
                <c:pt idx="36">
                  <c:v>8.2725597010000005</c:v>
                </c:pt>
                <c:pt idx="37">
                  <c:v>1.344515584</c:v>
                </c:pt>
                <c:pt idx="38">
                  <c:v>2.007855905</c:v>
                </c:pt>
                <c:pt idx="39">
                  <c:v>2.7393570770000002</c:v>
                </c:pt>
                <c:pt idx="40">
                  <c:v>6.9653623610000004</c:v>
                </c:pt>
                <c:pt idx="41">
                  <c:v>4.8005998590000001</c:v>
                </c:pt>
                <c:pt idx="42">
                  <c:v>7.0386809750000001</c:v>
                </c:pt>
                <c:pt idx="43">
                  <c:v>7.1907242340000002</c:v>
                </c:pt>
                <c:pt idx="44">
                  <c:v>5.0142994700000001</c:v>
                </c:pt>
                <c:pt idx="45">
                  <c:v>1.637225178</c:v>
                </c:pt>
                <c:pt idx="46">
                  <c:v>1.1192893690000001</c:v>
                </c:pt>
                <c:pt idx="47">
                  <c:v>2.193679317</c:v>
                </c:pt>
                <c:pt idx="48">
                  <c:v>1.7854284570000001</c:v>
                </c:pt>
                <c:pt idx="49">
                  <c:v>5.797896165</c:v>
                </c:pt>
                <c:pt idx="50">
                  <c:v>8.4933353139999994</c:v>
                </c:pt>
                <c:pt idx="51">
                  <c:v>7.9847093869999997</c:v>
                </c:pt>
                <c:pt idx="52">
                  <c:v>3.834658106</c:v>
                </c:pt>
                <c:pt idx="53">
                  <c:v>5.2005610610000002</c:v>
                </c:pt>
                <c:pt idx="54">
                  <c:v>10.75884697</c:v>
                </c:pt>
                <c:pt idx="55">
                  <c:v>7.5783694400000003</c:v>
                </c:pt>
                <c:pt idx="56">
                  <c:v>5.8549002149999998</c:v>
                </c:pt>
                <c:pt idx="57">
                  <c:v>5.0759789639999999</c:v>
                </c:pt>
                <c:pt idx="58">
                  <c:v>3.5754429669999999</c:v>
                </c:pt>
                <c:pt idx="59">
                  <c:v>7.7933786490000001</c:v>
                </c:pt>
                <c:pt idx="60">
                  <c:v>4.1727611180000004</c:v>
                </c:pt>
                <c:pt idx="61">
                  <c:v>6.2491337720000004</c:v>
                </c:pt>
                <c:pt idx="62">
                  <c:v>3.2050296409999999</c:v>
                </c:pt>
                <c:pt idx="63">
                  <c:v>7.7856595080000002</c:v>
                </c:pt>
                <c:pt idx="64">
                  <c:v>5.4374708829999996</c:v>
                </c:pt>
                <c:pt idx="65">
                  <c:v>3.1561638919999999</c:v>
                </c:pt>
                <c:pt idx="66">
                  <c:v>5.6336095909999999</c:v>
                </c:pt>
                <c:pt idx="67">
                  <c:v>4.2018126479999998</c:v>
                </c:pt>
                <c:pt idx="68">
                  <c:v>9.6656174139999997</c:v>
                </c:pt>
                <c:pt idx="69">
                  <c:v>4.325882086</c:v>
                </c:pt>
                <c:pt idx="70">
                  <c:v>0.51203456000000003</c:v>
                </c:pt>
                <c:pt idx="71">
                  <c:v>9.8031656989999991</c:v>
                </c:pt>
                <c:pt idx="72">
                  <c:v>3.7969780219999998</c:v>
                </c:pt>
                <c:pt idx="73">
                  <c:v>6.9996444860000002</c:v>
                </c:pt>
                <c:pt idx="74">
                  <c:v>6.0444262530000001</c:v>
                </c:pt>
                <c:pt idx="75">
                  <c:v>8.2257923890000004</c:v>
                </c:pt>
                <c:pt idx="76">
                  <c:v>7.0318262139999996</c:v>
                </c:pt>
                <c:pt idx="77">
                  <c:v>6.9996444860000002</c:v>
                </c:pt>
                <c:pt idx="78">
                  <c:v>10.436924769999999</c:v>
                </c:pt>
                <c:pt idx="79">
                  <c:v>7.7112409</c:v>
                </c:pt>
                <c:pt idx="80">
                  <c:v>2.9296597539999998</c:v>
                </c:pt>
                <c:pt idx="81">
                  <c:v>3.823960209</c:v>
                </c:pt>
                <c:pt idx="82">
                  <c:v>7.4497463310000001</c:v>
                </c:pt>
                <c:pt idx="83">
                  <c:v>9.2682531949999998</c:v>
                </c:pt>
                <c:pt idx="84">
                  <c:v>7.8066725119999996</c:v>
                </c:pt>
                <c:pt idx="85">
                  <c:v>9.3803932920000008</c:v>
                </c:pt>
                <c:pt idx="86">
                  <c:v>3.0497025290000002</c:v>
                </c:pt>
                <c:pt idx="87">
                  <c:v>10.959319280000001</c:v>
                </c:pt>
                <c:pt idx="88">
                  <c:v>0</c:v>
                </c:pt>
                <c:pt idx="89">
                  <c:v>0</c:v>
                </c:pt>
                <c:pt idx="90">
                  <c:v>0</c:v>
                </c:pt>
                <c:pt idx="91">
                  <c:v>0</c:v>
                </c:pt>
                <c:pt idx="92">
                  <c:v>0</c:v>
                </c:pt>
                <c:pt idx="93">
                  <c:v>0</c:v>
                </c:pt>
                <c:pt idx="94">
                  <c:v>0</c:v>
                </c:pt>
                <c:pt idx="95">
                  <c:v>0</c:v>
                </c:pt>
                <c:pt idx="96">
                  <c:v>0</c:v>
                </c:pt>
                <c:pt idx="97">
                  <c:v>0</c:v>
                </c:pt>
                <c:pt idx="98">
                  <c:v>0</c:v>
                </c:pt>
                <c:pt idx="99">
                  <c:v>0</c:v>
                </c:pt>
                <c:pt idx="100">
                  <c:v>0</c:v>
                </c:pt>
                <c:pt idx="101">
                  <c:v>0</c:v>
                </c:pt>
                <c:pt idx="102">
                  <c:v>0</c:v>
                </c:pt>
                <c:pt idx="103">
                  <c:v>0</c:v>
                </c:pt>
                <c:pt idx="104">
                  <c:v>0</c:v>
                </c:pt>
                <c:pt idx="105">
                  <c:v>0</c:v>
                </c:pt>
                <c:pt idx="106">
                  <c:v>-0.86913137900000004</c:v>
                </c:pt>
                <c:pt idx="107">
                  <c:v>0</c:v>
                </c:pt>
                <c:pt idx="108">
                  <c:v>0</c:v>
                </c:pt>
                <c:pt idx="109">
                  <c:v>0</c:v>
                </c:pt>
                <c:pt idx="110">
                  <c:v>0</c:v>
                </c:pt>
                <c:pt idx="111">
                  <c:v>0</c:v>
                </c:pt>
                <c:pt idx="112">
                  <c:v>0</c:v>
                </c:pt>
                <c:pt idx="113">
                  <c:v>1.9104255539999999</c:v>
                </c:pt>
                <c:pt idx="114">
                  <c:v>3.4196427539999998</c:v>
                </c:pt>
                <c:pt idx="115">
                  <c:v>3.1990087890000001</c:v>
                </c:pt>
                <c:pt idx="116">
                  <c:v>3.0444510980000001</c:v>
                </c:pt>
                <c:pt idx="117">
                  <c:v>3.1218248640000001</c:v>
                </c:pt>
                <c:pt idx="118">
                  <c:v>3.989568765</c:v>
                </c:pt>
                <c:pt idx="119">
                  <c:v>3.4023239699999999</c:v>
                </c:pt>
                <c:pt idx="120">
                  <c:v>3.4652172430000001</c:v>
                </c:pt>
                <c:pt idx="121">
                  <c:v>3.4717854739999998</c:v>
                </c:pt>
                <c:pt idx="122">
                  <c:v>3.7239160170000001</c:v>
                </c:pt>
                <c:pt idx="123">
                  <c:v>3.9793282200000002</c:v>
                </c:pt>
                <c:pt idx="124">
                  <c:v>3.6103820990000002</c:v>
                </c:pt>
                <c:pt idx="125">
                  <c:v>4.2079145059999998</c:v>
                </c:pt>
                <c:pt idx="126">
                  <c:v>2.732681683</c:v>
                </c:pt>
                <c:pt idx="127">
                  <c:v>2.3699310539999998</c:v>
                </c:pt>
                <c:pt idx="128">
                  <c:v>5.1189041729999998</c:v>
                </c:pt>
                <c:pt idx="129">
                  <c:v>4.7393300529999998</c:v>
                </c:pt>
                <c:pt idx="130">
                  <c:v>2.9348525520000002</c:v>
                </c:pt>
                <c:pt idx="131">
                  <c:v>3.4990621439999998</c:v>
                </c:pt>
                <c:pt idx="132">
                  <c:v>4.9891736829999997</c:v>
                </c:pt>
                <c:pt idx="133">
                  <c:v>4.8624698879999997</c:v>
                </c:pt>
                <c:pt idx="134">
                  <c:v>3.1173144009999998</c:v>
                </c:pt>
                <c:pt idx="135">
                  <c:v>4.0041280349999999</c:v>
                </c:pt>
                <c:pt idx="136">
                  <c:v>3.4972473530000001</c:v>
                </c:pt>
                <c:pt idx="137">
                  <c:v>4.30859141</c:v>
                </c:pt>
                <c:pt idx="138">
                  <c:v>4.9621315020000001</c:v>
                </c:pt>
                <c:pt idx="139">
                  <c:v>4.0130129840000004</c:v>
                </c:pt>
                <c:pt idx="140">
                  <c:v>0.64840397100000002</c:v>
                </c:pt>
                <c:pt idx="141">
                  <c:v>5.4282189110000001</c:v>
                </c:pt>
                <c:pt idx="142">
                  <c:v>2.9194108820000002</c:v>
                </c:pt>
                <c:pt idx="143">
                  <c:v>7.3789653609999997</c:v>
                </c:pt>
                <c:pt idx="144">
                  <c:v>2.5867741120000001</c:v>
                </c:pt>
                <c:pt idx="145">
                  <c:v>3.1301193719999998</c:v>
                </c:pt>
                <c:pt idx="146">
                  <c:v>0</c:v>
                </c:pt>
                <c:pt idx="147">
                  <c:v>0</c:v>
                </c:pt>
                <c:pt idx="148">
                  <c:v>0</c:v>
                </c:pt>
                <c:pt idx="149">
                  <c:v>0</c:v>
                </c:pt>
                <c:pt idx="150">
                  <c:v>0</c:v>
                </c:pt>
                <c:pt idx="151">
                  <c:v>0</c:v>
                </c:pt>
                <c:pt idx="152">
                  <c:v>0</c:v>
                </c:pt>
                <c:pt idx="153">
                  <c:v>0</c:v>
                </c:pt>
                <c:pt idx="154">
                  <c:v>0</c:v>
                </c:pt>
                <c:pt idx="155">
                  <c:v>0</c:v>
                </c:pt>
                <c:pt idx="156">
                  <c:v>0</c:v>
                </c:pt>
                <c:pt idx="157">
                  <c:v>0</c:v>
                </c:pt>
                <c:pt idx="158">
                  <c:v>0</c:v>
                </c:pt>
                <c:pt idx="159">
                  <c:v>0</c:v>
                </c:pt>
                <c:pt idx="160">
                  <c:v>0</c:v>
                </c:pt>
                <c:pt idx="161">
                  <c:v>0</c:v>
                </c:pt>
                <c:pt idx="162">
                  <c:v>0</c:v>
                </c:pt>
                <c:pt idx="163">
                  <c:v>0</c:v>
                </c:pt>
                <c:pt idx="164">
                  <c:v>0</c:v>
                </c:pt>
                <c:pt idx="165">
                  <c:v>0</c:v>
                </c:pt>
                <c:pt idx="166">
                  <c:v>0</c:v>
                </c:pt>
                <c:pt idx="167">
                  <c:v>0</c:v>
                </c:pt>
                <c:pt idx="168">
                  <c:v>0</c:v>
                </c:pt>
                <c:pt idx="169">
                  <c:v>0</c:v>
                </c:pt>
                <c:pt idx="170">
                  <c:v>0</c:v>
                </c:pt>
                <c:pt idx="171">
                  <c:v>0</c:v>
                </c:pt>
                <c:pt idx="172">
                  <c:v>0</c:v>
                </c:pt>
                <c:pt idx="173">
                  <c:v>0</c:v>
                </c:pt>
                <c:pt idx="174">
                  <c:v>0</c:v>
                </c:pt>
                <c:pt idx="175">
                  <c:v>0</c:v>
                </c:pt>
                <c:pt idx="176">
                  <c:v>0</c:v>
                </c:pt>
                <c:pt idx="177">
                  <c:v>0</c:v>
                </c:pt>
                <c:pt idx="178">
                  <c:v>0</c:v>
                </c:pt>
                <c:pt idx="179">
                  <c:v>0</c:v>
                </c:pt>
                <c:pt idx="180">
                  <c:v>0</c:v>
                </c:pt>
                <c:pt idx="181">
                  <c:v>0</c:v>
                </c:pt>
                <c:pt idx="182">
                  <c:v>0</c:v>
                </c:pt>
                <c:pt idx="183">
                  <c:v>0</c:v>
                </c:pt>
                <c:pt idx="184">
                  <c:v>0</c:v>
                </c:pt>
                <c:pt idx="185">
                  <c:v>0</c:v>
                </c:pt>
                <c:pt idx="186">
                  <c:v>0</c:v>
                </c:pt>
                <c:pt idx="187">
                  <c:v>0</c:v>
                </c:pt>
                <c:pt idx="188">
                  <c:v>0</c:v>
                </c:pt>
                <c:pt idx="189">
                  <c:v>0</c:v>
                </c:pt>
                <c:pt idx="190">
                  <c:v>0</c:v>
                </c:pt>
                <c:pt idx="191">
                  <c:v>0</c:v>
                </c:pt>
                <c:pt idx="192">
                  <c:v>0</c:v>
                </c:pt>
                <c:pt idx="193">
                  <c:v>0</c:v>
                </c:pt>
                <c:pt idx="194">
                  <c:v>0</c:v>
                </c:pt>
                <c:pt idx="195">
                  <c:v>0</c:v>
                </c:pt>
                <c:pt idx="196">
                  <c:v>0</c:v>
                </c:pt>
                <c:pt idx="197">
                  <c:v>0</c:v>
                </c:pt>
                <c:pt idx="198">
                  <c:v>0</c:v>
                </c:pt>
                <c:pt idx="199">
                  <c:v>0</c:v>
                </c:pt>
                <c:pt idx="200">
                  <c:v>0</c:v>
                </c:pt>
                <c:pt idx="201">
                  <c:v>0</c:v>
                </c:pt>
                <c:pt idx="202">
                  <c:v>0</c:v>
                </c:pt>
                <c:pt idx="203">
                  <c:v>0</c:v>
                </c:pt>
                <c:pt idx="204">
                  <c:v>0</c:v>
                </c:pt>
                <c:pt idx="205">
                  <c:v>0</c:v>
                </c:pt>
                <c:pt idx="206">
                  <c:v>0</c:v>
                </c:pt>
                <c:pt idx="207">
                  <c:v>0</c:v>
                </c:pt>
                <c:pt idx="208">
                  <c:v>0</c:v>
                </c:pt>
                <c:pt idx="209">
                  <c:v>0</c:v>
                </c:pt>
                <c:pt idx="210">
                  <c:v>0</c:v>
                </c:pt>
                <c:pt idx="211">
                  <c:v>0</c:v>
                </c:pt>
                <c:pt idx="212">
                  <c:v>0</c:v>
                </c:pt>
                <c:pt idx="213">
                  <c:v>0</c:v>
                </c:pt>
                <c:pt idx="214">
                  <c:v>0</c:v>
                </c:pt>
                <c:pt idx="215">
                  <c:v>0</c:v>
                </c:pt>
                <c:pt idx="216">
                  <c:v>0</c:v>
                </c:pt>
                <c:pt idx="217">
                  <c:v>0</c:v>
                </c:pt>
                <c:pt idx="218">
                  <c:v>0</c:v>
                </c:pt>
                <c:pt idx="219">
                  <c:v>0</c:v>
                </c:pt>
                <c:pt idx="220">
                  <c:v>0</c:v>
                </c:pt>
                <c:pt idx="221">
                  <c:v>0</c:v>
                </c:pt>
                <c:pt idx="222">
                  <c:v>0</c:v>
                </c:pt>
                <c:pt idx="223">
                  <c:v>0</c:v>
                </c:pt>
                <c:pt idx="224">
                  <c:v>0</c:v>
                </c:pt>
                <c:pt idx="225">
                  <c:v>0</c:v>
                </c:pt>
                <c:pt idx="226">
                  <c:v>0</c:v>
                </c:pt>
                <c:pt idx="227">
                  <c:v>0</c:v>
                </c:pt>
                <c:pt idx="228">
                  <c:v>0</c:v>
                </c:pt>
                <c:pt idx="229">
                  <c:v>0</c:v>
                </c:pt>
                <c:pt idx="230">
                  <c:v>0</c:v>
                </c:pt>
                <c:pt idx="231">
                  <c:v>0</c:v>
                </c:pt>
                <c:pt idx="232">
                  <c:v>0</c:v>
                </c:pt>
                <c:pt idx="233">
                  <c:v>0</c:v>
                </c:pt>
                <c:pt idx="234">
                  <c:v>0</c:v>
                </c:pt>
                <c:pt idx="235">
                  <c:v>0</c:v>
                </c:pt>
                <c:pt idx="236">
                  <c:v>0</c:v>
                </c:pt>
                <c:pt idx="237">
                  <c:v>0</c:v>
                </c:pt>
                <c:pt idx="238">
                  <c:v>0</c:v>
                </c:pt>
                <c:pt idx="239">
                  <c:v>6.1313241569999999</c:v>
                </c:pt>
                <c:pt idx="240">
                  <c:v>6.8884942010000003</c:v>
                </c:pt>
              </c:numCache>
            </c:numRef>
          </c:val>
        </c:ser>
        <c:dLbls>
          <c:showLegendKey val="0"/>
          <c:showVal val="0"/>
          <c:showCatName val="0"/>
          <c:showSerName val="0"/>
          <c:showPercent val="0"/>
          <c:showBubbleSize val="0"/>
        </c:dLbls>
        <c:axId val="305608712"/>
        <c:axId val="305605968"/>
      </c:areaChart>
      <c:barChart>
        <c:barDir val="col"/>
        <c:grouping val="clustered"/>
        <c:varyColors val="0"/>
        <c:ser>
          <c:idx val="2"/>
          <c:order val="2"/>
          <c:tx>
            <c:strRef>
              <c:f>Sheet1!$F$1</c:f>
              <c:strCache>
                <c:ptCount val="1"/>
                <c:pt idx="0">
                  <c:v>HPAT2</c:v>
                </c:pt>
              </c:strCache>
            </c:strRef>
          </c:tx>
          <c:spPr>
            <a:solidFill>
              <a:srgbClr val="FFFF00"/>
            </a:solidFill>
            <a:ln w="12700">
              <a:solidFill>
                <a:srgbClr val="FFFF00"/>
              </a:solidFill>
            </a:ln>
            <a:effectLst/>
          </c:spPr>
          <c:invertIfNegative val="0"/>
          <c:cat>
            <c:strRef>
              <c:f>Sheet1!$C$2:$C$242</c:f>
              <c:strCache>
                <c:ptCount val="241"/>
                <c:pt idx="0">
                  <c:v>Embryo1_12</c:v>
                </c:pt>
                <c:pt idx="1">
                  <c:v>Embryo1_17</c:v>
                </c:pt>
                <c:pt idx="2">
                  <c:v>Embryo1_23</c:v>
                </c:pt>
                <c:pt idx="3">
                  <c:v>Embryo1_30</c:v>
                </c:pt>
                <c:pt idx="4">
                  <c:v>Embryo1_31</c:v>
                </c:pt>
                <c:pt idx="5">
                  <c:v>Embryo1_32</c:v>
                </c:pt>
                <c:pt idx="6">
                  <c:v>Embryo1_34</c:v>
                </c:pt>
                <c:pt idx="7">
                  <c:v>Embryo1_40</c:v>
                </c:pt>
                <c:pt idx="8">
                  <c:v>Embryo1_43</c:v>
                </c:pt>
                <c:pt idx="9">
                  <c:v>Embryo1_46</c:v>
                </c:pt>
                <c:pt idx="10">
                  <c:v>Embryo1_47</c:v>
                </c:pt>
                <c:pt idx="11">
                  <c:v>Embryo1_48</c:v>
                </c:pt>
                <c:pt idx="12">
                  <c:v>Embryo1_51</c:v>
                </c:pt>
                <c:pt idx="13">
                  <c:v>Embryo2_1</c:v>
                </c:pt>
                <c:pt idx="14">
                  <c:v>Embryo2_6</c:v>
                </c:pt>
                <c:pt idx="15">
                  <c:v>Embryo2_7</c:v>
                </c:pt>
                <c:pt idx="16">
                  <c:v>Embryo2_10</c:v>
                </c:pt>
                <c:pt idx="17">
                  <c:v>Embryo2_12</c:v>
                </c:pt>
                <c:pt idx="18">
                  <c:v>Embryo2_13</c:v>
                </c:pt>
                <c:pt idx="19">
                  <c:v>Embryo2_20</c:v>
                </c:pt>
                <c:pt idx="20">
                  <c:v>Embryo2_23</c:v>
                </c:pt>
                <c:pt idx="21">
                  <c:v>Embryo2_28</c:v>
                </c:pt>
                <c:pt idx="22">
                  <c:v>Embryo2_31</c:v>
                </c:pt>
                <c:pt idx="23">
                  <c:v>Embryo2_33</c:v>
                </c:pt>
                <c:pt idx="24">
                  <c:v>Embryo2_35</c:v>
                </c:pt>
                <c:pt idx="25">
                  <c:v>Embryo1_8</c:v>
                </c:pt>
                <c:pt idx="26">
                  <c:v>Embryo1_10</c:v>
                </c:pt>
                <c:pt idx="27">
                  <c:v>Embryo1_37</c:v>
                </c:pt>
                <c:pt idx="28">
                  <c:v>Embryo1_50</c:v>
                </c:pt>
                <c:pt idx="29">
                  <c:v>Embryo1_53</c:v>
                </c:pt>
                <c:pt idx="30">
                  <c:v>Embryo2_25</c:v>
                </c:pt>
                <c:pt idx="31">
                  <c:v>Embryo3_1</c:v>
                </c:pt>
                <c:pt idx="32">
                  <c:v>Embryo3_2</c:v>
                </c:pt>
                <c:pt idx="33">
                  <c:v>Embryo3_5</c:v>
                </c:pt>
                <c:pt idx="34">
                  <c:v>Embryo3_7</c:v>
                </c:pt>
                <c:pt idx="35">
                  <c:v>Embryo3_10</c:v>
                </c:pt>
                <c:pt idx="36">
                  <c:v>Embryo3_11</c:v>
                </c:pt>
                <c:pt idx="37">
                  <c:v>Embryo3_12</c:v>
                </c:pt>
                <c:pt idx="38">
                  <c:v>Embryo3_14</c:v>
                </c:pt>
                <c:pt idx="39">
                  <c:v>Embryo3_15</c:v>
                </c:pt>
                <c:pt idx="40">
                  <c:v>Embryo3_18</c:v>
                </c:pt>
                <c:pt idx="41">
                  <c:v>Embryo3_20</c:v>
                </c:pt>
                <c:pt idx="42">
                  <c:v>Embryo3_22</c:v>
                </c:pt>
                <c:pt idx="43">
                  <c:v>Embryo3_27</c:v>
                </c:pt>
                <c:pt idx="44">
                  <c:v>Embryo3_35</c:v>
                </c:pt>
                <c:pt idx="45">
                  <c:v>Embryo3_39</c:v>
                </c:pt>
                <c:pt idx="46">
                  <c:v>Embryo3_44</c:v>
                </c:pt>
                <c:pt idx="47">
                  <c:v>Embryo3_49</c:v>
                </c:pt>
                <c:pt idx="48">
                  <c:v>Embryo3_51</c:v>
                </c:pt>
                <c:pt idx="49">
                  <c:v>Embryo3_55</c:v>
                </c:pt>
                <c:pt idx="50">
                  <c:v>Embryo3_62</c:v>
                </c:pt>
                <c:pt idx="51">
                  <c:v>Embryo3_67</c:v>
                </c:pt>
                <c:pt idx="52">
                  <c:v>Embryo3_68</c:v>
                </c:pt>
                <c:pt idx="53">
                  <c:v>Embryo3_70</c:v>
                </c:pt>
                <c:pt idx="54">
                  <c:v>Embryo3_72</c:v>
                </c:pt>
                <c:pt idx="55">
                  <c:v>Embryo3_73</c:v>
                </c:pt>
                <c:pt idx="56">
                  <c:v>Embryo3_78</c:v>
                </c:pt>
                <c:pt idx="57">
                  <c:v>Embryo3_81</c:v>
                </c:pt>
                <c:pt idx="58">
                  <c:v>Embryo3_82</c:v>
                </c:pt>
                <c:pt idx="59">
                  <c:v>Embryo4_2</c:v>
                </c:pt>
                <c:pt idx="60">
                  <c:v>Embryo4_3</c:v>
                </c:pt>
                <c:pt idx="61">
                  <c:v>Embryo4_4</c:v>
                </c:pt>
                <c:pt idx="62">
                  <c:v>Embryo4_5</c:v>
                </c:pt>
                <c:pt idx="63">
                  <c:v>Embryo4_8</c:v>
                </c:pt>
                <c:pt idx="64">
                  <c:v>Embryo4_10</c:v>
                </c:pt>
                <c:pt idx="65">
                  <c:v>Embryo4_11</c:v>
                </c:pt>
                <c:pt idx="66">
                  <c:v>Embryo4_14</c:v>
                </c:pt>
                <c:pt idx="67">
                  <c:v>Embryo4_15</c:v>
                </c:pt>
                <c:pt idx="68">
                  <c:v>Embryo4_16</c:v>
                </c:pt>
                <c:pt idx="69">
                  <c:v>Embryo4_21</c:v>
                </c:pt>
                <c:pt idx="70">
                  <c:v>Embryo4_32</c:v>
                </c:pt>
                <c:pt idx="71">
                  <c:v>Embryo4_37</c:v>
                </c:pt>
                <c:pt idx="72">
                  <c:v>Embryo4_39</c:v>
                </c:pt>
                <c:pt idx="73">
                  <c:v>Embryo4_40</c:v>
                </c:pt>
                <c:pt idx="74">
                  <c:v>Embryo4_41</c:v>
                </c:pt>
                <c:pt idx="75">
                  <c:v>Embryo4_43</c:v>
                </c:pt>
                <c:pt idx="76">
                  <c:v>Embryo4_46</c:v>
                </c:pt>
                <c:pt idx="77">
                  <c:v>Embryo4_47</c:v>
                </c:pt>
                <c:pt idx="78">
                  <c:v>Embryo4_50</c:v>
                </c:pt>
                <c:pt idx="79">
                  <c:v>Embryo4_52</c:v>
                </c:pt>
                <c:pt idx="80">
                  <c:v>Embryo4_54</c:v>
                </c:pt>
                <c:pt idx="81">
                  <c:v>Embryo4_55</c:v>
                </c:pt>
                <c:pt idx="82">
                  <c:v>Embryo4_59</c:v>
                </c:pt>
                <c:pt idx="83">
                  <c:v>Embryo4_60</c:v>
                </c:pt>
                <c:pt idx="84">
                  <c:v>Embryo4_61</c:v>
                </c:pt>
                <c:pt idx="85">
                  <c:v>Embryo4_62</c:v>
                </c:pt>
                <c:pt idx="86">
                  <c:v>Embryo4_65</c:v>
                </c:pt>
                <c:pt idx="87">
                  <c:v>Embryo4_70</c:v>
                </c:pt>
                <c:pt idx="88">
                  <c:v>Embryo1_6</c:v>
                </c:pt>
                <c:pt idx="89">
                  <c:v>Embryo1_13</c:v>
                </c:pt>
                <c:pt idx="90">
                  <c:v>Embryo2_11</c:v>
                </c:pt>
                <c:pt idx="91">
                  <c:v>Embryo2_24</c:v>
                </c:pt>
                <c:pt idx="92">
                  <c:v>Embryo3_21</c:v>
                </c:pt>
                <c:pt idx="93">
                  <c:v>Embryo3_26</c:v>
                </c:pt>
                <c:pt idx="94">
                  <c:v>Embryo3_28</c:v>
                </c:pt>
                <c:pt idx="95">
                  <c:v>Embryo3_32</c:v>
                </c:pt>
                <c:pt idx="96">
                  <c:v>Embryo3_45</c:v>
                </c:pt>
                <c:pt idx="97">
                  <c:v>Embryo3_48</c:v>
                </c:pt>
                <c:pt idx="98">
                  <c:v>Embryo3_52</c:v>
                </c:pt>
                <c:pt idx="99">
                  <c:v>Embryo3_54</c:v>
                </c:pt>
                <c:pt idx="100">
                  <c:v>Embryo3_60</c:v>
                </c:pt>
                <c:pt idx="101">
                  <c:v>Embryo3_64</c:v>
                </c:pt>
                <c:pt idx="102">
                  <c:v>Embryo3_80</c:v>
                </c:pt>
                <c:pt idx="103">
                  <c:v>Embryo4_7</c:v>
                </c:pt>
                <c:pt idx="104">
                  <c:v>Embryo4_20</c:v>
                </c:pt>
                <c:pt idx="105">
                  <c:v>Embryo4_25</c:v>
                </c:pt>
                <c:pt idx="106">
                  <c:v>Embryo4_28</c:v>
                </c:pt>
                <c:pt idx="107">
                  <c:v>Embryo4_29</c:v>
                </c:pt>
                <c:pt idx="108">
                  <c:v>Embryo4_34</c:v>
                </c:pt>
                <c:pt idx="109">
                  <c:v>Embryo4_35</c:v>
                </c:pt>
                <c:pt idx="110">
                  <c:v>Embryo4_49</c:v>
                </c:pt>
                <c:pt idx="111">
                  <c:v>Embryo4_58</c:v>
                </c:pt>
                <c:pt idx="112">
                  <c:v>Embryo4_18</c:v>
                </c:pt>
                <c:pt idx="113">
                  <c:v>Embryo1_7</c:v>
                </c:pt>
                <c:pt idx="114">
                  <c:v>Embryo1_18</c:v>
                </c:pt>
                <c:pt idx="115">
                  <c:v>Embryo1_22</c:v>
                </c:pt>
                <c:pt idx="116">
                  <c:v>Embryo1_35</c:v>
                </c:pt>
                <c:pt idx="117">
                  <c:v>Embryo1_42</c:v>
                </c:pt>
                <c:pt idx="118">
                  <c:v>Embryo1_44</c:v>
                </c:pt>
                <c:pt idx="119">
                  <c:v>Embryo1_45</c:v>
                </c:pt>
                <c:pt idx="120">
                  <c:v>Embryo1_49</c:v>
                </c:pt>
                <c:pt idx="121">
                  <c:v>Embryo2_9</c:v>
                </c:pt>
                <c:pt idx="122">
                  <c:v>Embryo2_14</c:v>
                </c:pt>
                <c:pt idx="123">
                  <c:v>Embryo2_15</c:v>
                </c:pt>
                <c:pt idx="124">
                  <c:v>Embryo2_16</c:v>
                </c:pt>
                <c:pt idx="125">
                  <c:v>Embryo2_18</c:v>
                </c:pt>
                <c:pt idx="126">
                  <c:v>Embryo2_21</c:v>
                </c:pt>
                <c:pt idx="127">
                  <c:v>Embryo2_22</c:v>
                </c:pt>
                <c:pt idx="128">
                  <c:v>Embryo2_32</c:v>
                </c:pt>
                <c:pt idx="129">
                  <c:v>Embryo3_8</c:v>
                </c:pt>
                <c:pt idx="130">
                  <c:v>Embryo3_23</c:v>
                </c:pt>
                <c:pt idx="131">
                  <c:v>Embryo3_24</c:v>
                </c:pt>
                <c:pt idx="132">
                  <c:v>Embryo3_29</c:v>
                </c:pt>
                <c:pt idx="133">
                  <c:v>Embryo3_30</c:v>
                </c:pt>
                <c:pt idx="134">
                  <c:v>Embryo3_65</c:v>
                </c:pt>
                <c:pt idx="135">
                  <c:v>Embryo3_66</c:v>
                </c:pt>
                <c:pt idx="136">
                  <c:v>Embryo3_74</c:v>
                </c:pt>
                <c:pt idx="137">
                  <c:v>Embryo3_75</c:v>
                </c:pt>
                <c:pt idx="138">
                  <c:v>Embryo3_77</c:v>
                </c:pt>
                <c:pt idx="139">
                  <c:v>Embryo3_79</c:v>
                </c:pt>
                <c:pt idx="140">
                  <c:v>Embryo4_1</c:v>
                </c:pt>
                <c:pt idx="141">
                  <c:v>Embryo4_19</c:v>
                </c:pt>
                <c:pt idx="142">
                  <c:v>Embryo4_30</c:v>
                </c:pt>
                <c:pt idx="143">
                  <c:v>Embryo4_45</c:v>
                </c:pt>
                <c:pt idx="144">
                  <c:v>Embryo4_71</c:v>
                </c:pt>
                <c:pt idx="145">
                  <c:v>Embryo1_28</c:v>
                </c:pt>
                <c:pt idx="146">
                  <c:v>Embryo1_2</c:v>
                </c:pt>
                <c:pt idx="147">
                  <c:v>Embryo1_3</c:v>
                </c:pt>
                <c:pt idx="148">
                  <c:v>Embryo1_5</c:v>
                </c:pt>
                <c:pt idx="149">
                  <c:v>Embryo1_9</c:v>
                </c:pt>
                <c:pt idx="150">
                  <c:v>Embryo1_11</c:v>
                </c:pt>
                <c:pt idx="151">
                  <c:v>Embryo1_16</c:v>
                </c:pt>
                <c:pt idx="152">
                  <c:v>Embryo1_19</c:v>
                </c:pt>
                <c:pt idx="153">
                  <c:v>Embryo1_20</c:v>
                </c:pt>
                <c:pt idx="154">
                  <c:v>Embryo1_24</c:v>
                </c:pt>
                <c:pt idx="155">
                  <c:v>Embryo1_25</c:v>
                </c:pt>
                <c:pt idx="156">
                  <c:v>Embryo1_26</c:v>
                </c:pt>
                <c:pt idx="157">
                  <c:v>Embryo1_27</c:v>
                </c:pt>
                <c:pt idx="158">
                  <c:v>Embryo1_29</c:v>
                </c:pt>
                <c:pt idx="159">
                  <c:v>Embryo1_33</c:v>
                </c:pt>
                <c:pt idx="160">
                  <c:v>Embryo1_36</c:v>
                </c:pt>
                <c:pt idx="161">
                  <c:v>Embryo1_38</c:v>
                </c:pt>
                <c:pt idx="162">
                  <c:v>Embryo1_39</c:v>
                </c:pt>
                <c:pt idx="163">
                  <c:v>Embryo1_52</c:v>
                </c:pt>
                <c:pt idx="164">
                  <c:v>Embryo2_2</c:v>
                </c:pt>
                <c:pt idx="165">
                  <c:v>Embryo2_3</c:v>
                </c:pt>
                <c:pt idx="166">
                  <c:v>Embryo2_4</c:v>
                </c:pt>
                <c:pt idx="167">
                  <c:v>Embryo2_5</c:v>
                </c:pt>
                <c:pt idx="168">
                  <c:v>Embryo2_8</c:v>
                </c:pt>
                <c:pt idx="169">
                  <c:v>Embryo2_19</c:v>
                </c:pt>
                <c:pt idx="170">
                  <c:v>Embryo2_26</c:v>
                </c:pt>
                <c:pt idx="171">
                  <c:v>Embryo2_27</c:v>
                </c:pt>
                <c:pt idx="172">
                  <c:v>Embryo2_29</c:v>
                </c:pt>
                <c:pt idx="173">
                  <c:v>Embryo2_30</c:v>
                </c:pt>
                <c:pt idx="174">
                  <c:v>Embryo2_34</c:v>
                </c:pt>
                <c:pt idx="175">
                  <c:v>Embryo3_3</c:v>
                </c:pt>
                <c:pt idx="176">
                  <c:v>Embryo3_4</c:v>
                </c:pt>
                <c:pt idx="177">
                  <c:v>Embryo3_6</c:v>
                </c:pt>
                <c:pt idx="178">
                  <c:v>Embryo3_9</c:v>
                </c:pt>
                <c:pt idx="179">
                  <c:v>Embryo3_16</c:v>
                </c:pt>
                <c:pt idx="180">
                  <c:v>Embryo3_17</c:v>
                </c:pt>
                <c:pt idx="181">
                  <c:v>Embryo3_19</c:v>
                </c:pt>
                <c:pt idx="182">
                  <c:v>Embryo3_31</c:v>
                </c:pt>
                <c:pt idx="183">
                  <c:v>Embryo3_33</c:v>
                </c:pt>
                <c:pt idx="184">
                  <c:v>Embryo3_34</c:v>
                </c:pt>
                <c:pt idx="185">
                  <c:v>Embryo3_36</c:v>
                </c:pt>
                <c:pt idx="186">
                  <c:v>Embryo3_38</c:v>
                </c:pt>
                <c:pt idx="187">
                  <c:v>Embryo3_41</c:v>
                </c:pt>
                <c:pt idx="188">
                  <c:v>Embryo3_42</c:v>
                </c:pt>
                <c:pt idx="189">
                  <c:v>Embryo3_43</c:v>
                </c:pt>
                <c:pt idx="190">
                  <c:v>Embryo3_46</c:v>
                </c:pt>
                <c:pt idx="191">
                  <c:v>Embryo3_47</c:v>
                </c:pt>
                <c:pt idx="192">
                  <c:v>Embryo3_50</c:v>
                </c:pt>
                <c:pt idx="193">
                  <c:v>Embryo3_53</c:v>
                </c:pt>
                <c:pt idx="194">
                  <c:v>Embryo3_56</c:v>
                </c:pt>
                <c:pt idx="195">
                  <c:v>Embryo3_57</c:v>
                </c:pt>
                <c:pt idx="196">
                  <c:v>Embryo3_58</c:v>
                </c:pt>
                <c:pt idx="197">
                  <c:v>Embryo3_59</c:v>
                </c:pt>
                <c:pt idx="198">
                  <c:v>Embryo3_61</c:v>
                </c:pt>
                <c:pt idx="199">
                  <c:v>Embryo3_63</c:v>
                </c:pt>
                <c:pt idx="200">
                  <c:v>Embryo3_69</c:v>
                </c:pt>
                <c:pt idx="201">
                  <c:v>Embryo3_71</c:v>
                </c:pt>
                <c:pt idx="202">
                  <c:v>Embryo4_6</c:v>
                </c:pt>
                <c:pt idx="203">
                  <c:v>Embryo4_9</c:v>
                </c:pt>
                <c:pt idx="204">
                  <c:v>Embryo4_12</c:v>
                </c:pt>
                <c:pt idx="205">
                  <c:v>Embryo4_13</c:v>
                </c:pt>
                <c:pt idx="206">
                  <c:v>Embryo4_17</c:v>
                </c:pt>
                <c:pt idx="207">
                  <c:v>Embryo4_22</c:v>
                </c:pt>
                <c:pt idx="208">
                  <c:v>Embryo4_23</c:v>
                </c:pt>
                <c:pt idx="209">
                  <c:v>Embryo4_26</c:v>
                </c:pt>
                <c:pt idx="210">
                  <c:v>Embryo4_27</c:v>
                </c:pt>
                <c:pt idx="211">
                  <c:v>Embryo4_31</c:v>
                </c:pt>
                <c:pt idx="212">
                  <c:v>Embryo4_33</c:v>
                </c:pt>
                <c:pt idx="213">
                  <c:v>Embryo4_36</c:v>
                </c:pt>
                <c:pt idx="214">
                  <c:v>Embryo4_38</c:v>
                </c:pt>
                <c:pt idx="215">
                  <c:v>Embryo4_42</c:v>
                </c:pt>
                <c:pt idx="216">
                  <c:v>Embryo4_44</c:v>
                </c:pt>
                <c:pt idx="217">
                  <c:v>Embryo4_48</c:v>
                </c:pt>
                <c:pt idx="218">
                  <c:v>Embryo4_51</c:v>
                </c:pt>
                <c:pt idx="219">
                  <c:v>Embryo4_53</c:v>
                </c:pt>
                <c:pt idx="220">
                  <c:v>Embryo4_57</c:v>
                </c:pt>
                <c:pt idx="221">
                  <c:v>Embryo4_63</c:v>
                </c:pt>
                <c:pt idx="222">
                  <c:v>Embryo4_64</c:v>
                </c:pt>
                <c:pt idx="223">
                  <c:v>Embryo4_66</c:v>
                </c:pt>
                <c:pt idx="224">
                  <c:v>Embryo4_67</c:v>
                </c:pt>
                <c:pt idx="225">
                  <c:v>Embryo4_68</c:v>
                </c:pt>
                <c:pt idx="226">
                  <c:v>Embryo4_69</c:v>
                </c:pt>
                <c:pt idx="227">
                  <c:v>Embryo2_17</c:v>
                </c:pt>
                <c:pt idx="228">
                  <c:v>Embryo1_4</c:v>
                </c:pt>
                <c:pt idx="229">
                  <c:v>Embryo1_14</c:v>
                </c:pt>
                <c:pt idx="230">
                  <c:v>Embryo1_15</c:v>
                </c:pt>
                <c:pt idx="231">
                  <c:v>Embryo1_21</c:v>
                </c:pt>
                <c:pt idx="232">
                  <c:v>Embryo3_13</c:v>
                </c:pt>
                <c:pt idx="233">
                  <c:v>Embryo3_25</c:v>
                </c:pt>
                <c:pt idx="234">
                  <c:v>Embryo3_37</c:v>
                </c:pt>
                <c:pt idx="235">
                  <c:v>Embryo3_40</c:v>
                </c:pt>
                <c:pt idx="236">
                  <c:v>Embryo3_76</c:v>
                </c:pt>
                <c:pt idx="237">
                  <c:v>Embryo4_24</c:v>
                </c:pt>
                <c:pt idx="238">
                  <c:v>Embryo4_56</c:v>
                </c:pt>
                <c:pt idx="239">
                  <c:v>Embryo1_1</c:v>
                </c:pt>
                <c:pt idx="240">
                  <c:v>Embryo1_41</c:v>
                </c:pt>
              </c:strCache>
            </c:strRef>
          </c:cat>
          <c:val>
            <c:numRef>
              <c:f>Sheet1!$F$2:$F$242</c:f>
              <c:numCache>
                <c:formatCode>General</c:formatCode>
                <c:ptCount val="241"/>
                <c:pt idx="0">
                  <c:v>0</c:v>
                </c:pt>
                <c:pt idx="1">
                  <c:v>0</c:v>
                </c:pt>
                <c:pt idx="2">
                  <c:v>0</c:v>
                </c:pt>
                <c:pt idx="3">
                  <c:v>0</c:v>
                </c:pt>
                <c:pt idx="4">
                  <c:v>0</c:v>
                </c:pt>
                <c:pt idx="5">
                  <c:v>0</c:v>
                </c:pt>
                <c:pt idx="6">
                  <c:v>0</c:v>
                </c:pt>
                <c:pt idx="7">
                  <c:v>0</c:v>
                </c:pt>
                <c:pt idx="8">
                  <c:v>0</c:v>
                </c:pt>
                <c:pt idx="9">
                  <c:v>0</c:v>
                </c:pt>
                <c:pt idx="10">
                  <c:v>0</c:v>
                </c:pt>
                <c:pt idx="11">
                  <c:v>0</c:v>
                </c:pt>
                <c:pt idx="12">
                  <c:v>0</c:v>
                </c:pt>
                <c:pt idx="13">
                  <c:v>0</c:v>
                </c:pt>
                <c:pt idx="14">
                  <c:v>0</c:v>
                </c:pt>
                <c:pt idx="15">
                  <c:v>0</c:v>
                </c:pt>
                <c:pt idx="16">
                  <c:v>0</c:v>
                </c:pt>
                <c:pt idx="17">
                  <c:v>0</c:v>
                </c:pt>
                <c:pt idx="18">
                  <c:v>0</c:v>
                </c:pt>
                <c:pt idx="19">
                  <c:v>0</c:v>
                </c:pt>
                <c:pt idx="20">
                  <c:v>0</c:v>
                </c:pt>
                <c:pt idx="21">
                  <c:v>0</c:v>
                </c:pt>
                <c:pt idx="22">
                  <c:v>0</c:v>
                </c:pt>
                <c:pt idx="23">
                  <c:v>0</c:v>
                </c:pt>
                <c:pt idx="24">
                  <c:v>0</c:v>
                </c:pt>
                <c:pt idx="25">
                  <c:v>0</c:v>
                </c:pt>
                <c:pt idx="26">
                  <c:v>0</c:v>
                </c:pt>
                <c:pt idx="27">
                  <c:v>0</c:v>
                </c:pt>
                <c:pt idx="28">
                  <c:v>0</c:v>
                </c:pt>
                <c:pt idx="29">
                  <c:v>0</c:v>
                </c:pt>
                <c:pt idx="30">
                  <c:v>0</c:v>
                </c:pt>
                <c:pt idx="31">
                  <c:v>0</c:v>
                </c:pt>
                <c:pt idx="32">
                  <c:v>0</c:v>
                </c:pt>
                <c:pt idx="33">
                  <c:v>0</c:v>
                </c:pt>
                <c:pt idx="34">
                  <c:v>0</c:v>
                </c:pt>
                <c:pt idx="35">
                  <c:v>0</c:v>
                </c:pt>
                <c:pt idx="36">
                  <c:v>0</c:v>
                </c:pt>
                <c:pt idx="37">
                  <c:v>0</c:v>
                </c:pt>
                <c:pt idx="38">
                  <c:v>0</c:v>
                </c:pt>
                <c:pt idx="39">
                  <c:v>0</c:v>
                </c:pt>
                <c:pt idx="40">
                  <c:v>0</c:v>
                </c:pt>
                <c:pt idx="41">
                  <c:v>0</c:v>
                </c:pt>
                <c:pt idx="42">
                  <c:v>0</c:v>
                </c:pt>
                <c:pt idx="43">
                  <c:v>-1.3723255510000001</c:v>
                </c:pt>
                <c:pt idx="44">
                  <c:v>0</c:v>
                </c:pt>
                <c:pt idx="45">
                  <c:v>0</c:v>
                </c:pt>
                <c:pt idx="46">
                  <c:v>0</c:v>
                </c:pt>
                <c:pt idx="47">
                  <c:v>0</c:v>
                </c:pt>
                <c:pt idx="48">
                  <c:v>0</c:v>
                </c:pt>
                <c:pt idx="49">
                  <c:v>0</c:v>
                </c:pt>
                <c:pt idx="50">
                  <c:v>0</c:v>
                </c:pt>
                <c:pt idx="51">
                  <c:v>0</c:v>
                </c:pt>
                <c:pt idx="52">
                  <c:v>0</c:v>
                </c:pt>
                <c:pt idx="53">
                  <c:v>0</c:v>
                </c:pt>
                <c:pt idx="54">
                  <c:v>0</c:v>
                </c:pt>
                <c:pt idx="55">
                  <c:v>0</c:v>
                </c:pt>
                <c:pt idx="56">
                  <c:v>0</c:v>
                </c:pt>
                <c:pt idx="57">
                  <c:v>0</c:v>
                </c:pt>
                <c:pt idx="58">
                  <c:v>0</c:v>
                </c:pt>
                <c:pt idx="59">
                  <c:v>0</c:v>
                </c:pt>
                <c:pt idx="60">
                  <c:v>0</c:v>
                </c:pt>
                <c:pt idx="61">
                  <c:v>0</c:v>
                </c:pt>
                <c:pt idx="62">
                  <c:v>0</c:v>
                </c:pt>
                <c:pt idx="63">
                  <c:v>0</c:v>
                </c:pt>
                <c:pt idx="64">
                  <c:v>0</c:v>
                </c:pt>
                <c:pt idx="65">
                  <c:v>0</c:v>
                </c:pt>
                <c:pt idx="66">
                  <c:v>0</c:v>
                </c:pt>
                <c:pt idx="67">
                  <c:v>0</c:v>
                </c:pt>
                <c:pt idx="68">
                  <c:v>0</c:v>
                </c:pt>
                <c:pt idx="69">
                  <c:v>0</c:v>
                </c:pt>
                <c:pt idx="70">
                  <c:v>0</c:v>
                </c:pt>
                <c:pt idx="71">
                  <c:v>0</c:v>
                </c:pt>
                <c:pt idx="72">
                  <c:v>0</c:v>
                </c:pt>
                <c:pt idx="73">
                  <c:v>0</c:v>
                </c:pt>
                <c:pt idx="74">
                  <c:v>-1.1610149030000001</c:v>
                </c:pt>
                <c:pt idx="75">
                  <c:v>0</c:v>
                </c:pt>
                <c:pt idx="76">
                  <c:v>0</c:v>
                </c:pt>
                <c:pt idx="77">
                  <c:v>0</c:v>
                </c:pt>
                <c:pt idx="78">
                  <c:v>0</c:v>
                </c:pt>
                <c:pt idx="79">
                  <c:v>0</c:v>
                </c:pt>
                <c:pt idx="80">
                  <c:v>0</c:v>
                </c:pt>
                <c:pt idx="81">
                  <c:v>0</c:v>
                </c:pt>
                <c:pt idx="82">
                  <c:v>0</c:v>
                </c:pt>
                <c:pt idx="83">
                  <c:v>0</c:v>
                </c:pt>
                <c:pt idx="84">
                  <c:v>0</c:v>
                </c:pt>
                <c:pt idx="85">
                  <c:v>0</c:v>
                </c:pt>
                <c:pt idx="86">
                  <c:v>0</c:v>
                </c:pt>
                <c:pt idx="87">
                  <c:v>0</c:v>
                </c:pt>
                <c:pt idx="88">
                  <c:v>2.6345949480000002</c:v>
                </c:pt>
                <c:pt idx="89">
                  <c:v>3.8854420589999998</c:v>
                </c:pt>
                <c:pt idx="90">
                  <c:v>2.7315017930000001</c:v>
                </c:pt>
                <c:pt idx="91">
                  <c:v>2.3242828819999999</c:v>
                </c:pt>
                <c:pt idx="92">
                  <c:v>2.9067377109999999</c:v>
                </c:pt>
                <c:pt idx="93">
                  <c:v>3.9820590359999999</c:v>
                </c:pt>
                <c:pt idx="94">
                  <c:v>3.8919508340000002</c:v>
                </c:pt>
                <c:pt idx="95">
                  <c:v>1.4720603720000001</c:v>
                </c:pt>
                <c:pt idx="96">
                  <c:v>4.5112534630000001</c:v>
                </c:pt>
                <c:pt idx="97">
                  <c:v>3.40292233</c:v>
                </c:pt>
                <c:pt idx="98">
                  <c:v>0.16710702899999999</c:v>
                </c:pt>
                <c:pt idx="99">
                  <c:v>6.285010357</c:v>
                </c:pt>
                <c:pt idx="100">
                  <c:v>5.1780957729999999</c:v>
                </c:pt>
                <c:pt idx="101">
                  <c:v>2.0436174380000001</c:v>
                </c:pt>
                <c:pt idx="102">
                  <c:v>0.59341937499999997</c:v>
                </c:pt>
                <c:pt idx="103">
                  <c:v>1.1165801120000001</c:v>
                </c:pt>
                <c:pt idx="104">
                  <c:v>4.284310208</c:v>
                </c:pt>
                <c:pt idx="105">
                  <c:v>3.7254184549999998</c:v>
                </c:pt>
                <c:pt idx="106">
                  <c:v>6.0012152060000004</c:v>
                </c:pt>
                <c:pt idx="107">
                  <c:v>4.2274467480000002</c:v>
                </c:pt>
                <c:pt idx="108">
                  <c:v>6.1486140059999999</c:v>
                </c:pt>
                <c:pt idx="109">
                  <c:v>2.7522529800000002</c:v>
                </c:pt>
                <c:pt idx="110">
                  <c:v>3.6425518499999998</c:v>
                </c:pt>
                <c:pt idx="111">
                  <c:v>2.9256091679999998</c:v>
                </c:pt>
                <c:pt idx="112">
                  <c:v>1.35850542</c:v>
                </c:pt>
                <c:pt idx="113">
                  <c:v>2.9579760070000001</c:v>
                </c:pt>
                <c:pt idx="114">
                  <c:v>3.3553319880000001</c:v>
                </c:pt>
                <c:pt idx="115">
                  <c:v>3.1683249409999998</c:v>
                </c:pt>
                <c:pt idx="116">
                  <c:v>3.3848362289999998</c:v>
                </c:pt>
                <c:pt idx="117">
                  <c:v>2.975747455</c:v>
                </c:pt>
                <c:pt idx="118">
                  <c:v>3.2924091230000001</c:v>
                </c:pt>
                <c:pt idx="119">
                  <c:v>2.576126822</c:v>
                </c:pt>
                <c:pt idx="120">
                  <c:v>3.3191049480000001</c:v>
                </c:pt>
                <c:pt idx="121">
                  <c:v>3.7752593409999999</c:v>
                </c:pt>
                <c:pt idx="122">
                  <c:v>3.743173927</c:v>
                </c:pt>
                <c:pt idx="123">
                  <c:v>3.7723614130000001</c:v>
                </c:pt>
                <c:pt idx="124">
                  <c:v>3.1713706820000001</c:v>
                </c:pt>
                <c:pt idx="125">
                  <c:v>3.3325664829999999</c:v>
                </c:pt>
                <c:pt idx="126">
                  <c:v>2.2870465790000001</c:v>
                </c:pt>
                <c:pt idx="127">
                  <c:v>2.9842021249999999</c:v>
                </c:pt>
                <c:pt idx="128">
                  <c:v>2.6969314440000001</c:v>
                </c:pt>
                <c:pt idx="129">
                  <c:v>4.102886678</c:v>
                </c:pt>
                <c:pt idx="130">
                  <c:v>6.890472033</c:v>
                </c:pt>
                <c:pt idx="131">
                  <c:v>3.7027362670000001</c:v>
                </c:pt>
                <c:pt idx="132">
                  <c:v>3.4532414239999998</c:v>
                </c:pt>
                <c:pt idx="133">
                  <c:v>3.3628207259999998</c:v>
                </c:pt>
                <c:pt idx="134">
                  <c:v>3.805301144</c:v>
                </c:pt>
                <c:pt idx="135">
                  <c:v>4.320395435</c:v>
                </c:pt>
                <c:pt idx="136">
                  <c:v>6.9937410770000001</c:v>
                </c:pt>
                <c:pt idx="137">
                  <c:v>4.5029680809999997</c:v>
                </c:pt>
                <c:pt idx="138">
                  <c:v>3.0504610699999999</c:v>
                </c:pt>
                <c:pt idx="139">
                  <c:v>4.320395435</c:v>
                </c:pt>
                <c:pt idx="140">
                  <c:v>7.2810172900000003</c:v>
                </c:pt>
                <c:pt idx="141">
                  <c:v>2.7446986619999998</c:v>
                </c:pt>
                <c:pt idx="142">
                  <c:v>3.890562912</c:v>
                </c:pt>
                <c:pt idx="143">
                  <c:v>5.729183087</c:v>
                </c:pt>
                <c:pt idx="144">
                  <c:v>3.022672268</c:v>
                </c:pt>
                <c:pt idx="145">
                  <c:v>3.1291214090000001</c:v>
                </c:pt>
                <c:pt idx="146">
                  <c:v>0</c:v>
                </c:pt>
                <c:pt idx="147">
                  <c:v>0</c:v>
                </c:pt>
                <c:pt idx="148">
                  <c:v>0</c:v>
                </c:pt>
                <c:pt idx="149">
                  <c:v>0</c:v>
                </c:pt>
                <c:pt idx="150">
                  <c:v>0</c:v>
                </c:pt>
                <c:pt idx="151">
                  <c:v>0</c:v>
                </c:pt>
                <c:pt idx="152">
                  <c:v>0</c:v>
                </c:pt>
                <c:pt idx="153">
                  <c:v>0</c:v>
                </c:pt>
                <c:pt idx="154">
                  <c:v>0</c:v>
                </c:pt>
                <c:pt idx="155">
                  <c:v>0</c:v>
                </c:pt>
                <c:pt idx="156">
                  <c:v>0</c:v>
                </c:pt>
                <c:pt idx="157">
                  <c:v>0</c:v>
                </c:pt>
                <c:pt idx="158">
                  <c:v>0</c:v>
                </c:pt>
                <c:pt idx="159">
                  <c:v>0</c:v>
                </c:pt>
                <c:pt idx="160">
                  <c:v>0</c:v>
                </c:pt>
                <c:pt idx="161">
                  <c:v>0</c:v>
                </c:pt>
                <c:pt idx="162">
                  <c:v>0</c:v>
                </c:pt>
                <c:pt idx="163">
                  <c:v>0</c:v>
                </c:pt>
                <c:pt idx="164">
                  <c:v>0</c:v>
                </c:pt>
                <c:pt idx="165">
                  <c:v>0</c:v>
                </c:pt>
                <c:pt idx="166">
                  <c:v>0</c:v>
                </c:pt>
                <c:pt idx="167">
                  <c:v>0</c:v>
                </c:pt>
                <c:pt idx="168">
                  <c:v>0</c:v>
                </c:pt>
                <c:pt idx="169">
                  <c:v>0</c:v>
                </c:pt>
                <c:pt idx="170">
                  <c:v>0</c:v>
                </c:pt>
                <c:pt idx="171">
                  <c:v>0</c:v>
                </c:pt>
                <c:pt idx="172">
                  <c:v>0</c:v>
                </c:pt>
                <c:pt idx="173">
                  <c:v>0</c:v>
                </c:pt>
                <c:pt idx="174">
                  <c:v>0</c:v>
                </c:pt>
                <c:pt idx="175">
                  <c:v>0</c:v>
                </c:pt>
                <c:pt idx="176">
                  <c:v>0</c:v>
                </c:pt>
                <c:pt idx="177">
                  <c:v>0</c:v>
                </c:pt>
                <c:pt idx="178">
                  <c:v>0</c:v>
                </c:pt>
                <c:pt idx="179">
                  <c:v>0</c:v>
                </c:pt>
                <c:pt idx="180">
                  <c:v>0</c:v>
                </c:pt>
                <c:pt idx="181">
                  <c:v>0</c:v>
                </c:pt>
                <c:pt idx="182">
                  <c:v>0</c:v>
                </c:pt>
                <c:pt idx="183">
                  <c:v>0</c:v>
                </c:pt>
                <c:pt idx="184">
                  <c:v>0</c:v>
                </c:pt>
                <c:pt idx="185">
                  <c:v>0</c:v>
                </c:pt>
                <c:pt idx="186">
                  <c:v>0</c:v>
                </c:pt>
                <c:pt idx="187">
                  <c:v>0</c:v>
                </c:pt>
                <c:pt idx="188">
                  <c:v>0</c:v>
                </c:pt>
                <c:pt idx="189">
                  <c:v>0</c:v>
                </c:pt>
                <c:pt idx="190">
                  <c:v>0</c:v>
                </c:pt>
                <c:pt idx="191">
                  <c:v>0</c:v>
                </c:pt>
                <c:pt idx="192">
                  <c:v>0</c:v>
                </c:pt>
                <c:pt idx="193">
                  <c:v>0</c:v>
                </c:pt>
                <c:pt idx="194">
                  <c:v>0</c:v>
                </c:pt>
                <c:pt idx="195">
                  <c:v>0</c:v>
                </c:pt>
                <c:pt idx="196">
                  <c:v>0</c:v>
                </c:pt>
                <c:pt idx="197">
                  <c:v>0</c:v>
                </c:pt>
                <c:pt idx="198">
                  <c:v>0</c:v>
                </c:pt>
                <c:pt idx="199">
                  <c:v>0</c:v>
                </c:pt>
                <c:pt idx="200">
                  <c:v>0</c:v>
                </c:pt>
                <c:pt idx="201">
                  <c:v>0</c:v>
                </c:pt>
                <c:pt idx="202">
                  <c:v>0</c:v>
                </c:pt>
                <c:pt idx="203">
                  <c:v>0</c:v>
                </c:pt>
                <c:pt idx="204">
                  <c:v>0</c:v>
                </c:pt>
                <c:pt idx="205">
                  <c:v>0</c:v>
                </c:pt>
                <c:pt idx="206">
                  <c:v>0</c:v>
                </c:pt>
                <c:pt idx="207">
                  <c:v>0</c:v>
                </c:pt>
                <c:pt idx="208">
                  <c:v>0</c:v>
                </c:pt>
                <c:pt idx="209">
                  <c:v>0</c:v>
                </c:pt>
                <c:pt idx="210">
                  <c:v>0</c:v>
                </c:pt>
                <c:pt idx="211">
                  <c:v>0</c:v>
                </c:pt>
                <c:pt idx="212">
                  <c:v>0</c:v>
                </c:pt>
                <c:pt idx="213">
                  <c:v>0</c:v>
                </c:pt>
                <c:pt idx="214">
                  <c:v>0</c:v>
                </c:pt>
                <c:pt idx="215">
                  <c:v>0</c:v>
                </c:pt>
                <c:pt idx="216">
                  <c:v>0</c:v>
                </c:pt>
                <c:pt idx="217">
                  <c:v>0</c:v>
                </c:pt>
                <c:pt idx="218">
                  <c:v>0</c:v>
                </c:pt>
                <c:pt idx="219">
                  <c:v>0</c:v>
                </c:pt>
                <c:pt idx="220">
                  <c:v>0</c:v>
                </c:pt>
                <c:pt idx="221">
                  <c:v>0</c:v>
                </c:pt>
                <c:pt idx="222">
                  <c:v>0</c:v>
                </c:pt>
                <c:pt idx="223">
                  <c:v>0</c:v>
                </c:pt>
                <c:pt idx="224">
                  <c:v>0</c:v>
                </c:pt>
                <c:pt idx="225">
                  <c:v>0</c:v>
                </c:pt>
                <c:pt idx="226">
                  <c:v>0</c:v>
                </c:pt>
                <c:pt idx="227">
                  <c:v>0</c:v>
                </c:pt>
                <c:pt idx="228">
                  <c:v>0</c:v>
                </c:pt>
                <c:pt idx="229">
                  <c:v>0</c:v>
                </c:pt>
                <c:pt idx="230">
                  <c:v>0</c:v>
                </c:pt>
                <c:pt idx="231">
                  <c:v>0</c:v>
                </c:pt>
                <c:pt idx="232">
                  <c:v>0</c:v>
                </c:pt>
                <c:pt idx="233">
                  <c:v>0</c:v>
                </c:pt>
                <c:pt idx="234">
                  <c:v>0</c:v>
                </c:pt>
                <c:pt idx="235">
                  <c:v>0</c:v>
                </c:pt>
                <c:pt idx="236">
                  <c:v>0</c:v>
                </c:pt>
                <c:pt idx="237">
                  <c:v>0</c:v>
                </c:pt>
                <c:pt idx="238">
                  <c:v>0</c:v>
                </c:pt>
                <c:pt idx="239">
                  <c:v>0</c:v>
                </c:pt>
                <c:pt idx="240">
                  <c:v>0</c:v>
                </c:pt>
              </c:numCache>
            </c:numRef>
          </c:val>
        </c:ser>
        <c:dLbls>
          <c:showLegendKey val="0"/>
          <c:showVal val="0"/>
          <c:showCatName val="0"/>
          <c:showSerName val="0"/>
          <c:showPercent val="0"/>
          <c:showBubbleSize val="0"/>
        </c:dLbls>
        <c:gapWidth val="150"/>
        <c:axId val="305608712"/>
        <c:axId val="305605968"/>
      </c:barChart>
      <c:catAx>
        <c:axId val="305608712"/>
        <c:scaling>
          <c:orientation val="minMax"/>
        </c:scaling>
        <c:delete val="0"/>
        <c:axPos val="b"/>
        <c:title>
          <c:tx>
            <c:rich>
              <a:bodyPr rot="0" spcFirstLastPara="1" vertOverflow="ellipsis" vert="horz" wrap="square" anchor="ctr" anchorCtr="1"/>
              <a:lstStyle/>
              <a:p>
                <a:pPr>
                  <a:defRPr sz="1600" b="1" i="0" u="none" strike="noStrike" kern="1200" baseline="0">
                    <a:solidFill>
                      <a:sysClr val="windowText" lastClr="000000"/>
                    </a:solidFill>
                    <a:latin typeface="+mn-lt"/>
                    <a:ea typeface="+mn-ea"/>
                    <a:cs typeface="+mn-cs"/>
                  </a:defRPr>
                </a:pPr>
                <a:r>
                  <a:rPr lang="en-US" sz="1600" b="1">
                    <a:solidFill>
                      <a:sysClr val="windowText" lastClr="000000"/>
                    </a:solidFill>
                  </a:rPr>
                  <a:t>HUMAN</a:t>
                </a:r>
                <a:r>
                  <a:rPr lang="en-US" sz="1600" b="1" baseline="0">
                    <a:solidFill>
                      <a:sysClr val="windowText" lastClr="000000"/>
                    </a:solidFill>
                  </a:rPr>
                  <a:t> BLASTOCYST CELLS</a:t>
                </a:r>
                <a:endParaRPr lang="en-US" sz="1600" b="1">
                  <a:solidFill>
                    <a:sysClr val="windowText" lastClr="000000"/>
                  </a:solidFill>
                </a:endParaRPr>
              </a:p>
            </c:rich>
          </c:tx>
          <c:overlay val="0"/>
          <c:spPr>
            <a:noFill/>
            <a:ln>
              <a:noFill/>
            </a:ln>
            <a:effectLst/>
          </c:spPr>
          <c:txPr>
            <a:bodyPr rot="0" spcFirstLastPara="1" vertOverflow="ellipsis" vert="horz" wrap="square" anchor="ctr" anchorCtr="1"/>
            <a:lstStyle/>
            <a:p>
              <a:pPr>
                <a:defRPr sz="1600" b="1"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305605968"/>
        <c:crosses val="autoZero"/>
        <c:auto val="1"/>
        <c:lblAlgn val="ctr"/>
        <c:lblOffset val="100"/>
        <c:tickLblSkip val="1"/>
        <c:noMultiLvlLbl val="0"/>
      </c:catAx>
      <c:valAx>
        <c:axId val="305605968"/>
        <c:scaling>
          <c:orientation val="minMax"/>
        </c:scaling>
        <c:delete val="0"/>
        <c:axPos val="l"/>
        <c:majorGridlines>
          <c:spPr>
            <a:ln w="9525" cap="flat" cmpd="sng" algn="ctr">
              <a:noFill/>
              <a:round/>
            </a:ln>
            <a:effectLst/>
          </c:spPr>
        </c:majorGridlines>
        <c:minorGridlines>
          <c:spPr>
            <a:ln w="9525" cap="flat" cmpd="sng" algn="ctr">
              <a:noFill/>
              <a:round/>
            </a:ln>
            <a:effectLst/>
          </c:spPr>
        </c:minorGridlines>
        <c:title>
          <c:tx>
            <c:rich>
              <a:bodyPr rot="-5400000" spcFirstLastPara="1" vertOverflow="ellipsis" vert="horz" wrap="square" anchor="ctr" anchorCtr="1"/>
              <a:lstStyle/>
              <a:p>
                <a:pPr>
                  <a:defRPr sz="1600" b="1" i="0" u="none" strike="noStrike" kern="1200" baseline="0">
                    <a:solidFill>
                      <a:sysClr val="windowText" lastClr="000000"/>
                    </a:solidFill>
                    <a:latin typeface="+mn-lt"/>
                    <a:ea typeface="+mn-ea"/>
                    <a:cs typeface="+mn-cs"/>
                  </a:defRPr>
                </a:pPr>
                <a:r>
                  <a:rPr lang="en-US" sz="1600" b="1">
                    <a:solidFill>
                      <a:sysClr val="windowText" lastClr="000000"/>
                    </a:solidFill>
                  </a:rPr>
                  <a:t>RELATIVE</a:t>
                </a:r>
                <a:r>
                  <a:rPr lang="en-US" sz="1600" b="1" baseline="0">
                    <a:solidFill>
                      <a:sysClr val="windowText" lastClr="000000"/>
                    </a:solidFill>
                  </a:rPr>
                  <a:t> EXPRESSION</a:t>
                </a:r>
                <a:endParaRPr lang="en-US" sz="1600" b="1">
                  <a:solidFill>
                    <a:sysClr val="windowText" lastClr="000000"/>
                  </a:solidFill>
                </a:endParaRPr>
              </a:p>
            </c:rich>
          </c:tx>
          <c:layout>
            <c:manualLayout>
              <c:xMode val="edge"/>
              <c:yMode val="edge"/>
              <c:x val="1.4658633889191808E-2"/>
              <c:y val="0.39526578482487978"/>
            </c:manualLayout>
          </c:layout>
          <c:overlay val="0"/>
          <c:spPr>
            <a:noFill/>
            <a:ln>
              <a:noFill/>
            </a:ln>
            <a:effectLst/>
          </c:spPr>
          <c:txPr>
            <a:bodyPr rot="-5400000" spcFirstLastPara="1" vertOverflow="ellipsis" vert="horz" wrap="square" anchor="ctr" anchorCtr="1"/>
            <a:lstStyle/>
            <a:p>
              <a:pPr>
                <a:defRPr sz="1600" b="1" i="0" u="none" strike="noStrike" kern="1200" baseline="0">
                  <a:solidFill>
                    <a:sysClr val="windowText" lastClr="000000"/>
                  </a:solidFill>
                  <a:latin typeface="+mn-lt"/>
                  <a:ea typeface="+mn-ea"/>
                  <a:cs typeface="+mn-cs"/>
                </a:defRPr>
              </a:pPr>
              <a:endParaRPr lang="en-US"/>
            </a:p>
          </c:txPr>
        </c:title>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crossAx val="305608712"/>
        <c:crossesAt val="1"/>
        <c:crossBetween val="between"/>
      </c:valAx>
      <c:spPr>
        <a:noFill/>
        <a:ln>
          <a:noFill/>
        </a:ln>
        <a:effectLst/>
      </c:spPr>
    </c:plotArea>
    <c:legend>
      <c:legendPos val="t"/>
      <c:overlay val="0"/>
      <c:spPr>
        <a:noFill/>
        <a:ln>
          <a:noFill/>
        </a:ln>
        <a:effectLst/>
      </c:spPr>
      <c:txPr>
        <a:bodyPr rot="0" spcFirstLastPara="1" vertOverflow="ellipsis" vert="horz" wrap="square" anchor="ctr" anchorCtr="1"/>
        <a:lstStyle/>
        <a:p>
          <a:pPr>
            <a:defRPr sz="1800" b="1" i="0" u="none" strike="noStrike" kern="1200" baseline="0">
              <a:solidFill>
                <a:sysClr val="windowText" lastClr="000000"/>
              </a:solidFill>
              <a:latin typeface="+mn-lt"/>
              <a:ea typeface="+mn-ea"/>
              <a:cs typeface="+mn-cs"/>
            </a:defRPr>
          </a:pPr>
          <a:endParaRPr lang="en-US"/>
        </a:p>
      </c:txPr>
    </c:legend>
    <c:plotVisOnly val="1"/>
    <c:dispBlanksAs val="zero"/>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view3D>
      <c:rotX val="15"/>
      <c:rotY val="20"/>
      <c:depthPercent val="100"/>
      <c:rAngAx val="1"/>
    </c:view3D>
    <c:floor>
      <c:thickness val="0"/>
      <c:spPr>
        <a:noFill/>
        <a:ln>
          <a:noFill/>
        </a:ln>
        <a:effectLst/>
        <a:sp3d/>
      </c:spPr>
    </c:floor>
    <c:sideWall>
      <c:thickness val="0"/>
      <c:spPr>
        <a:noFill/>
        <a:ln>
          <a:noFill/>
        </a:ln>
        <a:effectLst/>
        <a:sp3d/>
      </c:spPr>
    </c:sideWall>
    <c:backWall>
      <c:thickness val="0"/>
      <c:spPr>
        <a:noFill/>
        <a:ln>
          <a:noFill/>
        </a:ln>
        <a:effectLst/>
        <a:sp3d/>
      </c:spPr>
    </c:backWall>
    <c:plotArea>
      <c:layout>
        <c:manualLayout>
          <c:layoutTarget val="inner"/>
          <c:xMode val="edge"/>
          <c:yMode val="edge"/>
          <c:x val="0.13629366945542368"/>
          <c:y val="0.14331344180655131"/>
          <c:w val="0.84758183326646519"/>
          <c:h val="0.71770139177085468"/>
        </c:manualLayout>
      </c:layout>
      <c:bar3DChart>
        <c:barDir val="col"/>
        <c:grouping val="clustered"/>
        <c:varyColors val="0"/>
        <c:ser>
          <c:idx val="0"/>
          <c:order val="0"/>
          <c:tx>
            <c:strRef>
              <c:f>hpats!$AQ$1</c:f>
              <c:strCache>
                <c:ptCount val="1"/>
                <c:pt idx="0">
                  <c:v>HPAT21/HPAT2/HPAT15 &amp; HPAT21/HPAT2</c:v>
                </c:pt>
              </c:strCache>
            </c:strRef>
          </c:tx>
          <c:spPr>
            <a:solidFill>
              <a:srgbClr val="00B0F0"/>
            </a:solidFill>
            <a:ln>
              <a:noFill/>
            </a:ln>
            <a:effectLst/>
            <a:sp3d/>
          </c:spPr>
          <c:invertIfNegative val="0"/>
          <c:cat>
            <c:strRef>
              <c:f>hpats!$AP$2:$AP$17</c:f>
              <c:strCache>
                <c:ptCount val="16"/>
                <c:pt idx="0">
                  <c:v>HPAT21</c:v>
                </c:pt>
                <c:pt idx="1">
                  <c:v>HPAT15</c:v>
                </c:pt>
                <c:pt idx="2">
                  <c:v>HPAT2</c:v>
                </c:pt>
                <c:pt idx="3">
                  <c:v>HPAT1</c:v>
                </c:pt>
                <c:pt idx="4">
                  <c:v>HPAT5</c:v>
                </c:pt>
                <c:pt idx="5">
                  <c:v>HPAT7</c:v>
                </c:pt>
                <c:pt idx="6">
                  <c:v>HPAT9</c:v>
                </c:pt>
                <c:pt idx="7">
                  <c:v>HPAT20</c:v>
                </c:pt>
                <c:pt idx="8">
                  <c:v>HPAT4</c:v>
                </c:pt>
                <c:pt idx="9">
                  <c:v>HPAT6</c:v>
                </c:pt>
                <c:pt idx="10">
                  <c:v>HPAT3</c:v>
                </c:pt>
                <c:pt idx="11">
                  <c:v>HPAT17</c:v>
                </c:pt>
                <c:pt idx="12">
                  <c:v>HPAT8</c:v>
                </c:pt>
                <c:pt idx="13">
                  <c:v>HPAT23</c:v>
                </c:pt>
                <c:pt idx="14">
                  <c:v>HPAT14</c:v>
                </c:pt>
                <c:pt idx="15">
                  <c:v>LINC_ROR</c:v>
                </c:pt>
              </c:strCache>
            </c:strRef>
          </c:cat>
          <c:val>
            <c:numRef>
              <c:f>hpats!$AQ$2:$AQ$17</c:f>
              <c:numCache>
                <c:formatCode>General</c:formatCode>
                <c:ptCount val="16"/>
                <c:pt idx="0">
                  <c:v>100</c:v>
                </c:pt>
                <c:pt idx="1">
                  <c:v>56.896551724137936</c:v>
                </c:pt>
                <c:pt idx="2">
                  <c:v>100</c:v>
                </c:pt>
                <c:pt idx="3">
                  <c:v>3.4482758620689653</c:v>
                </c:pt>
                <c:pt idx="4">
                  <c:v>63.793103448275865</c:v>
                </c:pt>
                <c:pt idx="5">
                  <c:v>0</c:v>
                </c:pt>
                <c:pt idx="6">
                  <c:v>0</c:v>
                </c:pt>
                <c:pt idx="7">
                  <c:v>0</c:v>
                </c:pt>
                <c:pt idx="8">
                  <c:v>12.068965517241379</c:v>
                </c:pt>
                <c:pt idx="9">
                  <c:v>0</c:v>
                </c:pt>
                <c:pt idx="10">
                  <c:v>43.103448275862064</c:v>
                </c:pt>
                <c:pt idx="11">
                  <c:v>10.344827586206897</c:v>
                </c:pt>
                <c:pt idx="12">
                  <c:v>8.6206896551724146</c:v>
                </c:pt>
                <c:pt idx="13">
                  <c:v>6.8965517241379306</c:v>
                </c:pt>
                <c:pt idx="14">
                  <c:v>0</c:v>
                </c:pt>
                <c:pt idx="15">
                  <c:v>0</c:v>
                </c:pt>
              </c:numCache>
            </c:numRef>
          </c:val>
        </c:ser>
        <c:ser>
          <c:idx val="1"/>
          <c:order val="1"/>
          <c:tx>
            <c:strRef>
              <c:f>hpats!$AR$1</c:f>
              <c:strCache>
                <c:ptCount val="1"/>
                <c:pt idx="0">
                  <c:v>HPAT21</c:v>
                </c:pt>
              </c:strCache>
            </c:strRef>
          </c:tx>
          <c:spPr>
            <a:solidFill>
              <a:srgbClr val="FF0000"/>
            </a:solidFill>
            <a:ln>
              <a:solidFill>
                <a:schemeClr val="accent1"/>
              </a:solidFill>
            </a:ln>
            <a:effectLst/>
            <a:sp3d>
              <a:contourClr>
                <a:schemeClr val="accent1"/>
              </a:contourClr>
            </a:sp3d>
          </c:spPr>
          <c:invertIfNegative val="0"/>
          <c:cat>
            <c:strRef>
              <c:f>hpats!$AP$2:$AP$17</c:f>
              <c:strCache>
                <c:ptCount val="16"/>
                <c:pt idx="0">
                  <c:v>HPAT21</c:v>
                </c:pt>
                <c:pt idx="1">
                  <c:v>HPAT15</c:v>
                </c:pt>
                <c:pt idx="2">
                  <c:v>HPAT2</c:v>
                </c:pt>
                <c:pt idx="3">
                  <c:v>HPAT1</c:v>
                </c:pt>
                <c:pt idx="4">
                  <c:v>HPAT5</c:v>
                </c:pt>
                <c:pt idx="5">
                  <c:v>HPAT7</c:v>
                </c:pt>
                <c:pt idx="6">
                  <c:v>HPAT9</c:v>
                </c:pt>
                <c:pt idx="7">
                  <c:v>HPAT20</c:v>
                </c:pt>
                <c:pt idx="8">
                  <c:v>HPAT4</c:v>
                </c:pt>
                <c:pt idx="9">
                  <c:v>HPAT6</c:v>
                </c:pt>
                <c:pt idx="10">
                  <c:v>HPAT3</c:v>
                </c:pt>
                <c:pt idx="11">
                  <c:v>HPAT17</c:v>
                </c:pt>
                <c:pt idx="12">
                  <c:v>HPAT8</c:v>
                </c:pt>
                <c:pt idx="13">
                  <c:v>HPAT23</c:v>
                </c:pt>
                <c:pt idx="14">
                  <c:v>HPAT14</c:v>
                </c:pt>
                <c:pt idx="15">
                  <c:v>LINC_ROR</c:v>
                </c:pt>
              </c:strCache>
            </c:strRef>
          </c:cat>
          <c:val>
            <c:numRef>
              <c:f>hpats!$AR$2:$AR$17</c:f>
              <c:numCache>
                <c:formatCode>General</c:formatCode>
                <c:ptCount val="16"/>
                <c:pt idx="0">
                  <c:v>100</c:v>
                </c:pt>
                <c:pt idx="1">
                  <c:v>0</c:v>
                </c:pt>
                <c:pt idx="2">
                  <c:v>0</c:v>
                </c:pt>
                <c:pt idx="3">
                  <c:v>11.956521739130435</c:v>
                </c:pt>
                <c:pt idx="4">
                  <c:v>45.652173913043477</c:v>
                </c:pt>
                <c:pt idx="5">
                  <c:v>0</c:v>
                </c:pt>
                <c:pt idx="6">
                  <c:v>0</c:v>
                </c:pt>
                <c:pt idx="7">
                  <c:v>0</c:v>
                </c:pt>
                <c:pt idx="8">
                  <c:v>6.5217391304347823</c:v>
                </c:pt>
                <c:pt idx="9">
                  <c:v>1.0869565217391304</c:v>
                </c:pt>
                <c:pt idx="10">
                  <c:v>16.304347826086957</c:v>
                </c:pt>
                <c:pt idx="11">
                  <c:v>1.0869565217391304</c:v>
                </c:pt>
                <c:pt idx="12">
                  <c:v>6.5217391304347823</c:v>
                </c:pt>
                <c:pt idx="13">
                  <c:v>2.1739130434782608</c:v>
                </c:pt>
                <c:pt idx="14">
                  <c:v>1.0869565217391304</c:v>
                </c:pt>
                <c:pt idx="15">
                  <c:v>1.0869565217391304</c:v>
                </c:pt>
              </c:numCache>
            </c:numRef>
          </c:val>
          <c:shape val="cylinder"/>
        </c:ser>
        <c:ser>
          <c:idx val="2"/>
          <c:order val="2"/>
          <c:tx>
            <c:strRef>
              <c:f>hpats!$AS$1</c:f>
              <c:strCache>
                <c:ptCount val="1"/>
                <c:pt idx="0">
                  <c:v>HPAT21/HPAT15</c:v>
                </c:pt>
              </c:strCache>
            </c:strRef>
          </c:tx>
          <c:spPr>
            <a:solidFill>
              <a:srgbClr val="FFFF00"/>
            </a:solidFill>
            <a:ln>
              <a:solidFill>
                <a:schemeClr val="accent1"/>
              </a:solidFill>
            </a:ln>
            <a:effectLst/>
            <a:sp3d>
              <a:contourClr>
                <a:schemeClr val="accent1"/>
              </a:contourClr>
            </a:sp3d>
          </c:spPr>
          <c:invertIfNegative val="0"/>
          <c:cat>
            <c:strRef>
              <c:f>hpats!$AP$2:$AP$17</c:f>
              <c:strCache>
                <c:ptCount val="16"/>
                <c:pt idx="0">
                  <c:v>HPAT21</c:v>
                </c:pt>
                <c:pt idx="1">
                  <c:v>HPAT15</c:v>
                </c:pt>
                <c:pt idx="2">
                  <c:v>HPAT2</c:v>
                </c:pt>
                <c:pt idx="3">
                  <c:v>HPAT1</c:v>
                </c:pt>
                <c:pt idx="4">
                  <c:v>HPAT5</c:v>
                </c:pt>
                <c:pt idx="5">
                  <c:v>HPAT7</c:v>
                </c:pt>
                <c:pt idx="6">
                  <c:v>HPAT9</c:v>
                </c:pt>
                <c:pt idx="7">
                  <c:v>HPAT20</c:v>
                </c:pt>
                <c:pt idx="8">
                  <c:v>HPAT4</c:v>
                </c:pt>
                <c:pt idx="9">
                  <c:v>HPAT6</c:v>
                </c:pt>
                <c:pt idx="10">
                  <c:v>HPAT3</c:v>
                </c:pt>
                <c:pt idx="11">
                  <c:v>HPAT17</c:v>
                </c:pt>
                <c:pt idx="12">
                  <c:v>HPAT8</c:v>
                </c:pt>
                <c:pt idx="13">
                  <c:v>HPAT23</c:v>
                </c:pt>
                <c:pt idx="14">
                  <c:v>HPAT14</c:v>
                </c:pt>
                <c:pt idx="15">
                  <c:v>LINC_ROR</c:v>
                </c:pt>
              </c:strCache>
            </c:strRef>
          </c:cat>
          <c:val>
            <c:numRef>
              <c:f>hpats!$AS$2:$AS$17</c:f>
              <c:numCache>
                <c:formatCode>General</c:formatCode>
                <c:ptCount val="16"/>
                <c:pt idx="0">
                  <c:v>100</c:v>
                </c:pt>
                <c:pt idx="1">
                  <c:v>100</c:v>
                </c:pt>
                <c:pt idx="2">
                  <c:v>0</c:v>
                </c:pt>
                <c:pt idx="3">
                  <c:v>2.3809523809523809</c:v>
                </c:pt>
                <c:pt idx="4">
                  <c:v>38.095238095238095</c:v>
                </c:pt>
                <c:pt idx="5">
                  <c:v>1.1904761904761905</c:v>
                </c:pt>
                <c:pt idx="6">
                  <c:v>1.1904761904761905</c:v>
                </c:pt>
                <c:pt idx="7">
                  <c:v>5.9523809523809517</c:v>
                </c:pt>
                <c:pt idx="8">
                  <c:v>4.7619047619047619</c:v>
                </c:pt>
                <c:pt idx="9">
                  <c:v>0</c:v>
                </c:pt>
                <c:pt idx="10">
                  <c:v>16.666666666666664</c:v>
                </c:pt>
                <c:pt idx="11">
                  <c:v>2.3809523809523809</c:v>
                </c:pt>
                <c:pt idx="12">
                  <c:v>3.5714285714285712</c:v>
                </c:pt>
                <c:pt idx="13">
                  <c:v>4.7619047619047619</c:v>
                </c:pt>
                <c:pt idx="14">
                  <c:v>0</c:v>
                </c:pt>
                <c:pt idx="15">
                  <c:v>4.7619047619047619</c:v>
                </c:pt>
              </c:numCache>
            </c:numRef>
          </c:val>
          <c:shape val="cylinder"/>
        </c:ser>
        <c:dLbls>
          <c:showLegendKey val="0"/>
          <c:showVal val="0"/>
          <c:showCatName val="0"/>
          <c:showSerName val="0"/>
          <c:showPercent val="0"/>
          <c:showBubbleSize val="0"/>
        </c:dLbls>
        <c:gapWidth val="150"/>
        <c:shape val="box"/>
        <c:axId val="305606752"/>
        <c:axId val="305611064"/>
        <c:axId val="0"/>
      </c:bar3DChart>
      <c:catAx>
        <c:axId val="305606752"/>
        <c:scaling>
          <c:orientation val="minMax"/>
        </c:scaling>
        <c:delete val="0"/>
        <c:axPos val="b"/>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crossAx val="305611064"/>
        <c:crosses val="autoZero"/>
        <c:auto val="1"/>
        <c:lblAlgn val="ctr"/>
        <c:lblOffset val="100"/>
        <c:noMultiLvlLbl val="0"/>
      </c:catAx>
      <c:valAx>
        <c:axId val="305611064"/>
        <c:scaling>
          <c:orientation val="minMax"/>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800" b="1" i="0" u="none" strike="noStrike" kern="1200" baseline="0">
                    <a:solidFill>
                      <a:sysClr val="windowText" lastClr="000000"/>
                    </a:solidFill>
                    <a:latin typeface="+mn-lt"/>
                    <a:ea typeface="+mn-ea"/>
                    <a:cs typeface="+mn-cs"/>
                  </a:defRPr>
                </a:pPr>
                <a:r>
                  <a:rPr lang="en-US" sz="1800" b="1">
                    <a:solidFill>
                      <a:sysClr val="windowText" lastClr="000000"/>
                    </a:solidFill>
                  </a:rPr>
                  <a:t>PERCENT</a:t>
                </a:r>
                <a:r>
                  <a:rPr lang="en-US" sz="1800" b="1" baseline="0">
                    <a:solidFill>
                      <a:sysClr val="windowText" lastClr="000000"/>
                    </a:solidFill>
                  </a:rPr>
                  <a:t> OF POSITIVE CELLS</a:t>
                </a:r>
                <a:endParaRPr lang="en-US" sz="1800" b="1">
                  <a:solidFill>
                    <a:sysClr val="windowText" lastClr="000000"/>
                  </a:solidFill>
                </a:endParaRPr>
              </a:p>
            </c:rich>
          </c:tx>
          <c:layout>
            <c:manualLayout>
              <c:xMode val="edge"/>
              <c:yMode val="edge"/>
              <c:x val="2.9544996004079491E-2"/>
              <c:y val="0.2900429472532679"/>
            </c:manualLayout>
          </c:layout>
          <c:overlay val="0"/>
          <c:spPr>
            <a:noFill/>
            <a:ln>
              <a:noFill/>
            </a:ln>
            <a:effectLst/>
          </c:spPr>
          <c:txPr>
            <a:bodyPr rot="-5400000" spcFirstLastPara="1" vertOverflow="ellipsis" vert="horz" wrap="square" anchor="ctr" anchorCtr="1"/>
            <a:lstStyle/>
            <a:p>
              <a:pPr>
                <a:defRPr sz="1800" b="1" i="0" u="none" strike="noStrike" kern="1200" baseline="0">
                  <a:solidFill>
                    <a:sysClr val="windowText" lastClr="000000"/>
                  </a:solidFill>
                  <a:latin typeface="+mn-lt"/>
                  <a:ea typeface="+mn-ea"/>
                  <a:cs typeface="+mn-cs"/>
                </a:defRPr>
              </a:pPr>
              <a:endParaRPr lang="en-US"/>
            </a:p>
          </c:txPr>
        </c:title>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crossAx val="305606752"/>
        <c:crosses val="autoZero"/>
        <c:crossBetween val="between"/>
      </c:valAx>
      <c:spPr>
        <a:noFill/>
        <a:ln>
          <a:noFill/>
        </a:ln>
        <a:effectLst/>
      </c:spPr>
    </c:plotArea>
    <c:legend>
      <c:legendPos val="t"/>
      <c:overlay val="0"/>
      <c:spPr>
        <a:noFill/>
        <a:ln>
          <a:noFill/>
        </a:ln>
        <a:effectLst/>
      </c:spPr>
      <c:txPr>
        <a:bodyPr rot="0" spcFirstLastPara="1" vertOverflow="ellipsis" vert="horz" wrap="square" anchor="ctr" anchorCtr="1"/>
        <a:lstStyle/>
        <a:p>
          <a:pPr>
            <a:defRPr sz="1600" b="1" i="0" u="none" strike="noStrike" kern="1200" baseline="0">
              <a:solidFill>
                <a:sysClr val="windowText" lastClr="000000"/>
              </a:solidFill>
              <a:latin typeface="+mn-lt"/>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600" b="1" i="0" u="none" strike="noStrike" kern="1200" spc="0" baseline="0">
                <a:solidFill>
                  <a:sysClr val="windowText" lastClr="000000"/>
                </a:solidFill>
                <a:latin typeface="+mn-lt"/>
                <a:ea typeface="+mn-ea"/>
                <a:cs typeface="+mn-cs"/>
              </a:defRPr>
            </a:pPr>
            <a:r>
              <a:rPr lang="en-US" sz="1600" b="1">
                <a:solidFill>
                  <a:sysClr val="windowText" lastClr="000000"/>
                </a:solidFill>
              </a:rPr>
              <a:t>EXPRESSION</a:t>
            </a:r>
            <a:r>
              <a:rPr lang="en-US" sz="1600" b="1" baseline="0">
                <a:solidFill>
                  <a:sysClr val="windowText" lastClr="000000"/>
                </a:solidFill>
              </a:rPr>
              <a:t> PATTERNS OF PLURIPOTENCY REGULATORY GENES</a:t>
            </a:r>
            <a:endParaRPr lang="en-US" sz="1600" b="1">
              <a:solidFill>
                <a:sysClr val="windowText" lastClr="000000"/>
              </a:solidFill>
            </a:endParaRPr>
          </a:p>
        </c:rich>
      </c:tx>
      <c:overlay val="0"/>
      <c:spPr>
        <a:noFill/>
        <a:ln>
          <a:noFill/>
        </a:ln>
        <a:effectLst/>
      </c:spPr>
      <c:txPr>
        <a:bodyPr rot="0" spcFirstLastPara="1" vertOverflow="ellipsis" vert="horz" wrap="square" anchor="ctr" anchorCtr="1"/>
        <a:lstStyle/>
        <a:p>
          <a:pPr>
            <a:defRPr sz="1600" b="1" i="0" u="none" strike="noStrike" kern="1200" spc="0" baseline="0">
              <a:solidFill>
                <a:sysClr val="windowText" lastClr="000000"/>
              </a:solidFill>
              <a:latin typeface="+mn-lt"/>
              <a:ea typeface="+mn-ea"/>
              <a:cs typeface="+mn-cs"/>
            </a:defRPr>
          </a:pPr>
          <a:endParaRPr lang="en-US"/>
        </a:p>
      </c:txPr>
    </c:title>
    <c:autoTitleDeleted val="0"/>
    <c:view3D>
      <c:rotX val="15"/>
      <c:rotY val="20"/>
      <c:depthPercent val="100"/>
      <c:rAngAx val="1"/>
    </c:view3D>
    <c:floor>
      <c:thickness val="0"/>
      <c:spPr>
        <a:noFill/>
        <a:ln>
          <a:noFill/>
        </a:ln>
        <a:effectLst/>
        <a:sp3d/>
      </c:spPr>
    </c:floor>
    <c:sideWall>
      <c:thickness val="0"/>
      <c:spPr>
        <a:noFill/>
        <a:ln>
          <a:noFill/>
        </a:ln>
        <a:effectLst/>
        <a:sp3d/>
      </c:spPr>
    </c:sideWall>
    <c:backWall>
      <c:thickness val="0"/>
      <c:spPr>
        <a:noFill/>
        <a:ln>
          <a:noFill/>
        </a:ln>
        <a:effectLst/>
        <a:sp3d/>
      </c:spPr>
    </c:backWall>
    <c:plotArea>
      <c:layout>
        <c:manualLayout>
          <c:layoutTarget val="inner"/>
          <c:xMode val="edge"/>
          <c:yMode val="edge"/>
          <c:x val="0.14191531326308576"/>
          <c:y val="0.14331344180655131"/>
          <c:w val="0.84196018945880324"/>
          <c:h val="0.78361230762381318"/>
        </c:manualLayout>
      </c:layout>
      <c:bar3DChart>
        <c:barDir val="col"/>
        <c:grouping val="clustered"/>
        <c:varyColors val="0"/>
        <c:ser>
          <c:idx val="0"/>
          <c:order val="0"/>
          <c:tx>
            <c:strRef>
              <c:f>Figures!$C$1</c:f>
              <c:strCache>
                <c:ptCount val="1"/>
                <c:pt idx="0">
                  <c:v>HPAT21/HPAT2/HPAT15 &amp; HPAT21/HPAT2</c:v>
                </c:pt>
              </c:strCache>
            </c:strRef>
          </c:tx>
          <c:spPr>
            <a:solidFill>
              <a:schemeClr val="accent1"/>
            </a:solidFill>
            <a:ln>
              <a:noFill/>
            </a:ln>
            <a:effectLst/>
            <a:sp3d/>
          </c:spPr>
          <c:invertIfNegative val="0"/>
          <c:cat>
            <c:strRef>
              <c:f>Figures!$B$2:$B$10</c:f>
              <c:strCache>
                <c:ptCount val="9"/>
                <c:pt idx="0">
                  <c:v>TFCP2L1</c:v>
                </c:pt>
                <c:pt idx="1">
                  <c:v>POU5F1</c:v>
                </c:pt>
                <c:pt idx="2">
                  <c:v>DPPA3</c:v>
                </c:pt>
                <c:pt idx="3">
                  <c:v>KLF5</c:v>
                </c:pt>
                <c:pt idx="4">
                  <c:v>NANOG</c:v>
                </c:pt>
                <c:pt idx="5">
                  <c:v>LIN28A</c:v>
                </c:pt>
                <c:pt idx="6">
                  <c:v>TERT</c:v>
                </c:pt>
                <c:pt idx="7">
                  <c:v>YAP</c:v>
                </c:pt>
                <c:pt idx="8">
                  <c:v>MCRS1</c:v>
                </c:pt>
              </c:strCache>
            </c:strRef>
          </c:cat>
          <c:val>
            <c:numRef>
              <c:f>Figures!$C$2:$C$10</c:f>
              <c:numCache>
                <c:formatCode>0.0</c:formatCode>
                <c:ptCount val="9"/>
                <c:pt idx="0">
                  <c:v>94.594594594594597</c:v>
                </c:pt>
                <c:pt idx="1">
                  <c:v>40.54054054054054</c:v>
                </c:pt>
                <c:pt idx="2">
                  <c:v>29.72972972972973</c:v>
                </c:pt>
                <c:pt idx="3">
                  <c:v>75.675675675675677</c:v>
                </c:pt>
                <c:pt idx="4">
                  <c:v>27.027027027027028</c:v>
                </c:pt>
                <c:pt idx="5">
                  <c:v>91.891891891891902</c:v>
                </c:pt>
                <c:pt idx="6">
                  <c:v>40.54054054054054</c:v>
                </c:pt>
                <c:pt idx="7">
                  <c:v>89.189189189189193</c:v>
                </c:pt>
                <c:pt idx="8">
                  <c:v>86.486486486486484</c:v>
                </c:pt>
              </c:numCache>
            </c:numRef>
          </c:val>
        </c:ser>
        <c:ser>
          <c:idx val="1"/>
          <c:order val="1"/>
          <c:tx>
            <c:strRef>
              <c:f>Figures!$D$1</c:f>
              <c:strCache>
                <c:ptCount val="1"/>
                <c:pt idx="0">
                  <c:v>HPAT21/HPAT15</c:v>
                </c:pt>
              </c:strCache>
            </c:strRef>
          </c:tx>
          <c:spPr>
            <a:solidFill>
              <a:srgbClr val="FF0000"/>
            </a:solidFill>
            <a:ln>
              <a:solidFill>
                <a:schemeClr val="accent1"/>
              </a:solidFill>
            </a:ln>
            <a:effectLst/>
            <a:sp3d>
              <a:contourClr>
                <a:schemeClr val="accent1"/>
              </a:contourClr>
            </a:sp3d>
          </c:spPr>
          <c:invertIfNegative val="0"/>
          <c:cat>
            <c:strRef>
              <c:f>Figures!$B$2:$B$10</c:f>
              <c:strCache>
                <c:ptCount val="9"/>
                <c:pt idx="0">
                  <c:v>TFCP2L1</c:v>
                </c:pt>
                <c:pt idx="1">
                  <c:v>POU5F1</c:v>
                </c:pt>
                <c:pt idx="2">
                  <c:v>DPPA3</c:v>
                </c:pt>
                <c:pt idx="3">
                  <c:v>KLF5</c:v>
                </c:pt>
                <c:pt idx="4">
                  <c:v>NANOG</c:v>
                </c:pt>
                <c:pt idx="5">
                  <c:v>LIN28A</c:v>
                </c:pt>
                <c:pt idx="6">
                  <c:v>TERT</c:v>
                </c:pt>
                <c:pt idx="7">
                  <c:v>YAP</c:v>
                </c:pt>
                <c:pt idx="8">
                  <c:v>MCRS1</c:v>
                </c:pt>
              </c:strCache>
            </c:strRef>
          </c:cat>
          <c:val>
            <c:numRef>
              <c:f>Figures!$D$2:$D$10</c:f>
              <c:numCache>
                <c:formatCode>0.0</c:formatCode>
                <c:ptCount val="9"/>
                <c:pt idx="0">
                  <c:v>17.543859649122805</c:v>
                </c:pt>
                <c:pt idx="1">
                  <c:v>3.5087719298245612</c:v>
                </c:pt>
                <c:pt idx="2">
                  <c:v>5.2631578947368416</c:v>
                </c:pt>
                <c:pt idx="3">
                  <c:v>28.07017543859649</c:v>
                </c:pt>
                <c:pt idx="4">
                  <c:v>8.7719298245614024</c:v>
                </c:pt>
                <c:pt idx="5">
                  <c:v>47.368421052631575</c:v>
                </c:pt>
                <c:pt idx="6">
                  <c:v>3.5087719298245612</c:v>
                </c:pt>
                <c:pt idx="7">
                  <c:v>14.035087719298245</c:v>
                </c:pt>
                <c:pt idx="8">
                  <c:v>19.298245614035086</c:v>
                </c:pt>
              </c:numCache>
            </c:numRef>
          </c:val>
          <c:shape val="cylinder"/>
        </c:ser>
        <c:ser>
          <c:idx val="2"/>
          <c:order val="2"/>
          <c:tx>
            <c:strRef>
              <c:f>Figures!$E$1</c:f>
              <c:strCache>
                <c:ptCount val="1"/>
                <c:pt idx="0">
                  <c:v>HPAT21</c:v>
                </c:pt>
              </c:strCache>
            </c:strRef>
          </c:tx>
          <c:spPr>
            <a:solidFill>
              <a:srgbClr val="FFFF00"/>
            </a:solidFill>
            <a:ln>
              <a:solidFill>
                <a:srgbClr val="FFFF00"/>
              </a:solidFill>
            </a:ln>
            <a:effectLst/>
            <a:sp3d>
              <a:contourClr>
                <a:srgbClr val="FFFF00"/>
              </a:contourClr>
            </a:sp3d>
          </c:spPr>
          <c:invertIfNegative val="0"/>
          <c:cat>
            <c:strRef>
              <c:f>Figures!$B$2:$B$10</c:f>
              <c:strCache>
                <c:ptCount val="9"/>
                <c:pt idx="0">
                  <c:v>TFCP2L1</c:v>
                </c:pt>
                <c:pt idx="1">
                  <c:v>POU5F1</c:v>
                </c:pt>
                <c:pt idx="2">
                  <c:v>DPPA3</c:v>
                </c:pt>
                <c:pt idx="3">
                  <c:v>KLF5</c:v>
                </c:pt>
                <c:pt idx="4">
                  <c:v>NANOG</c:v>
                </c:pt>
                <c:pt idx="5">
                  <c:v>LIN28A</c:v>
                </c:pt>
                <c:pt idx="6">
                  <c:v>TERT</c:v>
                </c:pt>
                <c:pt idx="7">
                  <c:v>YAP</c:v>
                </c:pt>
                <c:pt idx="8">
                  <c:v>MCRS1</c:v>
                </c:pt>
              </c:strCache>
            </c:strRef>
          </c:cat>
          <c:val>
            <c:numRef>
              <c:f>Figures!$E$2:$E$10</c:f>
              <c:numCache>
                <c:formatCode>0.0</c:formatCode>
                <c:ptCount val="9"/>
                <c:pt idx="0">
                  <c:v>20.33898305084746</c:v>
                </c:pt>
                <c:pt idx="1">
                  <c:v>5.0847457627118651</c:v>
                </c:pt>
                <c:pt idx="2">
                  <c:v>8.4745762711864394</c:v>
                </c:pt>
                <c:pt idx="3">
                  <c:v>35.593220338983052</c:v>
                </c:pt>
                <c:pt idx="4">
                  <c:v>11.864406779661017</c:v>
                </c:pt>
                <c:pt idx="5">
                  <c:v>47.457627118644069</c:v>
                </c:pt>
                <c:pt idx="6">
                  <c:v>0</c:v>
                </c:pt>
                <c:pt idx="7">
                  <c:v>54.237288135593218</c:v>
                </c:pt>
                <c:pt idx="8">
                  <c:v>15.254237288135593</c:v>
                </c:pt>
              </c:numCache>
            </c:numRef>
          </c:val>
          <c:shape val="pyramidToMax"/>
        </c:ser>
        <c:dLbls>
          <c:showLegendKey val="0"/>
          <c:showVal val="0"/>
          <c:showCatName val="0"/>
          <c:showSerName val="0"/>
          <c:showPercent val="0"/>
          <c:showBubbleSize val="0"/>
        </c:dLbls>
        <c:gapWidth val="150"/>
        <c:shape val="box"/>
        <c:axId val="305605576"/>
        <c:axId val="305609888"/>
        <c:axId val="0"/>
      </c:bar3DChart>
      <c:catAx>
        <c:axId val="305605576"/>
        <c:scaling>
          <c:orientation val="minMax"/>
        </c:scaling>
        <c:delete val="0"/>
        <c:axPos val="b"/>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600" b="1" i="0" u="none" strike="noStrike" kern="1200" baseline="0">
                <a:solidFill>
                  <a:sysClr val="windowText" lastClr="000000"/>
                </a:solidFill>
                <a:latin typeface="+mn-lt"/>
                <a:ea typeface="+mn-ea"/>
                <a:cs typeface="+mn-cs"/>
              </a:defRPr>
            </a:pPr>
            <a:endParaRPr lang="en-US"/>
          </a:p>
        </c:txPr>
        <c:crossAx val="305609888"/>
        <c:crosses val="autoZero"/>
        <c:auto val="1"/>
        <c:lblAlgn val="ctr"/>
        <c:lblOffset val="100"/>
        <c:noMultiLvlLbl val="0"/>
      </c:catAx>
      <c:valAx>
        <c:axId val="305609888"/>
        <c:scaling>
          <c:orientation val="minMax"/>
        </c:scaling>
        <c:delete val="0"/>
        <c:axPos val="l"/>
        <c:majorGridlines>
          <c:spPr>
            <a:ln w="9525" cap="flat" cmpd="sng" algn="ctr">
              <a:noFill/>
              <a:round/>
            </a:ln>
            <a:effectLst/>
          </c:spPr>
        </c:majorGridlines>
        <c:title>
          <c:tx>
            <c:rich>
              <a:bodyPr rot="-5400000" spcFirstLastPara="1" vertOverflow="ellipsis" vert="horz" wrap="square" anchor="ctr" anchorCtr="1"/>
              <a:lstStyle/>
              <a:p>
                <a:pPr>
                  <a:defRPr sz="1600" b="1" i="0" u="none" strike="noStrike" kern="1200" baseline="0">
                    <a:solidFill>
                      <a:sysClr val="windowText" lastClr="000000"/>
                    </a:solidFill>
                    <a:latin typeface="+mn-lt"/>
                    <a:ea typeface="+mn-ea"/>
                    <a:cs typeface="+mn-cs"/>
                  </a:defRPr>
                </a:pPr>
                <a:r>
                  <a:rPr lang="en-US" sz="1600" b="1" dirty="0" smtClean="0">
                    <a:solidFill>
                      <a:sysClr val="windowText" lastClr="000000"/>
                    </a:solidFill>
                  </a:rPr>
                  <a:t>PERCENT</a:t>
                </a:r>
                <a:r>
                  <a:rPr lang="en-US" sz="1600" b="1" baseline="0" dirty="0" smtClean="0">
                    <a:solidFill>
                      <a:sysClr val="windowText" lastClr="000000"/>
                    </a:solidFill>
                  </a:rPr>
                  <a:t> </a:t>
                </a:r>
                <a:r>
                  <a:rPr lang="en-US" sz="1600" b="1" baseline="0" dirty="0">
                    <a:solidFill>
                      <a:sysClr val="windowText" lastClr="000000"/>
                    </a:solidFill>
                  </a:rPr>
                  <a:t>OF POSITIVE CELLS</a:t>
                </a:r>
                <a:endParaRPr lang="en-US" sz="1600" b="1" dirty="0">
                  <a:solidFill>
                    <a:sysClr val="windowText" lastClr="000000"/>
                  </a:solidFill>
                </a:endParaRPr>
              </a:p>
            </c:rich>
          </c:tx>
          <c:layout>
            <c:manualLayout>
              <c:xMode val="edge"/>
              <c:yMode val="edge"/>
              <c:x val="3.3241049345809411E-2"/>
              <c:y val="0.35509364600078547"/>
            </c:manualLayout>
          </c:layout>
          <c:overlay val="0"/>
          <c:spPr>
            <a:noFill/>
            <a:ln>
              <a:noFill/>
            </a:ln>
            <a:effectLst/>
          </c:spPr>
          <c:txPr>
            <a:bodyPr rot="-5400000" spcFirstLastPara="1" vertOverflow="ellipsis" vert="horz" wrap="square" anchor="ctr" anchorCtr="1"/>
            <a:lstStyle/>
            <a:p>
              <a:pPr>
                <a:defRPr sz="1600" b="1" i="0" u="none" strike="noStrike" kern="1200" baseline="0">
                  <a:solidFill>
                    <a:sysClr val="windowText" lastClr="000000"/>
                  </a:solidFill>
                  <a:latin typeface="+mn-lt"/>
                  <a:ea typeface="+mn-ea"/>
                  <a:cs typeface="+mn-cs"/>
                </a:defRPr>
              </a:pPr>
              <a:endParaRPr lang="en-US"/>
            </a:p>
          </c:txPr>
        </c:title>
        <c:numFmt formatCode="0.0" sourceLinked="1"/>
        <c:majorTickMark val="out"/>
        <c:minorTickMark val="none"/>
        <c:tickLblPos val="nextTo"/>
        <c:spPr>
          <a:noFill/>
          <a:ln>
            <a:noFill/>
          </a:ln>
          <a:effectLst/>
        </c:spPr>
        <c:txPr>
          <a:bodyPr rot="-60000000" spcFirstLastPara="1" vertOverflow="ellipsis" vert="horz" wrap="square" anchor="ctr" anchorCtr="1"/>
          <a:lstStyle/>
          <a:p>
            <a:pPr>
              <a:defRPr sz="1400" b="1" i="0" u="none" strike="noStrike" kern="1200" baseline="0">
                <a:solidFill>
                  <a:schemeClr val="tx1">
                    <a:lumMod val="65000"/>
                    <a:lumOff val="35000"/>
                  </a:schemeClr>
                </a:solidFill>
                <a:latin typeface="+mn-lt"/>
                <a:ea typeface="+mn-ea"/>
                <a:cs typeface="+mn-cs"/>
              </a:defRPr>
            </a:pPr>
            <a:endParaRPr lang="en-US"/>
          </a:p>
        </c:txPr>
        <c:crossAx val="305605576"/>
        <c:crosses val="autoZero"/>
        <c:crossBetween val="between"/>
      </c:valAx>
      <c:spPr>
        <a:noFill/>
        <a:ln>
          <a:noFill/>
        </a:ln>
        <a:effectLst/>
      </c:spPr>
    </c:plotArea>
    <c:legend>
      <c:legendPos val="t"/>
      <c:overlay val="0"/>
      <c:spPr>
        <a:noFill/>
        <a:ln>
          <a:noFill/>
        </a:ln>
        <a:effectLst/>
      </c:spPr>
      <c:txPr>
        <a:bodyPr rot="0" spcFirstLastPara="1" vertOverflow="ellipsis" vert="horz" wrap="square" anchor="ctr" anchorCtr="1"/>
        <a:lstStyle/>
        <a:p>
          <a:pPr>
            <a:defRPr sz="1600" b="1" i="0" u="none" strike="noStrike" kern="1200" baseline="0">
              <a:solidFill>
                <a:schemeClr val="tx1">
                  <a:lumMod val="65000"/>
                  <a:lumOff val="35000"/>
                </a:schemeClr>
              </a:solidFill>
              <a:latin typeface="+mn-lt"/>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solidFill>
                <a:latin typeface="+mn-lt"/>
                <a:ea typeface="+mn-ea"/>
                <a:cs typeface="+mn-cs"/>
              </a:defRPr>
            </a:pPr>
            <a:r>
              <a:rPr lang="en-US" sz="1800" b="1" i="0" baseline="0" dirty="0">
                <a:solidFill>
                  <a:sysClr val="windowText" lastClr="000000"/>
                </a:solidFill>
                <a:effectLst/>
              </a:rPr>
              <a:t>Cell identity </a:t>
            </a:r>
            <a:r>
              <a:rPr lang="en-US" sz="1800" b="1" i="0" baseline="0" dirty="0" smtClean="0">
                <a:solidFill>
                  <a:sysClr val="windowText" lastClr="000000"/>
                </a:solidFill>
                <a:effectLst/>
              </a:rPr>
              <a:t>GES </a:t>
            </a:r>
            <a:r>
              <a:rPr lang="en-US" sz="1800" b="1" i="0" baseline="0" dirty="0">
                <a:solidFill>
                  <a:sysClr val="windowText" lastClr="000000"/>
                </a:solidFill>
                <a:effectLst/>
              </a:rPr>
              <a:t>of the </a:t>
            </a:r>
            <a:r>
              <a:rPr lang="en-US" sz="1800" b="1" i="0" baseline="0" dirty="0" smtClean="0">
                <a:solidFill>
                  <a:sysClr val="windowText" lastClr="000000"/>
                </a:solidFill>
                <a:effectLst/>
              </a:rPr>
              <a:t>HPAT2/HPAT15/21 </a:t>
            </a:r>
            <a:r>
              <a:rPr lang="en-US" sz="1800" b="1" i="0" baseline="0" dirty="0">
                <a:solidFill>
                  <a:sysClr val="windowText" lastClr="000000"/>
                </a:solidFill>
                <a:effectLst/>
              </a:rPr>
              <a:t>cells in human blastocysts</a:t>
            </a:r>
            <a:endParaRPr lang="en-US" dirty="0">
              <a:solidFill>
                <a:sysClr val="windowText" lastClr="000000"/>
              </a:solidFill>
              <a:effectLst/>
            </a:endParaRPr>
          </a:p>
        </c:rich>
      </c:tx>
      <c:layout/>
      <c:overlay val="0"/>
      <c:spPr>
        <a:noFill/>
        <a:ln>
          <a:noFill/>
        </a:ln>
        <a:effectLst/>
      </c:spPr>
      <c:txPr>
        <a:bodyPr rot="0" spcFirstLastPara="1" vertOverflow="ellipsis" vert="horz" wrap="square" anchor="ctr" anchorCtr="1"/>
        <a:lstStyle/>
        <a:p>
          <a:pPr marL="0" marR="0" indent="0" algn="ctr" defTabSz="914400" rtl="0" eaLnBrk="1" fontAlgn="auto" latinLnBrk="0" hangingPunct="1">
            <a:lnSpc>
              <a:spcPct val="100000"/>
            </a:lnSpc>
            <a:spcBef>
              <a:spcPts val="0"/>
            </a:spcBef>
            <a:spcAft>
              <a:spcPts val="0"/>
            </a:spcAft>
            <a:buClrTx/>
            <a:buSzTx/>
            <a:buFontTx/>
            <a:buNone/>
            <a:tabLst/>
            <a:defRPr sz="1400" b="0" i="0" u="none" strike="noStrike" kern="1200" spc="0" baseline="0">
              <a:solidFill>
                <a:sysClr val="windowText" lastClr="000000"/>
              </a:solidFill>
              <a:latin typeface="+mn-lt"/>
              <a:ea typeface="+mn-ea"/>
              <a:cs typeface="+mn-cs"/>
            </a:defRPr>
          </a:pPr>
          <a:endParaRPr lang="en-US"/>
        </a:p>
      </c:txPr>
    </c:title>
    <c:autoTitleDeleted val="0"/>
    <c:plotArea>
      <c:layout/>
      <c:radarChart>
        <c:radarStyle val="marker"/>
        <c:varyColors val="0"/>
        <c:ser>
          <c:idx val="0"/>
          <c:order val="0"/>
          <c:tx>
            <c:strRef>
              <c:f>HPAT2_15!$K$38:$K$39</c:f>
              <c:strCache>
                <c:ptCount val="2"/>
                <c:pt idx="0">
                  <c:v>HPAT2/HPAT15/HPAT21</c:v>
                </c:pt>
                <c:pt idx="1">
                  <c:v>Early </c:v>
                </c:pt>
              </c:strCache>
            </c:strRef>
          </c:tx>
          <c:spPr>
            <a:ln w="38100" cap="rnd">
              <a:solidFill>
                <a:schemeClr val="accent1"/>
              </a:solidFill>
              <a:round/>
            </a:ln>
            <a:effectLst/>
          </c:spPr>
          <c:marker>
            <c:symbol val="none"/>
          </c:marker>
          <c:cat>
            <c:strRef>
              <c:f>HPAT2_15!$J$40:$J$86</c:f>
              <c:strCache>
                <c:ptCount val="47"/>
                <c:pt idx="0">
                  <c:v>Percent of cells</c:v>
                </c:pt>
                <c:pt idx="1">
                  <c:v>GATA4</c:v>
                </c:pt>
                <c:pt idx="2">
                  <c:v>GRB7</c:v>
                </c:pt>
                <c:pt idx="3">
                  <c:v>GDF3</c:v>
                </c:pt>
                <c:pt idx="4">
                  <c:v>REST</c:v>
                </c:pt>
                <c:pt idx="5">
                  <c:v>LINC-ROR</c:v>
                </c:pt>
                <c:pt idx="6">
                  <c:v>SOX7</c:v>
                </c:pt>
                <c:pt idx="7">
                  <c:v>SOX17</c:v>
                </c:pt>
                <c:pt idx="8">
                  <c:v>PDGFRa</c:v>
                </c:pt>
                <c:pt idx="9">
                  <c:v>RAS</c:v>
                </c:pt>
                <c:pt idx="10">
                  <c:v>BMP4</c:v>
                </c:pt>
                <c:pt idx="11">
                  <c:v>HPAT2</c:v>
                </c:pt>
                <c:pt idx="12">
                  <c:v>HPAT21</c:v>
                </c:pt>
                <c:pt idx="13">
                  <c:v>HPAT15</c:v>
                </c:pt>
                <c:pt idx="14">
                  <c:v>BPTF</c:v>
                </c:pt>
                <c:pt idx="15">
                  <c:v>G9A</c:v>
                </c:pt>
                <c:pt idx="16">
                  <c:v>P300</c:v>
                </c:pt>
                <c:pt idx="17">
                  <c:v>LIN28A</c:v>
                </c:pt>
                <c:pt idx="18">
                  <c:v>DNMT3B</c:v>
                </c:pt>
                <c:pt idx="19">
                  <c:v>SOX2</c:v>
                </c:pt>
                <c:pt idx="20">
                  <c:v>TFCP2L1</c:v>
                </c:pt>
                <c:pt idx="21">
                  <c:v>LAMC1</c:v>
                </c:pt>
                <c:pt idx="22">
                  <c:v>TAF1</c:v>
                </c:pt>
                <c:pt idx="23">
                  <c:v>YAP</c:v>
                </c:pt>
                <c:pt idx="24">
                  <c:v>MCRS1</c:v>
                </c:pt>
                <c:pt idx="25">
                  <c:v>HPAT5</c:v>
                </c:pt>
                <c:pt idx="26">
                  <c:v>HPAT3</c:v>
                </c:pt>
                <c:pt idx="27">
                  <c:v>EED</c:v>
                </c:pt>
                <c:pt idx="28">
                  <c:v>THAP11</c:v>
                </c:pt>
                <c:pt idx="29">
                  <c:v>TET1</c:v>
                </c:pt>
                <c:pt idx="30">
                  <c:v>LEFTY2</c:v>
                </c:pt>
                <c:pt idx="31">
                  <c:v>SALL4</c:v>
                </c:pt>
                <c:pt idx="32">
                  <c:v>FN1</c:v>
                </c:pt>
                <c:pt idx="33">
                  <c:v>CXCR4</c:v>
                </c:pt>
                <c:pt idx="34">
                  <c:v>EpCAM</c:v>
                </c:pt>
                <c:pt idx="35">
                  <c:v>BRG1</c:v>
                </c:pt>
                <c:pt idx="36">
                  <c:v>MAPK1</c:v>
                </c:pt>
                <c:pt idx="37">
                  <c:v>WNT1</c:v>
                </c:pt>
                <c:pt idx="38">
                  <c:v>HPAT4</c:v>
                </c:pt>
                <c:pt idx="39">
                  <c:v>MAPK3</c:v>
                </c:pt>
                <c:pt idx="40">
                  <c:v>NANOG</c:v>
                </c:pt>
                <c:pt idx="41">
                  <c:v>LATS2</c:v>
                </c:pt>
                <c:pt idx="42">
                  <c:v>DPPA3</c:v>
                </c:pt>
                <c:pt idx="43">
                  <c:v>TERT</c:v>
                </c:pt>
                <c:pt idx="44">
                  <c:v>FGFR2</c:v>
                </c:pt>
                <c:pt idx="45">
                  <c:v>ID2</c:v>
                </c:pt>
                <c:pt idx="46">
                  <c:v>CDKN2A</c:v>
                </c:pt>
              </c:strCache>
            </c:strRef>
          </c:cat>
          <c:val>
            <c:numRef>
              <c:f>HPAT2_15!$K$40:$K$86</c:f>
              <c:numCache>
                <c:formatCode>0</c:formatCode>
                <c:ptCount val="47"/>
                <c:pt idx="0">
                  <c:v>0</c:v>
                </c:pt>
                <c:pt idx="1">
                  <c:v>0</c:v>
                </c:pt>
                <c:pt idx="2">
                  <c:v>0</c:v>
                </c:pt>
                <c:pt idx="3">
                  <c:v>0</c:v>
                </c:pt>
                <c:pt idx="4">
                  <c:v>0</c:v>
                </c:pt>
                <c:pt idx="5">
                  <c:v>0</c:v>
                </c:pt>
                <c:pt idx="6">
                  <c:v>0</c:v>
                </c:pt>
                <c:pt idx="7">
                  <c:v>0</c:v>
                </c:pt>
                <c:pt idx="8">
                  <c:v>0</c:v>
                </c:pt>
                <c:pt idx="9">
                  <c:v>12.5</c:v>
                </c:pt>
                <c:pt idx="10">
                  <c:v>0</c:v>
                </c:pt>
                <c:pt idx="11">
                  <c:v>100</c:v>
                </c:pt>
                <c:pt idx="12">
                  <c:v>100</c:v>
                </c:pt>
                <c:pt idx="13">
                  <c:v>100</c:v>
                </c:pt>
                <c:pt idx="14">
                  <c:v>100</c:v>
                </c:pt>
                <c:pt idx="15">
                  <c:v>100</c:v>
                </c:pt>
                <c:pt idx="16">
                  <c:v>100</c:v>
                </c:pt>
                <c:pt idx="17">
                  <c:v>100</c:v>
                </c:pt>
                <c:pt idx="18">
                  <c:v>100</c:v>
                </c:pt>
                <c:pt idx="19">
                  <c:v>100</c:v>
                </c:pt>
                <c:pt idx="20">
                  <c:v>100</c:v>
                </c:pt>
                <c:pt idx="21">
                  <c:v>100</c:v>
                </c:pt>
                <c:pt idx="22">
                  <c:v>100</c:v>
                </c:pt>
                <c:pt idx="23">
                  <c:v>100</c:v>
                </c:pt>
                <c:pt idx="24">
                  <c:v>100</c:v>
                </c:pt>
                <c:pt idx="25">
                  <c:v>68.75</c:v>
                </c:pt>
                <c:pt idx="26">
                  <c:v>18.75</c:v>
                </c:pt>
                <c:pt idx="27">
                  <c:v>81.25</c:v>
                </c:pt>
                <c:pt idx="28">
                  <c:v>0</c:v>
                </c:pt>
                <c:pt idx="29">
                  <c:v>0</c:v>
                </c:pt>
                <c:pt idx="30">
                  <c:v>43.75</c:v>
                </c:pt>
                <c:pt idx="31">
                  <c:v>0</c:v>
                </c:pt>
                <c:pt idx="32">
                  <c:v>100</c:v>
                </c:pt>
                <c:pt idx="33">
                  <c:v>100</c:v>
                </c:pt>
                <c:pt idx="34">
                  <c:v>100</c:v>
                </c:pt>
                <c:pt idx="35">
                  <c:v>100</c:v>
                </c:pt>
                <c:pt idx="36">
                  <c:v>100</c:v>
                </c:pt>
                <c:pt idx="37">
                  <c:v>100</c:v>
                </c:pt>
                <c:pt idx="38">
                  <c:v>6.25</c:v>
                </c:pt>
                <c:pt idx="39">
                  <c:v>0</c:v>
                </c:pt>
                <c:pt idx="40">
                  <c:v>0</c:v>
                </c:pt>
                <c:pt idx="41">
                  <c:v>0</c:v>
                </c:pt>
                <c:pt idx="42">
                  <c:v>0</c:v>
                </c:pt>
                <c:pt idx="43">
                  <c:v>6.25</c:v>
                </c:pt>
                <c:pt idx="44">
                  <c:v>0</c:v>
                </c:pt>
                <c:pt idx="45">
                  <c:v>0</c:v>
                </c:pt>
                <c:pt idx="46">
                  <c:v>6.25</c:v>
                </c:pt>
              </c:numCache>
            </c:numRef>
          </c:val>
        </c:ser>
        <c:ser>
          <c:idx val="1"/>
          <c:order val="1"/>
          <c:tx>
            <c:strRef>
              <c:f>HPAT2_15!$L$38:$L$39</c:f>
              <c:strCache>
                <c:ptCount val="2"/>
                <c:pt idx="0">
                  <c:v>HPAT2/HPAT15/HPAT21</c:v>
                </c:pt>
                <c:pt idx="1">
                  <c:v>Late</c:v>
                </c:pt>
              </c:strCache>
            </c:strRef>
          </c:tx>
          <c:spPr>
            <a:ln w="38100" cap="rnd">
              <a:solidFill>
                <a:schemeClr val="accent2"/>
              </a:solidFill>
              <a:round/>
            </a:ln>
            <a:effectLst/>
          </c:spPr>
          <c:marker>
            <c:symbol val="none"/>
          </c:marker>
          <c:cat>
            <c:strRef>
              <c:f>HPAT2_15!$J$40:$J$86</c:f>
              <c:strCache>
                <c:ptCount val="47"/>
                <c:pt idx="0">
                  <c:v>Percent of cells</c:v>
                </c:pt>
                <c:pt idx="1">
                  <c:v>GATA4</c:v>
                </c:pt>
                <c:pt idx="2">
                  <c:v>GRB7</c:v>
                </c:pt>
                <c:pt idx="3">
                  <c:v>GDF3</c:v>
                </c:pt>
                <c:pt idx="4">
                  <c:v>REST</c:v>
                </c:pt>
                <c:pt idx="5">
                  <c:v>LINC-ROR</c:v>
                </c:pt>
                <c:pt idx="6">
                  <c:v>SOX7</c:v>
                </c:pt>
                <c:pt idx="7">
                  <c:v>SOX17</c:v>
                </c:pt>
                <c:pt idx="8">
                  <c:v>PDGFRa</c:v>
                </c:pt>
                <c:pt idx="9">
                  <c:v>RAS</c:v>
                </c:pt>
                <c:pt idx="10">
                  <c:v>BMP4</c:v>
                </c:pt>
                <c:pt idx="11">
                  <c:v>HPAT2</c:v>
                </c:pt>
                <c:pt idx="12">
                  <c:v>HPAT21</c:v>
                </c:pt>
                <c:pt idx="13">
                  <c:v>HPAT15</c:v>
                </c:pt>
                <c:pt idx="14">
                  <c:v>BPTF</c:v>
                </c:pt>
                <c:pt idx="15">
                  <c:v>G9A</c:v>
                </c:pt>
                <c:pt idx="16">
                  <c:v>P300</c:v>
                </c:pt>
                <c:pt idx="17">
                  <c:v>LIN28A</c:v>
                </c:pt>
                <c:pt idx="18">
                  <c:v>DNMT3B</c:v>
                </c:pt>
                <c:pt idx="19">
                  <c:v>SOX2</c:v>
                </c:pt>
                <c:pt idx="20">
                  <c:v>TFCP2L1</c:v>
                </c:pt>
                <c:pt idx="21">
                  <c:v>LAMC1</c:v>
                </c:pt>
                <c:pt idx="22">
                  <c:v>TAF1</c:v>
                </c:pt>
                <c:pt idx="23">
                  <c:v>YAP</c:v>
                </c:pt>
                <c:pt idx="24">
                  <c:v>MCRS1</c:v>
                </c:pt>
                <c:pt idx="25">
                  <c:v>HPAT5</c:v>
                </c:pt>
                <c:pt idx="26">
                  <c:v>HPAT3</c:v>
                </c:pt>
                <c:pt idx="27">
                  <c:v>EED</c:v>
                </c:pt>
                <c:pt idx="28">
                  <c:v>THAP11</c:v>
                </c:pt>
                <c:pt idx="29">
                  <c:v>TET1</c:v>
                </c:pt>
                <c:pt idx="30">
                  <c:v>LEFTY2</c:v>
                </c:pt>
                <c:pt idx="31">
                  <c:v>SALL4</c:v>
                </c:pt>
                <c:pt idx="32">
                  <c:v>FN1</c:v>
                </c:pt>
                <c:pt idx="33">
                  <c:v>CXCR4</c:v>
                </c:pt>
                <c:pt idx="34">
                  <c:v>EpCAM</c:v>
                </c:pt>
                <c:pt idx="35">
                  <c:v>BRG1</c:v>
                </c:pt>
                <c:pt idx="36">
                  <c:v>MAPK1</c:v>
                </c:pt>
                <c:pt idx="37">
                  <c:v>WNT1</c:v>
                </c:pt>
                <c:pt idx="38">
                  <c:v>HPAT4</c:v>
                </c:pt>
                <c:pt idx="39">
                  <c:v>MAPK3</c:v>
                </c:pt>
                <c:pt idx="40">
                  <c:v>NANOG</c:v>
                </c:pt>
                <c:pt idx="41">
                  <c:v>LATS2</c:v>
                </c:pt>
                <c:pt idx="42">
                  <c:v>DPPA3</c:v>
                </c:pt>
                <c:pt idx="43">
                  <c:v>TERT</c:v>
                </c:pt>
                <c:pt idx="44">
                  <c:v>FGFR2</c:v>
                </c:pt>
                <c:pt idx="45">
                  <c:v>ID2</c:v>
                </c:pt>
                <c:pt idx="46">
                  <c:v>CDKN2A</c:v>
                </c:pt>
              </c:strCache>
            </c:strRef>
          </c:cat>
          <c:val>
            <c:numRef>
              <c:f>HPAT2_15!$L$40:$L$86</c:f>
              <c:numCache>
                <c:formatCode>0</c:formatCode>
                <c:ptCount val="47"/>
                <c:pt idx="0">
                  <c:v>0</c:v>
                </c:pt>
                <c:pt idx="1">
                  <c:v>0</c:v>
                </c:pt>
                <c:pt idx="2">
                  <c:v>6.25</c:v>
                </c:pt>
                <c:pt idx="3">
                  <c:v>25</c:v>
                </c:pt>
                <c:pt idx="4">
                  <c:v>6.25</c:v>
                </c:pt>
                <c:pt idx="5">
                  <c:v>0</c:v>
                </c:pt>
                <c:pt idx="6">
                  <c:v>0</c:v>
                </c:pt>
                <c:pt idx="7">
                  <c:v>0</c:v>
                </c:pt>
                <c:pt idx="8">
                  <c:v>6.25</c:v>
                </c:pt>
                <c:pt idx="9">
                  <c:v>0</c:v>
                </c:pt>
                <c:pt idx="10">
                  <c:v>0</c:v>
                </c:pt>
                <c:pt idx="11">
                  <c:v>100</c:v>
                </c:pt>
                <c:pt idx="12">
                  <c:v>100</c:v>
                </c:pt>
                <c:pt idx="13">
                  <c:v>100</c:v>
                </c:pt>
                <c:pt idx="14">
                  <c:v>93.75</c:v>
                </c:pt>
                <c:pt idx="15">
                  <c:v>81.25</c:v>
                </c:pt>
                <c:pt idx="16">
                  <c:v>81.25</c:v>
                </c:pt>
                <c:pt idx="17">
                  <c:v>93.75</c:v>
                </c:pt>
                <c:pt idx="18">
                  <c:v>87.5</c:v>
                </c:pt>
                <c:pt idx="19">
                  <c:v>93.75</c:v>
                </c:pt>
                <c:pt idx="20">
                  <c:v>100</c:v>
                </c:pt>
                <c:pt idx="21">
                  <c:v>87.5</c:v>
                </c:pt>
                <c:pt idx="22">
                  <c:v>87.5</c:v>
                </c:pt>
                <c:pt idx="23">
                  <c:v>87.5</c:v>
                </c:pt>
                <c:pt idx="24">
                  <c:v>81.25</c:v>
                </c:pt>
                <c:pt idx="25">
                  <c:v>62.5</c:v>
                </c:pt>
                <c:pt idx="26">
                  <c:v>50</c:v>
                </c:pt>
                <c:pt idx="27">
                  <c:v>81.25</c:v>
                </c:pt>
                <c:pt idx="28">
                  <c:v>25</c:v>
                </c:pt>
                <c:pt idx="29">
                  <c:v>18.75</c:v>
                </c:pt>
                <c:pt idx="30">
                  <c:v>62.5</c:v>
                </c:pt>
                <c:pt idx="31">
                  <c:v>37.5</c:v>
                </c:pt>
                <c:pt idx="32">
                  <c:v>75</c:v>
                </c:pt>
                <c:pt idx="33">
                  <c:v>87.5</c:v>
                </c:pt>
                <c:pt idx="34">
                  <c:v>87.5</c:v>
                </c:pt>
                <c:pt idx="35">
                  <c:v>81.25</c:v>
                </c:pt>
                <c:pt idx="36">
                  <c:v>81.25</c:v>
                </c:pt>
                <c:pt idx="37">
                  <c:v>43.75</c:v>
                </c:pt>
                <c:pt idx="38">
                  <c:v>12.5</c:v>
                </c:pt>
                <c:pt idx="39">
                  <c:v>25</c:v>
                </c:pt>
                <c:pt idx="40">
                  <c:v>12.5</c:v>
                </c:pt>
                <c:pt idx="41">
                  <c:v>12.5</c:v>
                </c:pt>
                <c:pt idx="42">
                  <c:v>25</c:v>
                </c:pt>
                <c:pt idx="43">
                  <c:v>56.25</c:v>
                </c:pt>
                <c:pt idx="44">
                  <c:v>37.5</c:v>
                </c:pt>
                <c:pt idx="45">
                  <c:v>6.25</c:v>
                </c:pt>
                <c:pt idx="46">
                  <c:v>62.5</c:v>
                </c:pt>
              </c:numCache>
            </c:numRef>
          </c:val>
        </c:ser>
        <c:dLbls>
          <c:showLegendKey val="0"/>
          <c:showVal val="0"/>
          <c:showCatName val="0"/>
          <c:showSerName val="0"/>
          <c:showPercent val="0"/>
          <c:showBubbleSize val="0"/>
        </c:dLbls>
        <c:axId val="305610280"/>
        <c:axId val="305610672"/>
      </c:radarChart>
      <c:catAx>
        <c:axId val="30561028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mn-lt"/>
                <a:ea typeface="+mn-ea"/>
                <a:cs typeface="+mn-cs"/>
              </a:defRPr>
            </a:pPr>
            <a:endParaRPr lang="en-US"/>
          </a:p>
        </c:txPr>
        <c:crossAx val="305610672"/>
        <c:crosses val="autoZero"/>
        <c:auto val="1"/>
        <c:lblAlgn val="ctr"/>
        <c:lblOffset val="100"/>
        <c:noMultiLvlLbl val="0"/>
      </c:catAx>
      <c:valAx>
        <c:axId val="305610672"/>
        <c:scaling>
          <c:orientation val="minMax"/>
        </c:scaling>
        <c:delete val="0"/>
        <c:axPos val="l"/>
        <c:majorGridlines>
          <c:spPr>
            <a:ln w="9525" cap="flat" cmpd="sng" algn="ctr">
              <a:solidFill>
                <a:schemeClr val="tx1">
                  <a:lumMod val="15000"/>
                  <a:lumOff val="85000"/>
                </a:schemeClr>
              </a:solidFill>
              <a:round/>
            </a:ln>
            <a:effectLst/>
          </c:spPr>
        </c:majorGridlines>
        <c:numFmt formatCode="0" sourceLinked="1"/>
        <c:majorTickMark val="none"/>
        <c:minorTickMark val="none"/>
        <c:tickLblPos val="nextTo"/>
        <c:spPr>
          <a:noFill/>
          <a:ln>
            <a:noFill/>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mn-lt"/>
                <a:ea typeface="+mn-ea"/>
                <a:cs typeface="+mn-cs"/>
              </a:defRPr>
            </a:pPr>
            <a:endParaRPr lang="en-US"/>
          </a:p>
        </c:txPr>
        <c:crossAx val="305610280"/>
        <c:crosses val="autoZero"/>
        <c:crossBetween val="between"/>
      </c:valAx>
      <c:spPr>
        <a:noFill/>
        <a:ln>
          <a:noFill/>
        </a:ln>
        <a:effectLst/>
      </c:spPr>
    </c:plotArea>
    <c:legend>
      <c:legendPos val="t"/>
      <c:layout/>
      <c:overlay val="0"/>
      <c:spPr>
        <a:noFill/>
        <a:ln>
          <a:noFill/>
        </a:ln>
        <a:effectLst/>
      </c:spPr>
      <c:txPr>
        <a:bodyPr rot="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800" b="1" i="0" u="none" strike="noStrike" kern="1200" spc="0" baseline="0">
                <a:solidFill>
                  <a:sysClr val="windowText" lastClr="000000"/>
                </a:solidFill>
                <a:latin typeface="+mn-lt"/>
                <a:ea typeface="+mn-ea"/>
                <a:cs typeface="+mn-cs"/>
              </a:defRPr>
            </a:pPr>
            <a:r>
              <a:rPr lang="en-US" sz="1800" b="1" baseline="0" dirty="0">
                <a:solidFill>
                  <a:sysClr val="windowText" lastClr="000000"/>
                </a:solidFill>
              </a:rPr>
              <a:t>Cell identity </a:t>
            </a:r>
            <a:r>
              <a:rPr lang="en-US" sz="1800" b="1" baseline="0" dirty="0" smtClean="0">
                <a:solidFill>
                  <a:sysClr val="windowText" lastClr="000000"/>
                </a:solidFill>
              </a:rPr>
              <a:t>GES </a:t>
            </a:r>
            <a:r>
              <a:rPr lang="en-US" sz="1800" b="1" baseline="0" dirty="0">
                <a:solidFill>
                  <a:sysClr val="windowText" lastClr="000000"/>
                </a:solidFill>
              </a:rPr>
              <a:t>of the HPAT2/HPAT21 cells in human blastocysts</a:t>
            </a:r>
            <a:endParaRPr lang="en-US" sz="1800" b="1" dirty="0">
              <a:solidFill>
                <a:sysClr val="windowText" lastClr="000000"/>
              </a:solidFill>
            </a:endParaRPr>
          </a:p>
        </c:rich>
      </c:tx>
      <c:layout/>
      <c:overlay val="0"/>
      <c:spPr>
        <a:noFill/>
        <a:ln>
          <a:noFill/>
        </a:ln>
        <a:effectLst/>
      </c:spPr>
      <c:txPr>
        <a:bodyPr rot="0" spcFirstLastPara="1" vertOverflow="ellipsis" vert="horz" wrap="square" anchor="ctr" anchorCtr="1"/>
        <a:lstStyle/>
        <a:p>
          <a:pPr>
            <a:defRPr sz="1800" b="1" i="0" u="none" strike="noStrike" kern="1200" spc="0" baseline="0">
              <a:solidFill>
                <a:sysClr val="windowText" lastClr="000000"/>
              </a:solidFill>
              <a:latin typeface="+mn-lt"/>
              <a:ea typeface="+mn-ea"/>
              <a:cs typeface="+mn-cs"/>
            </a:defRPr>
          </a:pPr>
          <a:endParaRPr lang="en-US"/>
        </a:p>
      </c:txPr>
    </c:title>
    <c:autoTitleDeleted val="0"/>
    <c:plotArea>
      <c:layout/>
      <c:radarChart>
        <c:radarStyle val="marker"/>
        <c:varyColors val="0"/>
        <c:ser>
          <c:idx val="0"/>
          <c:order val="0"/>
          <c:tx>
            <c:strRef>
              <c:f>HPAT2!$K$29:$K$30</c:f>
              <c:strCache>
                <c:ptCount val="2"/>
                <c:pt idx="0">
                  <c:v>HPAT2/HPAT21</c:v>
                </c:pt>
                <c:pt idx="1">
                  <c:v>Early </c:v>
                </c:pt>
              </c:strCache>
            </c:strRef>
          </c:tx>
          <c:spPr>
            <a:ln w="38100" cap="rnd">
              <a:solidFill>
                <a:schemeClr val="accent1"/>
              </a:solidFill>
              <a:round/>
            </a:ln>
            <a:effectLst/>
          </c:spPr>
          <c:marker>
            <c:symbol val="none"/>
          </c:marker>
          <c:cat>
            <c:strRef>
              <c:f>HPAT2!$J$31:$J$77</c:f>
              <c:strCache>
                <c:ptCount val="47"/>
                <c:pt idx="0">
                  <c:v>Percent of cells</c:v>
                </c:pt>
                <c:pt idx="1">
                  <c:v>GATA4</c:v>
                </c:pt>
                <c:pt idx="2">
                  <c:v>GRB7</c:v>
                </c:pt>
                <c:pt idx="3">
                  <c:v>GDF3</c:v>
                </c:pt>
                <c:pt idx="4">
                  <c:v>REST</c:v>
                </c:pt>
                <c:pt idx="5">
                  <c:v>LINC-ROR</c:v>
                </c:pt>
                <c:pt idx="6">
                  <c:v>SOX7</c:v>
                </c:pt>
                <c:pt idx="7">
                  <c:v>SOX17</c:v>
                </c:pt>
                <c:pt idx="8">
                  <c:v>PDGFRa</c:v>
                </c:pt>
                <c:pt idx="9">
                  <c:v>RAS</c:v>
                </c:pt>
                <c:pt idx="10">
                  <c:v>BMP4</c:v>
                </c:pt>
                <c:pt idx="11">
                  <c:v>HPAT2</c:v>
                </c:pt>
                <c:pt idx="12">
                  <c:v>HPAT21</c:v>
                </c:pt>
                <c:pt idx="13">
                  <c:v>HPAT15</c:v>
                </c:pt>
                <c:pt idx="14">
                  <c:v>BPTF</c:v>
                </c:pt>
                <c:pt idx="15">
                  <c:v>G9A</c:v>
                </c:pt>
                <c:pt idx="16">
                  <c:v>P300</c:v>
                </c:pt>
                <c:pt idx="17">
                  <c:v>LIN28A</c:v>
                </c:pt>
                <c:pt idx="18">
                  <c:v>DNMT3B</c:v>
                </c:pt>
                <c:pt idx="19">
                  <c:v>SOX2</c:v>
                </c:pt>
                <c:pt idx="20">
                  <c:v>TFCP2L1</c:v>
                </c:pt>
                <c:pt idx="21">
                  <c:v>LAMC1</c:v>
                </c:pt>
                <c:pt idx="22">
                  <c:v>TAF1</c:v>
                </c:pt>
                <c:pt idx="23">
                  <c:v>YAP</c:v>
                </c:pt>
                <c:pt idx="24">
                  <c:v>MCRS1</c:v>
                </c:pt>
                <c:pt idx="25">
                  <c:v>HPAT5</c:v>
                </c:pt>
                <c:pt idx="26">
                  <c:v>HPAT3</c:v>
                </c:pt>
                <c:pt idx="27">
                  <c:v>EED</c:v>
                </c:pt>
                <c:pt idx="28">
                  <c:v>THAP11</c:v>
                </c:pt>
                <c:pt idx="29">
                  <c:v>TET1</c:v>
                </c:pt>
                <c:pt idx="30">
                  <c:v>LEFTY2</c:v>
                </c:pt>
                <c:pt idx="31">
                  <c:v>SALL4</c:v>
                </c:pt>
                <c:pt idx="32">
                  <c:v>FN1</c:v>
                </c:pt>
                <c:pt idx="33">
                  <c:v>CXCR4</c:v>
                </c:pt>
                <c:pt idx="34">
                  <c:v>EpCAM</c:v>
                </c:pt>
                <c:pt idx="35">
                  <c:v>BRG1</c:v>
                </c:pt>
                <c:pt idx="36">
                  <c:v>MAPK1</c:v>
                </c:pt>
                <c:pt idx="37">
                  <c:v>WNT1</c:v>
                </c:pt>
                <c:pt idx="38">
                  <c:v>HPAT4</c:v>
                </c:pt>
                <c:pt idx="39">
                  <c:v>MAPK3</c:v>
                </c:pt>
                <c:pt idx="40">
                  <c:v>NANOG</c:v>
                </c:pt>
                <c:pt idx="41">
                  <c:v>LATS2</c:v>
                </c:pt>
                <c:pt idx="42">
                  <c:v>DPPA3</c:v>
                </c:pt>
                <c:pt idx="43">
                  <c:v>TERT</c:v>
                </c:pt>
                <c:pt idx="44">
                  <c:v>FGFR2</c:v>
                </c:pt>
                <c:pt idx="45">
                  <c:v>ID2</c:v>
                </c:pt>
                <c:pt idx="46">
                  <c:v>CDKN2A</c:v>
                </c:pt>
              </c:strCache>
            </c:strRef>
          </c:cat>
          <c:val>
            <c:numRef>
              <c:f>HPAT2!$K$31:$K$77</c:f>
              <c:numCache>
                <c:formatCode>General</c:formatCode>
                <c:ptCount val="47"/>
                <c:pt idx="0">
                  <c:v>0</c:v>
                </c:pt>
                <c:pt idx="1">
                  <c:v>0</c:v>
                </c:pt>
                <c:pt idx="2">
                  <c:v>0</c:v>
                </c:pt>
                <c:pt idx="3">
                  <c:v>0</c:v>
                </c:pt>
                <c:pt idx="4">
                  <c:v>0</c:v>
                </c:pt>
                <c:pt idx="5">
                  <c:v>0</c:v>
                </c:pt>
                <c:pt idx="6">
                  <c:v>0</c:v>
                </c:pt>
                <c:pt idx="7">
                  <c:v>0</c:v>
                </c:pt>
                <c:pt idx="8">
                  <c:v>0</c:v>
                </c:pt>
                <c:pt idx="9">
                  <c:v>0</c:v>
                </c:pt>
                <c:pt idx="10">
                  <c:v>0</c:v>
                </c:pt>
                <c:pt idx="11">
                  <c:v>100</c:v>
                </c:pt>
                <c:pt idx="12">
                  <c:v>100</c:v>
                </c:pt>
                <c:pt idx="13">
                  <c:v>0</c:v>
                </c:pt>
                <c:pt idx="14">
                  <c:v>100</c:v>
                </c:pt>
                <c:pt idx="15">
                  <c:v>100</c:v>
                </c:pt>
                <c:pt idx="16">
                  <c:v>100</c:v>
                </c:pt>
                <c:pt idx="17">
                  <c:v>100</c:v>
                </c:pt>
                <c:pt idx="18">
                  <c:v>100</c:v>
                </c:pt>
                <c:pt idx="19">
                  <c:v>100</c:v>
                </c:pt>
                <c:pt idx="20">
                  <c:v>100</c:v>
                </c:pt>
                <c:pt idx="21">
                  <c:v>100</c:v>
                </c:pt>
                <c:pt idx="22">
                  <c:v>100</c:v>
                </c:pt>
                <c:pt idx="23">
                  <c:v>100</c:v>
                </c:pt>
                <c:pt idx="24">
                  <c:v>100</c:v>
                </c:pt>
                <c:pt idx="25">
                  <c:v>25</c:v>
                </c:pt>
                <c:pt idx="26">
                  <c:v>25</c:v>
                </c:pt>
                <c:pt idx="27">
                  <c:v>25</c:v>
                </c:pt>
                <c:pt idx="28">
                  <c:v>0</c:v>
                </c:pt>
                <c:pt idx="29">
                  <c:v>0</c:v>
                </c:pt>
                <c:pt idx="30">
                  <c:v>0</c:v>
                </c:pt>
                <c:pt idx="31">
                  <c:v>0</c:v>
                </c:pt>
                <c:pt idx="32">
                  <c:v>100</c:v>
                </c:pt>
                <c:pt idx="33">
                  <c:v>100</c:v>
                </c:pt>
                <c:pt idx="34">
                  <c:v>100</c:v>
                </c:pt>
                <c:pt idx="35">
                  <c:v>100</c:v>
                </c:pt>
                <c:pt idx="36">
                  <c:v>100</c:v>
                </c:pt>
                <c:pt idx="37">
                  <c:v>100</c:v>
                </c:pt>
                <c:pt idx="38">
                  <c:v>75</c:v>
                </c:pt>
                <c:pt idx="39">
                  <c:v>0</c:v>
                </c:pt>
                <c:pt idx="40">
                  <c:v>0</c:v>
                </c:pt>
                <c:pt idx="41">
                  <c:v>0</c:v>
                </c:pt>
                <c:pt idx="42">
                  <c:v>0</c:v>
                </c:pt>
                <c:pt idx="43">
                  <c:v>0</c:v>
                </c:pt>
                <c:pt idx="44">
                  <c:v>0</c:v>
                </c:pt>
                <c:pt idx="45">
                  <c:v>0</c:v>
                </c:pt>
                <c:pt idx="46">
                  <c:v>0</c:v>
                </c:pt>
              </c:numCache>
            </c:numRef>
          </c:val>
        </c:ser>
        <c:ser>
          <c:idx val="1"/>
          <c:order val="1"/>
          <c:tx>
            <c:strRef>
              <c:f>HPAT2!$L$29:$L$30</c:f>
              <c:strCache>
                <c:ptCount val="2"/>
                <c:pt idx="0">
                  <c:v>HPAT2/HPAT21</c:v>
                </c:pt>
                <c:pt idx="1">
                  <c:v>Late</c:v>
                </c:pt>
              </c:strCache>
            </c:strRef>
          </c:tx>
          <c:spPr>
            <a:ln w="38100" cap="rnd">
              <a:solidFill>
                <a:srgbClr val="FF0000"/>
              </a:solidFill>
              <a:round/>
            </a:ln>
            <a:effectLst/>
          </c:spPr>
          <c:marker>
            <c:symbol val="none"/>
          </c:marker>
          <c:cat>
            <c:strRef>
              <c:f>HPAT2!$J$31:$J$77</c:f>
              <c:strCache>
                <c:ptCount val="47"/>
                <c:pt idx="0">
                  <c:v>Percent of cells</c:v>
                </c:pt>
                <c:pt idx="1">
                  <c:v>GATA4</c:v>
                </c:pt>
                <c:pt idx="2">
                  <c:v>GRB7</c:v>
                </c:pt>
                <c:pt idx="3">
                  <c:v>GDF3</c:v>
                </c:pt>
                <c:pt idx="4">
                  <c:v>REST</c:v>
                </c:pt>
                <c:pt idx="5">
                  <c:v>LINC-ROR</c:v>
                </c:pt>
                <c:pt idx="6">
                  <c:v>SOX7</c:v>
                </c:pt>
                <c:pt idx="7">
                  <c:v>SOX17</c:v>
                </c:pt>
                <c:pt idx="8">
                  <c:v>PDGFRa</c:v>
                </c:pt>
                <c:pt idx="9">
                  <c:v>RAS</c:v>
                </c:pt>
                <c:pt idx="10">
                  <c:v>BMP4</c:v>
                </c:pt>
                <c:pt idx="11">
                  <c:v>HPAT2</c:v>
                </c:pt>
                <c:pt idx="12">
                  <c:v>HPAT21</c:v>
                </c:pt>
                <c:pt idx="13">
                  <c:v>HPAT15</c:v>
                </c:pt>
                <c:pt idx="14">
                  <c:v>BPTF</c:v>
                </c:pt>
                <c:pt idx="15">
                  <c:v>G9A</c:v>
                </c:pt>
                <c:pt idx="16">
                  <c:v>P300</c:v>
                </c:pt>
                <c:pt idx="17">
                  <c:v>LIN28A</c:v>
                </c:pt>
                <c:pt idx="18">
                  <c:v>DNMT3B</c:v>
                </c:pt>
                <c:pt idx="19">
                  <c:v>SOX2</c:v>
                </c:pt>
                <c:pt idx="20">
                  <c:v>TFCP2L1</c:v>
                </c:pt>
                <c:pt idx="21">
                  <c:v>LAMC1</c:v>
                </c:pt>
                <c:pt idx="22">
                  <c:v>TAF1</c:v>
                </c:pt>
                <c:pt idx="23">
                  <c:v>YAP</c:v>
                </c:pt>
                <c:pt idx="24">
                  <c:v>MCRS1</c:v>
                </c:pt>
                <c:pt idx="25">
                  <c:v>HPAT5</c:v>
                </c:pt>
                <c:pt idx="26">
                  <c:v>HPAT3</c:v>
                </c:pt>
                <c:pt idx="27">
                  <c:v>EED</c:v>
                </c:pt>
                <c:pt idx="28">
                  <c:v>THAP11</c:v>
                </c:pt>
                <c:pt idx="29">
                  <c:v>TET1</c:v>
                </c:pt>
                <c:pt idx="30">
                  <c:v>LEFTY2</c:v>
                </c:pt>
                <c:pt idx="31">
                  <c:v>SALL4</c:v>
                </c:pt>
                <c:pt idx="32">
                  <c:v>FN1</c:v>
                </c:pt>
                <c:pt idx="33">
                  <c:v>CXCR4</c:v>
                </c:pt>
                <c:pt idx="34">
                  <c:v>EpCAM</c:v>
                </c:pt>
                <c:pt idx="35">
                  <c:v>BRG1</c:v>
                </c:pt>
                <c:pt idx="36">
                  <c:v>MAPK1</c:v>
                </c:pt>
                <c:pt idx="37">
                  <c:v>WNT1</c:v>
                </c:pt>
                <c:pt idx="38">
                  <c:v>HPAT4</c:v>
                </c:pt>
                <c:pt idx="39">
                  <c:v>MAPK3</c:v>
                </c:pt>
                <c:pt idx="40">
                  <c:v>NANOG</c:v>
                </c:pt>
                <c:pt idx="41">
                  <c:v>LATS2</c:v>
                </c:pt>
                <c:pt idx="42">
                  <c:v>DPPA3</c:v>
                </c:pt>
                <c:pt idx="43">
                  <c:v>TERT</c:v>
                </c:pt>
                <c:pt idx="44">
                  <c:v>FGFR2</c:v>
                </c:pt>
                <c:pt idx="45">
                  <c:v>ID2</c:v>
                </c:pt>
                <c:pt idx="46">
                  <c:v>CDKN2A</c:v>
                </c:pt>
              </c:strCache>
            </c:strRef>
          </c:cat>
          <c:val>
            <c:numRef>
              <c:f>HPAT2!$L$31:$L$77</c:f>
              <c:numCache>
                <c:formatCode>General</c:formatCode>
                <c:ptCount val="47"/>
                <c:pt idx="0">
                  <c:v>0</c:v>
                </c:pt>
                <c:pt idx="1">
                  <c:v>0</c:v>
                </c:pt>
                <c:pt idx="2">
                  <c:v>0</c:v>
                </c:pt>
                <c:pt idx="3">
                  <c:v>0</c:v>
                </c:pt>
                <c:pt idx="4">
                  <c:v>0</c:v>
                </c:pt>
                <c:pt idx="5">
                  <c:v>0</c:v>
                </c:pt>
                <c:pt idx="6">
                  <c:v>0</c:v>
                </c:pt>
                <c:pt idx="7">
                  <c:v>0</c:v>
                </c:pt>
                <c:pt idx="8">
                  <c:v>0</c:v>
                </c:pt>
                <c:pt idx="9">
                  <c:v>0</c:v>
                </c:pt>
                <c:pt idx="10">
                  <c:v>0</c:v>
                </c:pt>
                <c:pt idx="11">
                  <c:v>100</c:v>
                </c:pt>
                <c:pt idx="12">
                  <c:v>100</c:v>
                </c:pt>
                <c:pt idx="13">
                  <c:v>0</c:v>
                </c:pt>
                <c:pt idx="14">
                  <c:v>85</c:v>
                </c:pt>
                <c:pt idx="15">
                  <c:v>85</c:v>
                </c:pt>
                <c:pt idx="16">
                  <c:v>85</c:v>
                </c:pt>
                <c:pt idx="17">
                  <c:v>95</c:v>
                </c:pt>
                <c:pt idx="18">
                  <c:v>90</c:v>
                </c:pt>
                <c:pt idx="19">
                  <c:v>90</c:v>
                </c:pt>
                <c:pt idx="20">
                  <c:v>90</c:v>
                </c:pt>
                <c:pt idx="21">
                  <c:v>95</c:v>
                </c:pt>
                <c:pt idx="22">
                  <c:v>95</c:v>
                </c:pt>
                <c:pt idx="23">
                  <c:v>95</c:v>
                </c:pt>
                <c:pt idx="24">
                  <c:v>95</c:v>
                </c:pt>
                <c:pt idx="25">
                  <c:v>70</c:v>
                </c:pt>
                <c:pt idx="26">
                  <c:v>65</c:v>
                </c:pt>
                <c:pt idx="27">
                  <c:v>70</c:v>
                </c:pt>
                <c:pt idx="28">
                  <c:v>60</c:v>
                </c:pt>
                <c:pt idx="29">
                  <c:v>55.000000000000007</c:v>
                </c:pt>
                <c:pt idx="30">
                  <c:v>55.000000000000007</c:v>
                </c:pt>
                <c:pt idx="31">
                  <c:v>50</c:v>
                </c:pt>
                <c:pt idx="32">
                  <c:v>40</c:v>
                </c:pt>
                <c:pt idx="33">
                  <c:v>35</c:v>
                </c:pt>
                <c:pt idx="34">
                  <c:v>35</c:v>
                </c:pt>
                <c:pt idx="35">
                  <c:v>35</c:v>
                </c:pt>
                <c:pt idx="36">
                  <c:v>30</c:v>
                </c:pt>
                <c:pt idx="37">
                  <c:v>20</c:v>
                </c:pt>
                <c:pt idx="38">
                  <c:v>5</c:v>
                </c:pt>
                <c:pt idx="39">
                  <c:v>40</c:v>
                </c:pt>
                <c:pt idx="40">
                  <c:v>40</c:v>
                </c:pt>
                <c:pt idx="41">
                  <c:v>35</c:v>
                </c:pt>
                <c:pt idx="42">
                  <c:v>30</c:v>
                </c:pt>
                <c:pt idx="43">
                  <c:v>25</c:v>
                </c:pt>
                <c:pt idx="44">
                  <c:v>25</c:v>
                </c:pt>
                <c:pt idx="45">
                  <c:v>30</c:v>
                </c:pt>
                <c:pt idx="46">
                  <c:v>45</c:v>
                </c:pt>
              </c:numCache>
            </c:numRef>
          </c:val>
        </c:ser>
        <c:dLbls>
          <c:showLegendKey val="0"/>
          <c:showVal val="0"/>
          <c:showCatName val="0"/>
          <c:showSerName val="0"/>
          <c:showPercent val="0"/>
          <c:showBubbleSize val="0"/>
        </c:dLbls>
        <c:axId val="306057376"/>
        <c:axId val="306058944"/>
      </c:radarChart>
      <c:catAx>
        <c:axId val="306057376"/>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mn-lt"/>
                <a:ea typeface="+mn-ea"/>
                <a:cs typeface="+mn-cs"/>
              </a:defRPr>
            </a:pPr>
            <a:endParaRPr lang="en-US"/>
          </a:p>
        </c:txPr>
        <c:crossAx val="306058944"/>
        <c:crosses val="autoZero"/>
        <c:auto val="1"/>
        <c:lblAlgn val="ctr"/>
        <c:lblOffset val="100"/>
        <c:noMultiLvlLbl val="0"/>
      </c:catAx>
      <c:valAx>
        <c:axId val="30605894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1000" b="1" i="0" u="none" strike="noStrike" kern="1200" baseline="0">
                <a:solidFill>
                  <a:sysClr val="windowText" lastClr="000000"/>
                </a:solidFill>
                <a:latin typeface="+mn-lt"/>
                <a:ea typeface="+mn-ea"/>
                <a:cs typeface="+mn-cs"/>
              </a:defRPr>
            </a:pPr>
            <a:endParaRPr lang="en-US"/>
          </a:p>
        </c:txPr>
        <c:crossAx val="306057376"/>
        <c:crosses val="autoZero"/>
        <c:crossBetween val="between"/>
      </c:valAx>
      <c:spPr>
        <a:noFill/>
        <a:ln>
          <a:noFill/>
        </a:ln>
        <a:effectLst/>
      </c:spPr>
    </c:plotArea>
    <c:legend>
      <c:legendPos val="t"/>
      <c:layout/>
      <c:overlay val="0"/>
      <c:spPr>
        <a:noFill/>
        <a:ln>
          <a:noFill/>
        </a:ln>
        <a:effectLst/>
      </c:spPr>
      <c:txPr>
        <a:bodyPr rot="0" spcFirstLastPara="1" vertOverflow="ellipsis" vert="horz" wrap="square" anchor="ctr" anchorCtr="1"/>
        <a:lstStyle/>
        <a:p>
          <a:pPr>
            <a:defRPr sz="1400" b="1" i="0" u="none" strike="noStrike" kern="1200" baseline="0">
              <a:solidFill>
                <a:sysClr val="windowText" lastClr="000000"/>
              </a:solidFill>
              <a:latin typeface="+mn-lt"/>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32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8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8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31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31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 = '1.0' encoding = 'UTF-8' standalone = 'yes'?>
<Relationships xmlns="http://schemas.openxmlformats.org/package/2006/relationships">
   <Relationship Id="rId1" Type="http://schemas.openxmlformats.org/officeDocument/2006/relationships/theme" Target="../theme/theme2.xml"/>
</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BBA0860-CD0F-4111-A88D-97823E48FAA2}" type="datetimeFigureOut">
              <a:rPr lang="en-US" smtClean="0"/>
              <a:t>5/31/2018</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426E606-3D27-4AB1-8873-A0DD79BBB60F}" type="slidenum">
              <a:rPr lang="en-US" smtClean="0"/>
              <a:t>‹#›</a:t>
            </a:fld>
            <a:endParaRPr lang="en-US"/>
          </a:p>
        </p:txBody>
      </p:sp>
    </p:spTree>
    <p:extLst>
      <p:ext uri="{BB962C8B-B14F-4D97-AF65-F5344CB8AC3E}">
        <p14:creationId xmlns:p14="http://schemas.microsoft.com/office/powerpoint/2010/main" val="182111973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10.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11.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2.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3.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4.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5.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6.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7.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8.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9.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8865C0C0-B12A-4BA8-8A83-1D012D019158}" type="datetimeFigureOut">
              <a:rPr lang="en-US" smtClean="0"/>
              <a:t>5/3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42538569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65C0C0-B12A-4BA8-8A83-1D012D019158}" type="datetimeFigureOut">
              <a:rPr lang="en-US" smtClean="0"/>
              <a:t>5/3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413580499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65C0C0-B12A-4BA8-8A83-1D012D019158}" type="datetimeFigureOut">
              <a:rPr lang="en-US" smtClean="0"/>
              <a:t>5/3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33635840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865C0C0-B12A-4BA8-8A83-1D012D019158}" type="datetimeFigureOut">
              <a:rPr lang="en-US" smtClean="0"/>
              <a:t>5/3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272681281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865C0C0-B12A-4BA8-8A83-1D012D019158}" type="datetimeFigureOut">
              <a:rPr lang="en-US" smtClean="0"/>
              <a:t>5/3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22939024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8865C0C0-B12A-4BA8-8A83-1D012D019158}" type="datetimeFigureOut">
              <a:rPr lang="en-US" smtClean="0"/>
              <a:t>5/3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32548812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8865C0C0-B12A-4BA8-8A83-1D012D019158}" type="datetimeFigureOut">
              <a:rPr lang="en-US" smtClean="0"/>
              <a:t>5/31/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17106517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8865C0C0-B12A-4BA8-8A83-1D012D019158}" type="datetimeFigureOut">
              <a:rPr lang="en-US" smtClean="0"/>
              <a:t>5/31/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10012374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865C0C0-B12A-4BA8-8A83-1D012D019158}" type="datetimeFigureOut">
              <a:rPr lang="en-US" smtClean="0"/>
              <a:t>5/31/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25334664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865C0C0-B12A-4BA8-8A83-1D012D019158}" type="datetimeFigureOut">
              <a:rPr lang="en-US" smtClean="0"/>
              <a:t>5/3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28526337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865C0C0-B12A-4BA8-8A83-1D012D019158}" type="datetimeFigureOut">
              <a:rPr lang="en-US" smtClean="0"/>
              <a:t>5/3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CB4C7F-67AB-4CD2-85B5-72AB5B0D54BD}" type="slidenum">
              <a:rPr lang="en-US" smtClean="0"/>
              <a:t>‹#›</a:t>
            </a:fld>
            <a:endParaRPr lang="en-US"/>
          </a:p>
        </p:txBody>
      </p:sp>
    </p:spTree>
    <p:extLst>
      <p:ext uri="{BB962C8B-B14F-4D97-AF65-F5344CB8AC3E}">
        <p14:creationId xmlns:p14="http://schemas.microsoft.com/office/powerpoint/2010/main" val="1379744470"/>
      </p:ext>
    </p:extLst>
  </p:cSld>
  <p:clrMapOvr>
    <a:masterClrMapping/>
  </p:clrMapOvr>
</p:sldLayout>
</file>

<file path=ppt/slideMasters/_rels/slideMaster1.xml.rels><?xml version = '1.0' encoding = 'UTF-8' standalone = 'yes'?>
<Relationships xmlns="http://schemas.openxmlformats.org/package/2006/relationships">
   <Relationship Id="rId1" Type="http://schemas.openxmlformats.org/officeDocument/2006/relationships/slideLayout" Target="../slideLayouts/slideLayout1.xml"/>
   <Relationship Id="rId10" Type="http://schemas.openxmlformats.org/officeDocument/2006/relationships/slideLayout" Target="../slideLayouts/slideLayout10.xml"/>
   <Relationship Id="rId11" Type="http://schemas.openxmlformats.org/officeDocument/2006/relationships/slideLayout" Target="../slideLayouts/slideLayout11.xml"/>
   <Relationship Id="rId12" Type="http://schemas.openxmlformats.org/officeDocument/2006/relationships/theme" Target="../theme/theme1.xml"/>
   <Relationship Id="rId2" Type="http://schemas.openxmlformats.org/officeDocument/2006/relationships/slideLayout" Target="../slideLayouts/slideLayout2.xml"/>
   <Relationship Id="rId3" Type="http://schemas.openxmlformats.org/officeDocument/2006/relationships/slideLayout" Target="../slideLayouts/slideLayout3.xml"/>
   <Relationship Id="rId4" Type="http://schemas.openxmlformats.org/officeDocument/2006/relationships/slideLayout" Target="../slideLayouts/slideLayout4.xml"/>
   <Relationship Id="rId5" Type="http://schemas.openxmlformats.org/officeDocument/2006/relationships/slideLayout" Target="../slideLayouts/slideLayout5.xml"/>
   <Relationship Id="rId6" Type="http://schemas.openxmlformats.org/officeDocument/2006/relationships/slideLayout" Target="../slideLayouts/slideLayout6.xml"/>
   <Relationship Id="rId7" Type="http://schemas.openxmlformats.org/officeDocument/2006/relationships/slideLayout" Target="../slideLayouts/slideLayout7.xml"/>
   <Relationship Id="rId8" Type="http://schemas.openxmlformats.org/officeDocument/2006/relationships/slideLayout" Target="../slideLayouts/slideLayout8.xml"/>
   <Relationship Id="rId9" Type="http://schemas.openxmlformats.org/officeDocument/2006/relationships/slideLayout" Target="../slideLayouts/slideLayout9.xml"/>
</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865C0C0-B12A-4BA8-8A83-1D012D019158}" type="datetimeFigureOut">
              <a:rPr lang="en-US" smtClean="0"/>
              <a:t>5/31/2018</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BCB4C7F-67AB-4CD2-85B5-72AB5B0D54BD}" type="slidenum">
              <a:rPr lang="en-US" smtClean="0"/>
              <a:t>‹#›</a:t>
            </a:fld>
            <a:endParaRPr lang="en-US"/>
          </a:p>
        </p:txBody>
      </p:sp>
    </p:spTree>
    <p:extLst>
      <p:ext uri="{BB962C8B-B14F-4D97-AF65-F5344CB8AC3E}">
        <p14:creationId xmlns:p14="http://schemas.microsoft.com/office/powerpoint/2010/main" val="19808446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 = '1.0' encoding = 'UTF-8' standalone = 'yes'?>
<Relationships xmlns="http://schemas.openxmlformats.org/package/2006/relationships">
   <Relationship Id="rId1" Type="http://schemas.openxmlformats.org/officeDocument/2006/relationships/slideLayout" Target="../slideLayouts/slideLayout7.xml"/>
</Relationships>
</file>

<file path=ppt/slides/_rels/slide2.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image" Target="../media/image1.png"/>
</Relationships>
</file>

<file path=ppt/slides/_rels/slide3.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1.xml"/>
</Relationships>
</file>

<file path=ppt/slides/_rels/slide4.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2.xml"/>
</Relationships>
</file>

<file path=ppt/slides/_rels/slide5.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3.xml"/>
</Relationships>
</file>

<file path=ppt/slides/_rels/slide6.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4.xml"/>
</Relationships>
</file>

<file path=ppt/slides/_rels/slide7.xml.rels><?xml version = '1.0' encoding = 'UTF-8' standalone = 'yes'?>
<Relationships xmlns="http://schemas.openxmlformats.org/package/2006/relationships">
   <Relationship Id="rId1" Type="http://schemas.openxmlformats.org/officeDocument/2006/relationships/slideLayout" Target="../slideLayouts/slideLayout7.xml"/>
   <Relationship Id="rId2" Type="http://schemas.openxmlformats.org/officeDocument/2006/relationships/chart" Target="../charts/chart5.xml"/>
</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232011" y="0"/>
            <a:ext cx="11477767" cy="6868547"/>
          </a:xfrm>
          <a:prstGeom prst="rect">
            <a:avLst/>
          </a:prstGeom>
        </p:spPr>
        <p:txBody>
          <a:bodyPr wrap="square">
            <a:spAutoFit/>
          </a:bodyPr>
          <a:lstStyle/>
          <a:p>
            <a:pPr marL="228600" marR="0" algn="ctr">
              <a:spcBef>
                <a:spcPts val="0"/>
              </a:spcBef>
              <a:spcAft>
                <a:spcPts val="1000"/>
              </a:spcAft>
            </a:pPr>
            <a:r>
              <a:rPr lang="en-US" b="1" dirty="0">
                <a:latin typeface="Arial" panose="020B0604020202020204" pitchFamily="34" charset="0"/>
                <a:ea typeface="Calibri" panose="020F0502020204030204" pitchFamily="34" charset="0"/>
                <a:cs typeface="Arial" panose="020B0604020202020204" pitchFamily="34" charset="0"/>
              </a:rPr>
              <a:t>Supplemental Figure S1.</a:t>
            </a:r>
            <a:r>
              <a:rPr lang="en-US" dirty="0">
                <a:latin typeface="Arial" panose="020B0604020202020204" pitchFamily="34" charset="0"/>
                <a:ea typeface="Calibri" panose="020F0502020204030204" pitchFamily="34" charset="0"/>
                <a:cs typeface="Arial" panose="020B0604020202020204" pitchFamily="34" charset="0"/>
              </a:rPr>
              <a:t> Single-cell gene expression analysis of HPAT </a:t>
            </a:r>
            <a:r>
              <a:rPr lang="en-US" dirty="0" err="1">
                <a:latin typeface="Arial" panose="020B0604020202020204" pitchFamily="34" charset="0"/>
                <a:ea typeface="Calibri" panose="020F0502020204030204" pitchFamily="34" charset="0"/>
                <a:cs typeface="Arial" panose="020B0604020202020204" pitchFamily="34" charset="0"/>
              </a:rPr>
              <a:t>lincRNAs</a:t>
            </a:r>
            <a:r>
              <a:rPr lang="en-US" dirty="0">
                <a:latin typeface="Arial" panose="020B0604020202020204" pitchFamily="34" charset="0"/>
                <a:ea typeface="Calibri" panose="020F0502020204030204" pitchFamily="34" charset="0"/>
                <a:cs typeface="Arial" panose="020B0604020202020204" pitchFamily="34" charset="0"/>
              </a:rPr>
              <a:t> captures the entire spectrum of a cellular diversity during human blastocyst differentiation.</a:t>
            </a:r>
            <a:r>
              <a:rPr lang="en-US" b="1" dirty="0">
                <a:latin typeface="Arial" panose="020B0604020202020204" pitchFamily="34" charset="0"/>
                <a:ea typeface="Calibri" panose="020F0502020204030204" pitchFamily="34" charset="0"/>
                <a:cs typeface="Arial" panose="020B0604020202020204" pitchFamily="34" charset="0"/>
              </a:rPr>
              <a:t> </a:t>
            </a:r>
            <a:endParaRPr lang="en-US" dirty="0">
              <a:latin typeface="Arial" panose="020B0604020202020204" pitchFamily="34" charset="0"/>
              <a:ea typeface="Calibri" panose="020F0502020204030204" pitchFamily="34" charset="0"/>
              <a:cs typeface="Arial" panose="020B0604020202020204" pitchFamily="34" charset="0"/>
            </a:endParaRPr>
          </a:p>
          <a:p>
            <a:pPr marL="342900" marR="0" lvl="0" indent="-342900" algn="ctr">
              <a:spcBef>
                <a:spcPts val="0"/>
              </a:spcBef>
              <a:spcAft>
                <a:spcPts val="0"/>
              </a:spcAft>
              <a:buFont typeface="Helvetica" panose="020B0604020202020204" pitchFamily="34" charset="0"/>
              <a:buAutoNum type="alphaUcParenBoth"/>
            </a:pPr>
            <a:r>
              <a:rPr lang="en-US" dirty="0">
                <a:latin typeface="Arial" panose="020B0604020202020204" pitchFamily="34" charset="0"/>
                <a:ea typeface="Calibri" panose="020F0502020204030204" pitchFamily="34" charset="0"/>
                <a:cs typeface="Arial" panose="020B0604020202020204" pitchFamily="34" charset="0"/>
              </a:rPr>
              <a:t>A high complexity expression matrix of 89 genes expression of which were measured in 241 individual human blastocyst cells. </a:t>
            </a:r>
          </a:p>
          <a:p>
            <a:pPr marL="342900" marR="0" lvl="0" indent="-342900" algn="ctr">
              <a:spcBef>
                <a:spcPts val="0"/>
              </a:spcBef>
              <a:spcAft>
                <a:spcPts val="0"/>
              </a:spcAft>
              <a:buFont typeface="Helvetica" panose="020B0604020202020204" pitchFamily="34" charset="0"/>
              <a:buAutoNum type="alphaUcParenBoth"/>
            </a:pPr>
            <a:r>
              <a:rPr lang="en-US" dirty="0">
                <a:latin typeface="Arial" panose="020B0604020202020204" pitchFamily="34" charset="0"/>
                <a:ea typeface="Calibri" panose="020F0502020204030204" pitchFamily="34" charset="0"/>
                <a:cs typeface="Arial" panose="020B0604020202020204" pitchFamily="34" charset="0"/>
              </a:rPr>
              <a:t>Expression profiles of the </a:t>
            </a:r>
            <a:r>
              <a:rPr lang="en-US" i="1" dirty="0">
                <a:latin typeface="Arial" panose="020B0604020202020204" pitchFamily="34" charset="0"/>
                <a:ea typeface="Calibri" panose="020F0502020204030204" pitchFamily="34" charset="0"/>
                <a:cs typeface="Arial" panose="020B0604020202020204" pitchFamily="34" charset="0"/>
              </a:rPr>
              <a:t>HPAT21; HPAT15</a:t>
            </a:r>
            <a:r>
              <a:rPr lang="en-US" dirty="0">
                <a:latin typeface="Arial" panose="020B0604020202020204" pitchFamily="34" charset="0"/>
                <a:ea typeface="Calibri" panose="020F0502020204030204" pitchFamily="34" charset="0"/>
                <a:cs typeface="Arial" panose="020B0604020202020204" pitchFamily="34" charset="0"/>
              </a:rPr>
              <a:t>; and </a:t>
            </a:r>
            <a:r>
              <a:rPr lang="en-US" i="1" dirty="0">
                <a:latin typeface="Arial" panose="020B0604020202020204" pitchFamily="34" charset="0"/>
                <a:ea typeface="Calibri" panose="020F0502020204030204" pitchFamily="34" charset="0"/>
                <a:cs typeface="Arial" panose="020B0604020202020204" pitchFamily="34" charset="0"/>
              </a:rPr>
              <a:t>HAPT2</a:t>
            </a:r>
            <a:r>
              <a:rPr lang="en-US" dirty="0">
                <a:latin typeface="Arial" panose="020B0604020202020204" pitchFamily="34" charset="0"/>
                <a:ea typeface="Calibri" panose="020F0502020204030204" pitchFamily="34" charset="0"/>
                <a:cs typeface="Arial" panose="020B0604020202020204" pitchFamily="34" charset="0"/>
              </a:rPr>
              <a:t> </a:t>
            </a:r>
            <a:r>
              <a:rPr lang="en-US" dirty="0" err="1">
                <a:latin typeface="Arial" panose="020B0604020202020204" pitchFamily="34" charset="0"/>
                <a:ea typeface="Calibri" panose="020F0502020204030204" pitchFamily="34" charset="0"/>
                <a:cs typeface="Arial" panose="020B0604020202020204" pitchFamily="34" charset="0"/>
              </a:rPr>
              <a:t>lincRNAs</a:t>
            </a:r>
            <a:r>
              <a:rPr lang="en-US" dirty="0">
                <a:latin typeface="Arial" panose="020B0604020202020204" pitchFamily="34" charset="0"/>
                <a:ea typeface="Calibri" panose="020F0502020204030204" pitchFamily="34" charset="0"/>
                <a:cs typeface="Arial" panose="020B0604020202020204" pitchFamily="34" charset="0"/>
              </a:rPr>
              <a:t> define major sub-populations of human blastocyst cells. A color-coded stacked area plot depicts relative expression values of designated HPAT </a:t>
            </a:r>
            <a:r>
              <a:rPr lang="en-US" dirty="0" err="1">
                <a:latin typeface="Arial" panose="020B0604020202020204" pitchFamily="34" charset="0"/>
                <a:ea typeface="Calibri" panose="020F0502020204030204" pitchFamily="34" charset="0"/>
                <a:cs typeface="Arial" panose="020B0604020202020204" pitchFamily="34" charset="0"/>
              </a:rPr>
              <a:t>lincRNAs</a:t>
            </a:r>
            <a:r>
              <a:rPr lang="en-US" dirty="0">
                <a:latin typeface="Arial" panose="020B0604020202020204" pitchFamily="34" charset="0"/>
                <a:ea typeface="Calibri" panose="020F0502020204030204" pitchFamily="34" charset="0"/>
                <a:cs typeface="Arial" panose="020B0604020202020204" pitchFamily="34" charset="0"/>
              </a:rPr>
              <a:t> in each individual blastocyst cell. Note that there is only one cell manifesting </a:t>
            </a:r>
            <a:r>
              <a:rPr lang="en-US" i="1" dirty="0">
                <a:latin typeface="Arial" panose="020B0604020202020204" pitchFamily="34" charset="0"/>
                <a:ea typeface="Calibri" panose="020F0502020204030204" pitchFamily="34" charset="0"/>
                <a:cs typeface="Arial" panose="020B0604020202020204" pitchFamily="34" charset="0"/>
              </a:rPr>
              <a:t>HPAT21/HPAT2/HPAT15</a:t>
            </a:r>
            <a:r>
              <a:rPr lang="en-US" dirty="0">
                <a:latin typeface="Arial" panose="020B0604020202020204" pitchFamily="34" charset="0"/>
                <a:ea typeface="Calibri" panose="020F0502020204030204" pitchFamily="34" charset="0"/>
                <a:cs typeface="Arial" panose="020B0604020202020204" pitchFamily="34" charset="0"/>
              </a:rPr>
              <a:t>-null phenotype. </a:t>
            </a:r>
          </a:p>
          <a:p>
            <a:pPr marL="342900" marR="0" lvl="0" indent="-342900" algn="ctr">
              <a:spcBef>
                <a:spcPts val="0"/>
              </a:spcBef>
              <a:spcAft>
                <a:spcPts val="0"/>
              </a:spcAft>
              <a:buFont typeface="Helvetica" panose="020B0604020202020204" pitchFamily="34" charset="0"/>
              <a:buAutoNum type="alphaUcParenBoth"/>
            </a:pPr>
            <a:r>
              <a:rPr lang="en-US" dirty="0">
                <a:latin typeface="Arial" panose="020B0604020202020204" pitchFamily="34" charset="0"/>
                <a:ea typeface="Calibri" panose="020F0502020204030204" pitchFamily="34" charset="0"/>
                <a:cs typeface="Arial" panose="020B0604020202020204" pitchFamily="34" charset="0"/>
              </a:rPr>
              <a:t>Expression patterns of HPAT </a:t>
            </a:r>
            <a:r>
              <a:rPr lang="en-US" dirty="0" err="1">
                <a:latin typeface="Arial" panose="020B0604020202020204" pitchFamily="34" charset="0"/>
                <a:ea typeface="Calibri" panose="020F0502020204030204" pitchFamily="34" charset="0"/>
                <a:cs typeface="Arial" panose="020B0604020202020204" pitchFamily="34" charset="0"/>
              </a:rPr>
              <a:t>lincRNAs</a:t>
            </a:r>
            <a:r>
              <a:rPr lang="en-US" dirty="0">
                <a:latin typeface="Arial" panose="020B0604020202020204" pitchFamily="34" charset="0"/>
                <a:ea typeface="Calibri" panose="020F0502020204030204" pitchFamily="34" charset="0"/>
                <a:cs typeface="Arial" panose="020B0604020202020204" pitchFamily="34" charset="0"/>
              </a:rPr>
              <a:t> in distinct sub-populations of human blastocyst cells. Stars designate sub-populations harboring the significantly enriched numbers of cells expressing defined genetic markers. P values were estimated using two-tailed Fisher’s exact test and reported in the Supplemental Table S2. </a:t>
            </a:r>
          </a:p>
          <a:p>
            <a:pPr marL="342900" marR="0" lvl="0" indent="-342900" algn="ctr">
              <a:spcBef>
                <a:spcPts val="0"/>
              </a:spcBef>
              <a:spcAft>
                <a:spcPts val="0"/>
              </a:spcAft>
              <a:buFont typeface="Helvetica" panose="020B0604020202020204" pitchFamily="34" charset="0"/>
              <a:buAutoNum type="alphaUcParenBoth"/>
            </a:pPr>
            <a:r>
              <a:rPr lang="en-US" dirty="0">
                <a:latin typeface="Arial" panose="020B0604020202020204" pitchFamily="34" charset="0"/>
                <a:ea typeface="Calibri" panose="020F0502020204030204" pitchFamily="34" charset="0"/>
                <a:cs typeface="Arial" panose="020B0604020202020204" pitchFamily="34" charset="0"/>
              </a:rPr>
              <a:t>Expression patterns of pluripotency regulatory genes in distinct sub-populations of human blastocyst cells. Stars designate sub-populations harboring the significantly enriched numbers of cells expressing defined genetic markers.</a:t>
            </a:r>
          </a:p>
          <a:p>
            <a:pPr marL="342900" marR="0" lvl="0" indent="-342900" algn="ctr">
              <a:spcBef>
                <a:spcPts val="0"/>
              </a:spcBef>
              <a:spcAft>
                <a:spcPts val="0"/>
              </a:spcAft>
              <a:buFont typeface="Helvetica" panose="020B0604020202020204" pitchFamily="34" charset="0"/>
              <a:buAutoNum type="alphaUcParenBoth"/>
            </a:pPr>
            <a:r>
              <a:rPr lang="en-US" dirty="0">
                <a:latin typeface="Arial" panose="020B0604020202020204" pitchFamily="34" charset="0"/>
                <a:ea typeface="Calibri" panose="020F0502020204030204" pitchFamily="34" charset="0"/>
                <a:cs typeface="Arial" panose="020B0604020202020204" pitchFamily="34" charset="0"/>
              </a:rPr>
              <a:t>Cell identity gene expression signature (GES) of the </a:t>
            </a:r>
            <a:r>
              <a:rPr lang="en-US" i="1" dirty="0">
                <a:latin typeface="Arial" panose="020B0604020202020204" pitchFamily="34" charset="0"/>
                <a:ea typeface="Calibri" panose="020F0502020204030204" pitchFamily="34" charset="0"/>
                <a:cs typeface="Arial" panose="020B0604020202020204" pitchFamily="34" charset="0"/>
              </a:rPr>
              <a:t>HPAT21 </a:t>
            </a:r>
            <a:r>
              <a:rPr lang="en-US" i="1" baseline="30000" dirty="0">
                <a:latin typeface="Arial" panose="020B0604020202020204" pitchFamily="34" charset="0"/>
                <a:ea typeface="Calibri" panose="020F0502020204030204" pitchFamily="34" charset="0"/>
                <a:cs typeface="Arial" panose="020B0604020202020204" pitchFamily="34" charset="0"/>
              </a:rPr>
              <a:t>(+)</a:t>
            </a:r>
            <a:r>
              <a:rPr lang="en-US" i="1" dirty="0">
                <a:latin typeface="Arial" panose="020B0604020202020204" pitchFamily="34" charset="0"/>
                <a:ea typeface="Calibri" panose="020F0502020204030204" pitchFamily="34" charset="0"/>
                <a:cs typeface="Arial" panose="020B0604020202020204" pitchFamily="34" charset="0"/>
              </a:rPr>
              <a:t> HPAT15 </a:t>
            </a:r>
            <a:r>
              <a:rPr lang="en-US" i="1" baseline="30000" dirty="0">
                <a:latin typeface="Arial" panose="020B0604020202020204" pitchFamily="34" charset="0"/>
                <a:ea typeface="Calibri" panose="020F0502020204030204" pitchFamily="34" charset="0"/>
                <a:cs typeface="Arial" panose="020B0604020202020204" pitchFamily="34" charset="0"/>
              </a:rPr>
              <a:t>(+)</a:t>
            </a:r>
            <a:r>
              <a:rPr lang="en-US" i="1" dirty="0">
                <a:latin typeface="Arial" panose="020B0604020202020204" pitchFamily="34" charset="0"/>
                <a:ea typeface="Calibri" panose="020F0502020204030204" pitchFamily="34" charset="0"/>
                <a:cs typeface="Arial" panose="020B0604020202020204" pitchFamily="34" charset="0"/>
              </a:rPr>
              <a:t> HPAT2 </a:t>
            </a:r>
            <a:r>
              <a:rPr lang="en-US" i="1" baseline="30000" dirty="0">
                <a:latin typeface="Arial" panose="020B0604020202020204" pitchFamily="34" charset="0"/>
                <a:ea typeface="Calibri" panose="020F0502020204030204" pitchFamily="34" charset="0"/>
                <a:cs typeface="Arial" panose="020B0604020202020204" pitchFamily="34" charset="0"/>
              </a:rPr>
              <a:t>(+)</a:t>
            </a:r>
            <a:r>
              <a:rPr lang="en-US" dirty="0">
                <a:latin typeface="Arial" panose="020B0604020202020204" pitchFamily="34" charset="0"/>
                <a:ea typeface="Calibri" panose="020F0502020204030204" pitchFamily="34" charset="0"/>
                <a:cs typeface="Arial" panose="020B0604020202020204" pitchFamily="34" charset="0"/>
              </a:rPr>
              <a:t> cells recovered from human blastocysts. Stars designate transcripts encoded by the genomic loci that were implicated in the regulation of the human pluripotency state. Positions of colored lines’ heights inside the circle reflect the percentage of cells within a population that express transcripts encoded by the corresponding genes names of which are listed on the circle. </a:t>
            </a:r>
          </a:p>
          <a:p>
            <a:pPr marL="342900" marR="0" lvl="0" indent="-342900" algn="ctr">
              <a:spcBef>
                <a:spcPts val="0"/>
              </a:spcBef>
              <a:spcAft>
                <a:spcPts val="800"/>
              </a:spcAft>
              <a:buFont typeface="Helvetica" panose="020B0604020202020204" pitchFamily="34" charset="0"/>
              <a:buAutoNum type="alphaUcParenBoth"/>
            </a:pPr>
            <a:r>
              <a:rPr lang="en-US" dirty="0">
                <a:latin typeface="Arial" panose="020B0604020202020204" pitchFamily="34" charset="0"/>
                <a:ea typeface="Calibri" panose="020F0502020204030204" pitchFamily="34" charset="0"/>
                <a:cs typeface="Arial" panose="020B0604020202020204" pitchFamily="34" charset="0"/>
              </a:rPr>
              <a:t>Cell identity gene expression signature (GES) of the </a:t>
            </a:r>
            <a:r>
              <a:rPr lang="en-US" i="1" dirty="0">
                <a:latin typeface="Arial" panose="020B0604020202020204" pitchFamily="34" charset="0"/>
                <a:ea typeface="Calibri" panose="020F0502020204030204" pitchFamily="34" charset="0"/>
                <a:cs typeface="Arial" panose="020B0604020202020204" pitchFamily="34" charset="0"/>
              </a:rPr>
              <a:t>HPAT21 </a:t>
            </a:r>
            <a:r>
              <a:rPr lang="en-US" i="1" baseline="30000" dirty="0">
                <a:latin typeface="Arial" panose="020B0604020202020204" pitchFamily="34" charset="0"/>
                <a:ea typeface="Calibri" panose="020F0502020204030204" pitchFamily="34" charset="0"/>
                <a:cs typeface="Arial" panose="020B0604020202020204" pitchFamily="34" charset="0"/>
              </a:rPr>
              <a:t>(+)</a:t>
            </a:r>
            <a:r>
              <a:rPr lang="en-US" i="1" dirty="0">
                <a:latin typeface="Arial" panose="020B0604020202020204" pitchFamily="34" charset="0"/>
                <a:ea typeface="Calibri" panose="020F0502020204030204" pitchFamily="34" charset="0"/>
                <a:cs typeface="Arial" panose="020B0604020202020204" pitchFamily="34" charset="0"/>
              </a:rPr>
              <a:t> HPAT15 </a:t>
            </a:r>
            <a:r>
              <a:rPr lang="en-US" i="1" baseline="30000" dirty="0">
                <a:latin typeface="Arial" panose="020B0604020202020204" pitchFamily="34" charset="0"/>
                <a:ea typeface="Calibri" panose="020F0502020204030204" pitchFamily="34" charset="0"/>
                <a:cs typeface="Arial" panose="020B0604020202020204" pitchFamily="34" charset="0"/>
              </a:rPr>
              <a:t>(-)</a:t>
            </a:r>
            <a:r>
              <a:rPr lang="en-US" i="1" dirty="0">
                <a:latin typeface="Arial" panose="020B0604020202020204" pitchFamily="34" charset="0"/>
                <a:ea typeface="Calibri" panose="020F0502020204030204" pitchFamily="34" charset="0"/>
                <a:cs typeface="Arial" panose="020B0604020202020204" pitchFamily="34" charset="0"/>
              </a:rPr>
              <a:t> HPAT2 </a:t>
            </a:r>
            <a:r>
              <a:rPr lang="en-US" i="1" baseline="30000" dirty="0">
                <a:latin typeface="Arial" panose="020B0604020202020204" pitchFamily="34" charset="0"/>
                <a:ea typeface="Calibri" panose="020F0502020204030204" pitchFamily="34" charset="0"/>
                <a:cs typeface="Arial" panose="020B0604020202020204" pitchFamily="34" charset="0"/>
              </a:rPr>
              <a:t>(+)</a:t>
            </a:r>
            <a:r>
              <a:rPr lang="en-US" dirty="0">
                <a:latin typeface="Arial" panose="020B0604020202020204" pitchFamily="34" charset="0"/>
                <a:ea typeface="Calibri" panose="020F0502020204030204" pitchFamily="34" charset="0"/>
                <a:cs typeface="Arial" panose="020B0604020202020204" pitchFamily="34" charset="0"/>
              </a:rPr>
              <a:t> cells recovered from human blastocysts. Stars designate transcripts encoded by the genomic loci that were implicated in the regulation of the human pluripotency state. Positions of colored lines’ heights inside the circle depict the percentage of cells within a population that express transcripts encoded by the corresponding genes listed on the circle</a:t>
            </a:r>
            <a:r>
              <a:rPr lang="en-US" dirty="0">
                <a:latin typeface="Arial" panose="020B0604020202020204" pitchFamily="34" charset="0"/>
                <a:ea typeface="Calibri" panose="020F0502020204030204" pitchFamily="34" charset="0"/>
                <a:cs typeface="Times New Roman" panose="02020603050405020304" pitchFamily="18" charset="0"/>
              </a:rPr>
              <a:t>. </a:t>
            </a:r>
            <a:endParaRPr lang="en-US"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66197636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762" y="428"/>
            <a:ext cx="12190476" cy="6857143"/>
          </a:xfrm>
          <a:prstGeom prst="rect">
            <a:avLst/>
          </a:prstGeom>
        </p:spPr>
      </p:pic>
      <p:sp>
        <p:nvSpPr>
          <p:cNvPr id="3" name="TextBox 2"/>
          <p:cNvSpPr txBox="1"/>
          <p:nvPr/>
        </p:nvSpPr>
        <p:spPr>
          <a:xfrm>
            <a:off x="0" y="0"/>
            <a:ext cx="351378" cy="369332"/>
          </a:xfrm>
          <a:prstGeom prst="rect">
            <a:avLst/>
          </a:prstGeom>
          <a:noFill/>
        </p:spPr>
        <p:txBody>
          <a:bodyPr wrap="none" rtlCol="0">
            <a:spAutoFit/>
          </a:bodyPr>
          <a:lstStyle/>
          <a:p>
            <a:r>
              <a:rPr lang="en-US" b="1" dirty="0" smtClean="0">
                <a:latin typeface="Arial" panose="020B0604020202020204" pitchFamily="34" charset="0"/>
                <a:cs typeface="Arial" panose="020B0604020202020204" pitchFamily="34" charset="0"/>
              </a:rPr>
              <a:t>A</a:t>
            </a:r>
            <a:endParaRPr lang="en-US" b="1" dirty="0">
              <a:latin typeface="Arial" panose="020B0604020202020204" pitchFamily="34" charset="0"/>
              <a:cs typeface="Arial" panose="020B0604020202020204" pitchFamily="34" charset="0"/>
            </a:endParaRPr>
          </a:p>
        </p:txBody>
      </p:sp>
      <p:sp>
        <p:nvSpPr>
          <p:cNvPr id="4" name="TextBox 3"/>
          <p:cNvSpPr txBox="1"/>
          <p:nvPr/>
        </p:nvSpPr>
        <p:spPr>
          <a:xfrm rot="16200000" flipH="1">
            <a:off x="699109" y="4243352"/>
            <a:ext cx="1404355" cy="369332"/>
          </a:xfrm>
          <a:prstGeom prst="rect">
            <a:avLst/>
          </a:prstGeom>
          <a:noFill/>
        </p:spPr>
        <p:txBody>
          <a:bodyPr wrap="square" rtlCol="0">
            <a:spAutoFit/>
          </a:bodyPr>
          <a:lstStyle/>
          <a:p>
            <a:r>
              <a:rPr lang="en-US" b="1" dirty="0" smtClean="0"/>
              <a:t>EXPRESSION</a:t>
            </a:r>
            <a:endParaRPr lang="en-US" b="1" dirty="0"/>
          </a:p>
        </p:txBody>
      </p:sp>
      <p:sp>
        <p:nvSpPr>
          <p:cNvPr id="5" name="TextBox 4"/>
          <p:cNvSpPr txBox="1"/>
          <p:nvPr/>
        </p:nvSpPr>
        <p:spPr>
          <a:xfrm rot="18524510" flipH="1">
            <a:off x="9329606" y="4243353"/>
            <a:ext cx="878559" cy="369332"/>
          </a:xfrm>
          <a:prstGeom prst="rect">
            <a:avLst/>
          </a:prstGeom>
          <a:noFill/>
        </p:spPr>
        <p:txBody>
          <a:bodyPr wrap="square" rtlCol="0">
            <a:spAutoFit/>
          </a:bodyPr>
          <a:lstStyle/>
          <a:p>
            <a:r>
              <a:rPr lang="en-US" b="1" dirty="0" smtClean="0"/>
              <a:t>GENES</a:t>
            </a:r>
            <a:endParaRPr lang="en-US" b="1" dirty="0"/>
          </a:p>
        </p:txBody>
      </p:sp>
      <p:sp>
        <p:nvSpPr>
          <p:cNvPr id="7" name="TextBox 6"/>
          <p:cNvSpPr txBox="1"/>
          <p:nvPr/>
        </p:nvSpPr>
        <p:spPr>
          <a:xfrm>
            <a:off x="2757268" y="369332"/>
            <a:ext cx="6802295" cy="707886"/>
          </a:xfrm>
          <a:prstGeom prst="rect">
            <a:avLst/>
          </a:prstGeom>
          <a:solidFill>
            <a:schemeClr val="bg1"/>
          </a:solidFill>
        </p:spPr>
        <p:txBody>
          <a:bodyPr wrap="square" rtlCol="0">
            <a:spAutoFit/>
          </a:bodyPr>
          <a:lstStyle/>
          <a:p>
            <a:pPr algn="ctr"/>
            <a:r>
              <a:rPr lang="en-US" sz="2000" b="1" dirty="0" smtClean="0"/>
              <a:t>HIGH-COMPLEXITY GENE EXPRESSION MATRIX OF 241 INDIVIDUAL HUMAN BLASTOCYST CELLS</a:t>
            </a:r>
            <a:endParaRPr lang="en-US" sz="2000" b="1" dirty="0"/>
          </a:p>
        </p:txBody>
      </p:sp>
    </p:spTree>
    <p:extLst>
      <p:ext uri="{BB962C8B-B14F-4D97-AF65-F5344CB8AC3E}">
        <p14:creationId xmlns:p14="http://schemas.microsoft.com/office/powerpoint/2010/main" val="1593690015"/>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noGrp="1"/>
          </p:cNvGraphicFramePr>
          <p:nvPr>
            <p:extLst>
              <p:ext uri="{D42A27DB-BD31-4B8C-83A1-F6EECF244321}">
                <p14:modId xmlns:p14="http://schemas.microsoft.com/office/powerpoint/2010/main" val="582799346"/>
              </p:ext>
            </p:extLst>
          </p:nvPr>
        </p:nvGraphicFramePr>
        <p:xfrm>
          <a:off x="1764082" y="284445"/>
          <a:ext cx="8663836" cy="6289110"/>
        </p:xfrm>
        <a:graphic>
          <a:graphicData uri="http://schemas.openxmlformats.org/drawingml/2006/chart">
            <c:chart xmlns:c="http://schemas.openxmlformats.org/drawingml/2006/chart" r:id="rId2"/>
          </a:graphicData>
        </a:graphic>
      </p:graphicFrame>
      <p:sp>
        <p:nvSpPr>
          <p:cNvPr id="3" name="TextBox 2"/>
          <p:cNvSpPr txBox="1"/>
          <p:nvPr/>
        </p:nvSpPr>
        <p:spPr>
          <a:xfrm>
            <a:off x="0" y="0"/>
            <a:ext cx="351378"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3510106470"/>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noGrp="1"/>
          </p:cNvGraphicFramePr>
          <p:nvPr>
            <p:extLst>
              <p:ext uri="{D42A27DB-BD31-4B8C-83A1-F6EECF244321}">
                <p14:modId xmlns:p14="http://schemas.microsoft.com/office/powerpoint/2010/main" val="2140625703"/>
              </p:ext>
            </p:extLst>
          </p:nvPr>
        </p:nvGraphicFramePr>
        <p:xfrm>
          <a:off x="1764082" y="284445"/>
          <a:ext cx="8663836" cy="6289110"/>
        </p:xfrm>
        <a:graphic>
          <a:graphicData uri="http://schemas.openxmlformats.org/drawingml/2006/chart">
            <c:chart xmlns:c="http://schemas.openxmlformats.org/drawingml/2006/chart" r:id="rId2"/>
          </a:graphicData>
        </a:graphic>
      </p:graphicFrame>
      <p:sp>
        <p:nvSpPr>
          <p:cNvPr id="3" name="5-Point Star 2"/>
          <p:cNvSpPr/>
          <p:nvPr/>
        </p:nvSpPr>
        <p:spPr>
          <a:xfrm>
            <a:off x="7578868" y="3572564"/>
            <a:ext cx="91440" cy="91440"/>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4" name="5-Point Star 3"/>
          <p:cNvSpPr/>
          <p:nvPr/>
        </p:nvSpPr>
        <p:spPr>
          <a:xfrm>
            <a:off x="4890259" y="2644516"/>
            <a:ext cx="91440" cy="91440"/>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5" name="5-Point Star 4"/>
          <p:cNvSpPr/>
          <p:nvPr/>
        </p:nvSpPr>
        <p:spPr>
          <a:xfrm>
            <a:off x="4019077" y="1072330"/>
            <a:ext cx="91440" cy="91440"/>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6" name="5-Point Star 5"/>
          <p:cNvSpPr/>
          <p:nvPr/>
        </p:nvSpPr>
        <p:spPr>
          <a:xfrm>
            <a:off x="3736835" y="1072330"/>
            <a:ext cx="91440" cy="91440"/>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7" name="5-Point Star 6"/>
          <p:cNvSpPr/>
          <p:nvPr/>
        </p:nvSpPr>
        <p:spPr>
          <a:xfrm>
            <a:off x="3550127" y="2974337"/>
            <a:ext cx="91440" cy="91440"/>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8" name="5-Point Star 7"/>
          <p:cNvSpPr/>
          <p:nvPr/>
        </p:nvSpPr>
        <p:spPr>
          <a:xfrm>
            <a:off x="4551340" y="4953262"/>
            <a:ext cx="91440" cy="91440"/>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9" name="5-Point Star 8"/>
          <p:cNvSpPr/>
          <p:nvPr/>
        </p:nvSpPr>
        <p:spPr>
          <a:xfrm>
            <a:off x="6421083" y="5212571"/>
            <a:ext cx="91440" cy="91440"/>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0" name="5-Point Star 9"/>
          <p:cNvSpPr/>
          <p:nvPr/>
        </p:nvSpPr>
        <p:spPr>
          <a:xfrm>
            <a:off x="8031519" y="5012437"/>
            <a:ext cx="91440" cy="91440"/>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1" name="TextBox 10"/>
          <p:cNvSpPr txBox="1"/>
          <p:nvPr/>
        </p:nvSpPr>
        <p:spPr>
          <a:xfrm flipH="1">
            <a:off x="0" y="0"/>
            <a:ext cx="35006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C</a:t>
            </a:r>
          </a:p>
        </p:txBody>
      </p:sp>
    </p:spTree>
    <p:extLst>
      <p:ext uri="{BB962C8B-B14F-4D97-AF65-F5344CB8AC3E}">
        <p14:creationId xmlns:p14="http://schemas.microsoft.com/office/powerpoint/2010/main" val="15884833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p:cNvGraphicFramePr>
            <a:graphicFrameLocks noGrp="1"/>
          </p:cNvGraphicFramePr>
          <p:nvPr>
            <p:extLst>
              <p:ext uri="{D42A27DB-BD31-4B8C-83A1-F6EECF244321}">
                <p14:modId xmlns:p14="http://schemas.microsoft.com/office/powerpoint/2010/main" val="3440703208"/>
              </p:ext>
            </p:extLst>
          </p:nvPr>
        </p:nvGraphicFramePr>
        <p:xfrm>
          <a:off x="1764082" y="284445"/>
          <a:ext cx="8663836" cy="6289110"/>
        </p:xfrm>
        <a:graphic>
          <a:graphicData uri="http://schemas.openxmlformats.org/drawingml/2006/chart">
            <c:chart xmlns:c="http://schemas.openxmlformats.org/drawingml/2006/chart" r:id="rId2"/>
          </a:graphicData>
        </a:graphic>
      </p:graphicFrame>
      <p:sp>
        <p:nvSpPr>
          <p:cNvPr id="3" name="TextBox 2"/>
          <p:cNvSpPr txBox="1"/>
          <p:nvPr/>
        </p:nvSpPr>
        <p:spPr>
          <a:xfrm flipH="1">
            <a:off x="0" y="0"/>
            <a:ext cx="350066"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D</a:t>
            </a:r>
          </a:p>
        </p:txBody>
      </p:sp>
      <p:sp>
        <p:nvSpPr>
          <p:cNvPr id="4" name="5-Point Star 3"/>
          <p:cNvSpPr/>
          <p:nvPr/>
        </p:nvSpPr>
        <p:spPr>
          <a:xfrm>
            <a:off x="3294311" y="1315592"/>
            <a:ext cx="91440" cy="91440"/>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5" name="5-Point Star 4"/>
          <p:cNvSpPr/>
          <p:nvPr/>
        </p:nvSpPr>
        <p:spPr>
          <a:xfrm>
            <a:off x="4072233" y="3894703"/>
            <a:ext cx="91440" cy="91440"/>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6" name="5-Point Star 5"/>
          <p:cNvSpPr/>
          <p:nvPr/>
        </p:nvSpPr>
        <p:spPr>
          <a:xfrm>
            <a:off x="4835667" y="4398935"/>
            <a:ext cx="91440" cy="91440"/>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7" name="5-Point Star 6"/>
          <p:cNvSpPr/>
          <p:nvPr/>
        </p:nvSpPr>
        <p:spPr>
          <a:xfrm>
            <a:off x="5628076" y="2225005"/>
            <a:ext cx="91440" cy="91440"/>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8" name="5-Point Star 7"/>
          <p:cNvSpPr/>
          <p:nvPr/>
        </p:nvSpPr>
        <p:spPr>
          <a:xfrm>
            <a:off x="7169435" y="1416219"/>
            <a:ext cx="91440" cy="91440"/>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9" name="5-Point Star 8"/>
          <p:cNvSpPr/>
          <p:nvPr/>
        </p:nvSpPr>
        <p:spPr>
          <a:xfrm>
            <a:off x="6415555" y="4490375"/>
            <a:ext cx="91440" cy="91440"/>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0" name="5-Point Star 9"/>
          <p:cNvSpPr/>
          <p:nvPr/>
        </p:nvSpPr>
        <p:spPr>
          <a:xfrm>
            <a:off x="8003208" y="3862316"/>
            <a:ext cx="91440" cy="91440"/>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1" name="5-Point Star 10"/>
          <p:cNvSpPr/>
          <p:nvPr/>
        </p:nvSpPr>
        <p:spPr>
          <a:xfrm>
            <a:off x="8750856" y="1610273"/>
            <a:ext cx="91440" cy="91440"/>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2" name="5-Point Star 11"/>
          <p:cNvSpPr/>
          <p:nvPr/>
        </p:nvSpPr>
        <p:spPr>
          <a:xfrm>
            <a:off x="9533573" y="1710744"/>
            <a:ext cx="91440" cy="91440"/>
          </a:xfrm>
          <a:prstGeom prst="star5">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Tree>
    <p:extLst>
      <p:ext uri="{BB962C8B-B14F-4D97-AF65-F5344CB8AC3E}">
        <p14:creationId xmlns:p14="http://schemas.microsoft.com/office/powerpoint/2010/main" val="4169563740"/>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Chart 2"/>
          <p:cNvGraphicFramePr>
            <a:graphicFrameLocks noGrp="1"/>
          </p:cNvGraphicFramePr>
          <p:nvPr>
            <p:extLst>
              <p:ext uri="{D42A27DB-BD31-4B8C-83A1-F6EECF244321}">
                <p14:modId xmlns:p14="http://schemas.microsoft.com/office/powerpoint/2010/main" val="2043545226"/>
              </p:ext>
            </p:extLst>
          </p:nvPr>
        </p:nvGraphicFramePr>
        <p:xfrm>
          <a:off x="1764082" y="284445"/>
          <a:ext cx="8663836" cy="6289110"/>
        </p:xfrm>
        <a:graphic>
          <a:graphicData uri="http://schemas.openxmlformats.org/drawingml/2006/chart">
            <c:chart xmlns:c="http://schemas.openxmlformats.org/drawingml/2006/chart" r:id="rId2"/>
          </a:graphicData>
        </a:graphic>
      </p:graphicFrame>
      <p:sp>
        <p:nvSpPr>
          <p:cNvPr id="4" name="Oval 3"/>
          <p:cNvSpPr/>
          <p:nvPr/>
        </p:nvSpPr>
        <p:spPr>
          <a:xfrm>
            <a:off x="4217158" y="1460310"/>
            <a:ext cx="818865" cy="218364"/>
          </a:xfrm>
          <a:prstGeom prst="ellipse">
            <a:avLst/>
          </a:prstGeom>
          <a:solidFill>
            <a:schemeClr val="accent1">
              <a:alpha val="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5-Point Star 4"/>
          <p:cNvSpPr/>
          <p:nvPr/>
        </p:nvSpPr>
        <p:spPr>
          <a:xfrm>
            <a:off x="4926841" y="6318914"/>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cxnSp>
        <p:nvCxnSpPr>
          <p:cNvPr id="6" name="Straight Arrow Connector 5"/>
          <p:cNvCxnSpPr/>
          <p:nvPr/>
        </p:nvCxnSpPr>
        <p:spPr>
          <a:xfrm flipH="1">
            <a:off x="5268037" y="3821373"/>
            <a:ext cx="818864" cy="2292824"/>
          </a:xfrm>
          <a:prstGeom prst="straightConnector1">
            <a:avLst/>
          </a:prstGeom>
          <a:ln>
            <a:solidFill>
              <a:srgbClr val="002060"/>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7" name="Straight Arrow Connector 6"/>
          <p:cNvCxnSpPr/>
          <p:nvPr/>
        </p:nvCxnSpPr>
        <p:spPr>
          <a:xfrm flipH="1" flipV="1">
            <a:off x="4831307" y="1678674"/>
            <a:ext cx="1255594" cy="2142700"/>
          </a:xfrm>
          <a:prstGeom prst="straightConnector1">
            <a:avLst/>
          </a:prstGeom>
          <a:ln>
            <a:solidFill>
              <a:srgbClr val="002060"/>
            </a:solidFill>
            <a:prstDash val="dash"/>
            <a:tailEnd type="triangle"/>
          </a:ln>
        </p:spPr>
        <p:style>
          <a:lnRef idx="1">
            <a:schemeClr val="accent1"/>
          </a:lnRef>
          <a:fillRef idx="0">
            <a:schemeClr val="accent1"/>
          </a:fillRef>
          <a:effectRef idx="0">
            <a:schemeClr val="accent1"/>
          </a:effectRef>
          <a:fontRef idx="minor">
            <a:schemeClr val="tx1"/>
          </a:fontRef>
        </p:style>
      </p:cxnSp>
      <p:sp>
        <p:nvSpPr>
          <p:cNvPr id="8" name="TextBox 7"/>
          <p:cNvSpPr txBox="1"/>
          <p:nvPr/>
        </p:nvSpPr>
        <p:spPr>
          <a:xfrm>
            <a:off x="0" y="0"/>
            <a:ext cx="338554"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E</a:t>
            </a:r>
          </a:p>
        </p:txBody>
      </p:sp>
      <p:sp>
        <p:nvSpPr>
          <p:cNvPr id="9" name="5-Point Star 8"/>
          <p:cNvSpPr/>
          <p:nvPr/>
        </p:nvSpPr>
        <p:spPr>
          <a:xfrm>
            <a:off x="5240739" y="6432412"/>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0" name="5-Point Star 9"/>
          <p:cNvSpPr/>
          <p:nvPr/>
        </p:nvSpPr>
        <p:spPr>
          <a:xfrm>
            <a:off x="5677469" y="6459707"/>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1" name="5-Point Star 10"/>
          <p:cNvSpPr/>
          <p:nvPr/>
        </p:nvSpPr>
        <p:spPr>
          <a:xfrm>
            <a:off x="6270632" y="6498492"/>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2" name="5-Point Star 11"/>
          <p:cNvSpPr/>
          <p:nvPr/>
        </p:nvSpPr>
        <p:spPr>
          <a:xfrm>
            <a:off x="7520942" y="6209732"/>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3" name="5-Point Star 12"/>
          <p:cNvSpPr/>
          <p:nvPr/>
        </p:nvSpPr>
        <p:spPr>
          <a:xfrm>
            <a:off x="9072239" y="3432412"/>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4" name="5-Point Star 13"/>
          <p:cNvSpPr/>
          <p:nvPr/>
        </p:nvSpPr>
        <p:spPr>
          <a:xfrm>
            <a:off x="3848669" y="5804965"/>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5" name="5-Point Star 14"/>
          <p:cNvSpPr/>
          <p:nvPr/>
        </p:nvSpPr>
        <p:spPr>
          <a:xfrm>
            <a:off x="4039738" y="5991367"/>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Tree>
    <p:extLst>
      <p:ext uri="{BB962C8B-B14F-4D97-AF65-F5344CB8AC3E}">
        <p14:creationId xmlns:p14="http://schemas.microsoft.com/office/powerpoint/2010/main" val="1137952046"/>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val 1"/>
          <p:cNvSpPr/>
          <p:nvPr/>
        </p:nvSpPr>
        <p:spPr>
          <a:xfrm>
            <a:off x="4203511" y="1473958"/>
            <a:ext cx="818865" cy="218364"/>
          </a:xfrm>
          <a:prstGeom prst="ellipse">
            <a:avLst/>
          </a:prstGeom>
          <a:solidFill>
            <a:schemeClr val="accent1">
              <a:alpha val="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7" name="Chart 6"/>
          <p:cNvGraphicFramePr>
            <a:graphicFrameLocks noGrp="1"/>
          </p:cNvGraphicFramePr>
          <p:nvPr>
            <p:extLst>
              <p:ext uri="{D42A27DB-BD31-4B8C-83A1-F6EECF244321}">
                <p14:modId xmlns:p14="http://schemas.microsoft.com/office/powerpoint/2010/main" val="2046599003"/>
              </p:ext>
            </p:extLst>
          </p:nvPr>
        </p:nvGraphicFramePr>
        <p:xfrm>
          <a:off x="1764082" y="284445"/>
          <a:ext cx="8663836" cy="6289110"/>
        </p:xfrm>
        <a:graphic>
          <a:graphicData uri="http://schemas.openxmlformats.org/drawingml/2006/chart">
            <c:chart xmlns:c="http://schemas.openxmlformats.org/drawingml/2006/chart" r:id="rId2"/>
          </a:graphicData>
        </a:graphic>
      </p:graphicFrame>
      <p:sp>
        <p:nvSpPr>
          <p:cNvPr id="11" name="TextBox 10"/>
          <p:cNvSpPr txBox="1"/>
          <p:nvPr/>
        </p:nvSpPr>
        <p:spPr>
          <a:xfrm>
            <a:off x="9676263" y="3244334"/>
            <a:ext cx="2129050" cy="923330"/>
          </a:xfrm>
          <a:prstGeom prst="rect">
            <a:avLst/>
          </a:prstGeom>
          <a:noFill/>
        </p:spPr>
        <p:txBody>
          <a:bodyPr wrap="square" rtlCol="0">
            <a:spAutoFit/>
          </a:bodyPr>
          <a:lstStyle/>
          <a:p>
            <a:pPr algn="ctr"/>
            <a:r>
              <a:rPr lang="en-US" b="1" dirty="0" smtClean="0"/>
              <a:t>HPAT2/HPAT21</a:t>
            </a:r>
          </a:p>
          <a:p>
            <a:pPr algn="ctr"/>
            <a:r>
              <a:rPr lang="en-US" b="1" dirty="0" smtClean="0"/>
              <a:t>Lineage Identity Genes</a:t>
            </a:r>
          </a:p>
        </p:txBody>
      </p:sp>
      <p:sp>
        <p:nvSpPr>
          <p:cNvPr id="12" name="TextBox 11"/>
          <p:cNvSpPr txBox="1"/>
          <p:nvPr/>
        </p:nvSpPr>
        <p:spPr>
          <a:xfrm>
            <a:off x="163772" y="3244333"/>
            <a:ext cx="2593075" cy="923330"/>
          </a:xfrm>
          <a:prstGeom prst="rect">
            <a:avLst/>
          </a:prstGeom>
          <a:noFill/>
        </p:spPr>
        <p:txBody>
          <a:bodyPr wrap="square" rtlCol="0">
            <a:spAutoFit/>
          </a:bodyPr>
          <a:lstStyle/>
          <a:p>
            <a:pPr algn="ctr"/>
            <a:r>
              <a:rPr lang="en-US" b="1" dirty="0" smtClean="0"/>
              <a:t>Putative HPAT2/HPAT21</a:t>
            </a:r>
          </a:p>
          <a:p>
            <a:pPr algn="ctr"/>
            <a:r>
              <a:rPr lang="en-US" b="1" dirty="0" smtClean="0"/>
              <a:t>Lineage Specification Genes</a:t>
            </a:r>
          </a:p>
        </p:txBody>
      </p:sp>
      <p:sp>
        <p:nvSpPr>
          <p:cNvPr id="3" name="5-Point Star 2"/>
          <p:cNvSpPr/>
          <p:nvPr/>
        </p:nvSpPr>
        <p:spPr>
          <a:xfrm>
            <a:off x="4926841" y="6318914"/>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cxnSp>
        <p:nvCxnSpPr>
          <p:cNvPr id="8" name="Straight Arrow Connector 7"/>
          <p:cNvCxnSpPr/>
          <p:nvPr/>
        </p:nvCxnSpPr>
        <p:spPr>
          <a:xfrm flipH="1">
            <a:off x="5268037" y="3821373"/>
            <a:ext cx="818864" cy="2292824"/>
          </a:xfrm>
          <a:prstGeom prst="straightConnector1">
            <a:avLst/>
          </a:prstGeom>
          <a:ln>
            <a:solidFill>
              <a:srgbClr val="002060"/>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10" name="Straight Arrow Connector 9"/>
          <p:cNvCxnSpPr/>
          <p:nvPr/>
        </p:nvCxnSpPr>
        <p:spPr>
          <a:xfrm flipH="1" flipV="1">
            <a:off x="4926841" y="1692322"/>
            <a:ext cx="1160060" cy="2129051"/>
          </a:xfrm>
          <a:prstGeom prst="straightConnector1">
            <a:avLst/>
          </a:prstGeom>
          <a:ln>
            <a:solidFill>
              <a:srgbClr val="002060"/>
            </a:solidFill>
            <a:prstDash val="dash"/>
            <a:tailEnd type="triangle"/>
          </a:ln>
        </p:spPr>
        <p:style>
          <a:lnRef idx="1">
            <a:schemeClr val="accent1"/>
          </a:lnRef>
          <a:fillRef idx="0">
            <a:schemeClr val="accent1"/>
          </a:fillRef>
          <a:effectRef idx="0">
            <a:schemeClr val="accent1"/>
          </a:effectRef>
          <a:fontRef idx="minor">
            <a:schemeClr val="tx1"/>
          </a:fontRef>
        </p:style>
      </p:cxnSp>
      <p:sp>
        <p:nvSpPr>
          <p:cNvPr id="9" name="TextBox 8"/>
          <p:cNvSpPr txBox="1"/>
          <p:nvPr/>
        </p:nvSpPr>
        <p:spPr>
          <a:xfrm>
            <a:off x="0" y="0"/>
            <a:ext cx="325730"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F</a:t>
            </a:r>
          </a:p>
        </p:txBody>
      </p:sp>
      <p:sp>
        <p:nvSpPr>
          <p:cNvPr id="13" name="5-Point Star 12"/>
          <p:cNvSpPr/>
          <p:nvPr/>
        </p:nvSpPr>
        <p:spPr>
          <a:xfrm>
            <a:off x="5240739" y="6432412"/>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4" name="5-Point Star 13"/>
          <p:cNvSpPr/>
          <p:nvPr/>
        </p:nvSpPr>
        <p:spPr>
          <a:xfrm>
            <a:off x="5677469" y="6459707"/>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5" name="5-Point Star 14"/>
          <p:cNvSpPr/>
          <p:nvPr/>
        </p:nvSpPr>
        <p:spPr>
          <a:xfrm>
            <a:off x="3848669" y="5804965"/>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6" name="5-Point Star 15"/>
          <p:cNvSpPr/>
          <p:nvPr/>
        </p:nvSpPr>
        <p:spPr>
          <a:xfrm>
            <a:off x="4039738" y="5991367"/>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7" name="5-Point Star 16"/>
          <p:cNvSpPr/>
          <p:nvPr/>
        </p:nvSpPr>
        <p:spPr>
          <a:xfrm>
            <a:off x="6270632" y="6498492"/>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8" name="5-Point Star 17"/>
          <p:cNvSpPr/>
          <p:nvPr/>
        </p:nvSpPr>
        <p:spPr>
          <a:xfrm>
            <a:off x="7520942" y="6209732"/>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9" name="5-Point Star 18"/>
          <p:cNvSpPr/>
          <p:nvPr/>
        </p:nvSpPr>
        <p:spPr>
          <a:xfrm>
            <a:off x="9072239" y="3432412"/>
            <a:ext cx="191069" cy="150125"/>
          </a:xfrm>
          <a:prstGeom prst="star5">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Tree>
    <p:extLst>
      <p:ext uri="{BB962C8B-B14F-4D97-AF65-F5344CB8AC3E}">
        <p14:creationId xmlns:p14="http://schemas.microsoft.com/office/powerpoint/2010/main" val="3107808241"/>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943</TotalTime>
  <Words>396</Words>
  <Application>Microsoft Office PowerPoint</Application>
  <PresentationFormat>Widescreen</PresentationFormat>
  <Paragraphs>28</Paragraphs>
  <Slides>7</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7</vt:i4>
      </vt:variant>
    </vt:vector>
  </HeadingPairs>
  <TitlesOfParts>
    <vt:vector size="13" baseType="lpstr">
      <vt:lpstr>Arial</vt:lpstr>
      <vt:lpstr>Calibri</vt:lpstr>
      <vt:lpstr>Calibri Light</vt:lpstr>
      <vt:lpstr>Helvetica</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Manager/>
  <Company/>
  <LinksUpToDate>false</LinksUpToDate>
  <SharedDoc>false</SharedDoc>
  <HyperlinkBase/>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xsi="http://www.w3.org/2001/XMLSchema-instance"/>
</file>